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C1C1C"/>
    <a:srgbClr val="686868"/>
    <a:srgbClr val="58585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4409" autoAdjust="0"/>
    <p:restoredTop sz="93614" autoAdjust="0"/>
  </p:normalViewPr>
  <p:slideViewPr>
    <p:cSldViewPr snapToGrid="0" snapToObjects="1">
      <p:cViewPr>
        <p:scale>
          <a:sx n="150" d="100"/>
          <a:sy n="150" d="100"/>
        </p:scale>
        <p:origin x="384" y="-5922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5895" cy="7589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im\Dropbox\Shedd%20Experiments%20Working%20Group\FULL%20BLEACHING%20EXPERIMENT%209-2012\Paper%20Development\Data\Master%20Excel%20Spreadsheet%20(with%20data%20and%20graphs)%206-4%20Split%20Setup.xlsm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Q$31</c:f>
              <c:strCache>
                <c:ptCount val="1"/>
                <c:pt idx="0">
                  <c:v>high Rs</c:v>
                </c:pt>
              </c:strCache>
            </c:strRef>
          </c:tx>
          <c:spPr>
            <a:ln w="12700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BC$31:$BL$31</c:f>
                <c:numCache>
                  <c:formatCode>General</c:formatCode>
                  <c:ptCount val="10"/>
                  <c:pt idx="0">
                    <c:v>1.2105182753680339E-2</c:v>
                  </c:pt>
                  <c:pt idx="1">
                    <c:v>6.2691319096027879E-3</c:v>
                  </c:pt>
                  <c:pt idx="2">
                    <c:v>8.1650633469679684E-3</c:v>
                  </c:pt>
                  <c:pt idx="3">
                    <c:v>8.1965002470566831E-3</c:v>
                  </c:pt>
                  <c:pt idx="4">
                    <c:v>4.8545352774493197E-3</c:v>
                  </c:pt>
                  <c:pt idx="5">
                    <c:v>9.017843838745496E-3</c:v>
                  </c:pt>
                  <c:pt idx="6">
                    <c:v>1.0369841220578062E-2</c:v>
                  </c:pt>
                  <c:pt idx="7">
                    <c:v>1.9252274884802571E-2</c:v>
                  </c:pt>
                  <c:pt idx="8">
                    <c:v>7.6112138887302451E-3</c:v>
                  </c:pt>
                  <c:pt idx="9">
                    <c:v>5.2355536249760618E-3</c:v>
                  </c:pt>
                </c:numCache>
              </c:numRef>
            </c:plus>
            <c:minus>
              <c:numRef>
                <c:f>'Fig S3'!$BC$31:$BL$31</c:f>
                <c:numCache>
                  <c:formatCode>General</c:formatCode>
                  <c:ptCount val="10"/>
                  <c:pt idx="0">
                    <c:v>1.2105182753680339E-2</c:v>
                  </c:pt>
                  <c:pt idx="1">
                    <c:v>6.2691319096027879E-3</c:v>
                  </c:pt>
                  <c:pt idx="2">
                    <c:v>8.1650633469679684E-3</c:v>
                  </c:pt>
                  <c:pt idx="3">
                    <c:v>8.1965002470566831E-3</c:v>
                  </c:pt>
                  <c:pt idx="4">
                    <c:v>4.8545352774493197E-3</c:v>
                  </c:pt>
                  <c:pt idx="5">
                    <c:v>9.017843838745496E-3</c:v>
                  </c:pt>
                  <c:pt idx="6">
                    <c:v>1.0369841220578062E-2</c:v>
                  </c:pt>
                  <c:pt idx="7">
                    <c:v>1.9252274884802571E-2</c:v>
                  </c:pt>
                  <c:pt idx="8">
                    <c:v>7.6112138887302451E-3</c:v>
                  </c:pt>
                  <c:pt idx="9">
                    <c:v>5.2355536249760618E-3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S$30:$BB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3'!$AS$31:$BB$31</c:f>
              <c:numCache>
                <c:formatCode>0.00E+00</c:formatCode>
                <c:ptCount val="10"/>
                <c:pt idx="0">
                  <c:v>6.0897E-2</c:v>
                </c:pt>
                <c:pt idx="1">
                  <c:v>5.7876999999999998E-2</c:v>
                </c:pt>
                <c:pt idx="2">
                  <c:v>6.2349600000000005E-2</c:v>
                </c:pt>
                <c:pt idx="3">
                  <c:v>5.1764999999999992E-2</c:v>
                </c:pt>
                <c:pt idx="4">
                  <c:v>4.5260399999999999E-2</c:v>
                </c:pt>
                <c:pt idx="5">
                  <c:v>5.2808999999999995E-2</c:v>
                </c:pt>
                <c:pt idx="6">
                  <c:v>5.2259800000000002E-2</c:v>
                </c:pt>
                <c:pt idx="7">
                  <c:v>5.9729199999999996E-2</c:v>
                </c:pt>
                <c:pt idx="8">
                  <c:v>4.82666E-2</c:v>
                </c:pt>
                <c:pt idx="9">
                  <c:v>5.1399600000000004E-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Q$32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solidFill>
                  <a:sysClr val="windowText" lastClr="000000"/>
                </a:solidFill>
              </a:ln>
            </c:spPr>
          </c:marker>
          <c:dPt>
            <c:idx val="0"/>
            <c:marker>
              <c:spPr>
                <a:solidFill>
                  <a:sysClr val="windowText" lastClr="000000"/>
                </a:solidFill>
                <a:ln w="15875">
                  <a:noFill/>
                </a:ln>
              </c:spPr>
            </c:marker>
            <c:bubble3D val="0"/>
          </c:dPt>
          <c:errBars>
            <c:errDir val="y"/>
            <c:errBarType val="both"/>
            <c:errValType val="cust"/>
            <c:noEndCap val="0"/>
            <c:plus>
              <c:numRef>
                <c:f>'Fig S3'!$BC$32:$BL$32</c:f>
                <c:numCache>
                  <c:formatCode>General</c:formatCode>
                  <c:ptCount val="10"/>
                  <c:pt idx="0">
                    <c:v>3.053905104288606E-2</c:v>
                  </c:pt>
                  <c:pt idx="1">
                    <c:v>2.462415795392809E-2</c:v>
                  </c:pt>
                  <c:pt idx="2">
                    <c:v>2.8929640565344056E-2</c:v>
                  </c:pt>
                  <c:pt idx="3">
                    <c:v>2.4961790116896664E-2</c:v>
                  </c:pt>
                  <c:pt idx="4">
                    <c:v>2.6127181209231118E-2</c:v>
                  </c:pt>
                  <c:pt idx="5">
                    <c:v>2.1838617914144671E-2</c:v>
                  </c:pt>
                  <c:pt idx="6">
                    <c:v>1.9717178145972101E-2</c:v>
                  </c:pt>
                  <c:pt idx="7">
                    <c:v>2.8141465920239476E-2</c:v>
                  </c:pt>
                  <c:pt idx="8">
                    <c:v>2.2935026410274749E-2</c:v>
                  </c:pt>
                  <c:pt idx="9">
                    <c:v>2.0782740434312306E-2</c:v>
                  </c:pt>
                </c:numCache>
              </c:numRef>
            </c:plus>
            <c:minus>
              <c:numRef>
                <c:f>'Fig S3'!$BC$32:$BL$32</c:f>
                <c:numCache>
                  <c:formatCode>General</c:formatCode>
                  <c:ptCount val="10"/>
                  <c:pt idx="0">
                    <c:v>3.053905104288606E-2</c:v>
                  </c:pt>
                  <c:pt idx="1">
                    <c:v>2.462415795392809E-2</c:v>
                  </c:pt>
                  <c:pt idx="2">
                    <c:v>2.8929640565344056E-2</c:v>
                  </c:pt>
                  <c:pt idx="3">
                    <c:v>2.4961790116896664E-2</c:v>
                  </c:pt>
                  <c:pt idx="4">
                    <c:v>2.6127181209231118E-2</c:v>
                  </c:pt>
                  <c:pt idx="5">
                    <c:v>2.1838617914144671E-2</c:v>
                  </c:pt>
                  <c:pt idx="6">
                    <c:v>1.9717178145972101E-2</c:v>
                  </c:pt>
                  <c:pt idx="7">
                    <c:v>2.8141465920239476E-2</c:v>
                  </c:pt>
                  <c:pt idx="8">
                    <c:v>2.2935026410274749E-2</c:v>
                  </c:pt>
                  <c:pt idx="9">
                    <c:v>2.0782740434312306E-2</c:v>
                  </c:pt>
                </c:numCache>
              </c:numRef>
            </c:minus>
          </c:errBars>
          <c:xVal>
            <c:numRef>
              <c:f>'Fig S3'!$AS$30:$BB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3'!$AS$32:$BB$32</c:f>
              <c:numCache>
                <c:formatCode>0.00E+00</c:formatCode>
                <c:ptCount val="10"/>
                <c:pt idx="0">
                  <c:v>0.110683</c:v>
                </c:pt>
                <c:pt idx="1">
                  <c:v>8.9619799999999999E-2</c:v>
                </c:pt>
                <c:pt idx="2">
                  <c:v>9.7568200000000008E-2</c:v>
                </c:pt>
                <c:pt idx="3">
                  <c:v>9.0787199999999998E-2</c:v>
                </c:pt>
                <c:pt idx="4">
                  <c:v>8.4545200000000015E-2</c:v>
                </c:pt>
                <c:pt idx="5">
                  <c:v>8.2179999999999989E-2</c:v>
                </c:pt>
                <c:pt idx="6">
                  <c:v>7.6500200000000004E-2</c:v>
                </c:pt>
                <c:pt idx="7">
                  <c:v>8.628319999999999E-2</c:v>
                </c:pt>
                <c:pt idx="8">
                  <c:v>8.2443799999999998E-2</c:v>
                </c:pt>
                <c:pt idx="9">
                  <c:v>7.5217400000000004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027488"/>
        <c:axId val="205031968"/>
      </c:scatterChart>
      <c:scatterChart>
        <c:scatterStyle val="smoothMarker"/>
        <c:varyColors val="0"/>
        <c:ser>
          <c:idx val="2"/>
          <c:order val="2"/>
          <c:tx>
            <c:strRef>
              <c:f>'Fig S3'!$J$21</c:f>
              <c:strCache>
                <c:ptCount val="1"/>
                <c:pt idx="0">
                  <c:v>High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  <a:prstDash val="dashDot"/>
            </a:ln>
          </c:spPr>
          <c:marker>
            <c:symbol val="none"/>
          </c:marker>
          <c:xVal>
            <c:numRef>
              <c:f>'Fig S3'!$N$11:$W$11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3'!$N$12:$W$12</c:f>
              <c:numCache>
                <c:formatCode>General</c:formatCode>
                <c:ptCount val="10"/>
                <c:pt idx="0">
                  <c:v>0.49628800000000001</c:v>
                </c:pt>
                <c:pt idx="1">
                  <c:v>0.49628800000000001</c:v>
                </c:pt>
                <c:pt idx="2">
                  <c:v>0.49628800000000001</c:v>
                </c:pt>
                <c:pt idx="3">
                  <c:v>0.49628800000000001</c:v>
                </c:pt>
                <c:pt idx="4">
                  <c:v>0.49628800000000001</c:v>
                </c:pt>
                <c:pt idx="5">
                  <c:v>0.49628800000000001</c:v>
                </c:pt>
                <c:pt idx="6">
                  <c:v>0.49628800000000001</c:v>
                </c:pt>
                <c:pt idx="7">
                  <c:v>0.49628800000000001</c:v>
                </c:pt>
                <c:pt idx="8">
                  <c:v>0.49628800000000001</c:v>
                </c:pt>
                <c:pt idx="9">
                  <c:v>0.49628800000000001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'Fig S3'!$J$22</c:f>
              <c:strCache>
                <c:ptCount val="1"/>
                <c:pt idx="0">
                  <c:v>Low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  <a:prstDash val="dash"/>
            </a:ln>
          </c:spPr>
          <c:marker>
            <c:symbol val="none"/>
          </c:marker>
          <c:xVal>
            <c:numRef>
              <c:f>'Fig S3'!$N$11:$W$11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3'!$N$13:$W$13</c:f>
              <c:numCache>
                <c:formatCode>General</c:formatCode>
                <c:ptCount val="10"/>
                <c:pt idx="0">
                  <c:v>0.34598200000000001</c:v>
                </c:pt>
                <c:pt idx="1">
                  <c:v>0.34598200000000001</c:v>
                </c:pt>
                <c:pt idx="2">
                  <c:v>0.34598200000000001</c:v>
                </c:pt>
                <c:pt idx="3">
                  <c:v>0.34598200000000001</c:v>
                </c:pt>
                <c:pt idx="4">
                  <c:v>0.34598200000000001</c:v>
                </c:pt>
                <c:pt idx="5">
                  <c:v>0.34598200000000001</c:v>
                </c:pt>
                <c:pt idx="6">
                  <c:v>0.34598200000000001</c:v>
                </c:pt>
                <c:pt idx="7">
                  <c:v>0.34598200000000001</c:v>
                </c:pt>
                <c:pt idx="8">
                  <c:v>0.34598200000000001</c:v>
                </c:pt>
                <c:pt idx="9">
                  <c:v>0.3459820000000000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027488"/>
        <c:axId val="205031968"/>
      </c:scatterChart>
      <c:valAx>
        <c:axId val="20502748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05031968"/>
        <c:crosses val="autoZero"/>
        <c:crossBetween val="midCat"/>
        <c:majorUnit val="2"/>
        <c:minorUnit val="1"/>
      </c:valAx>
      <c:valAx>
        <c:axId val="205031968"/>
        <c:scaling>
          <c:orientation val="minMax"/>
          <c:max val="0.6000000000000002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 baseline="0"/>
            </a:pPr>
            <a:endParaRPr lang="en-US"/>
          </a:p>
        </c:txPr>
        <c:crossAx val="205027488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M$91</c:f>
              <c:strCache>
                <c:ptCount val="1"/>
                <c:pt idx="0">
                  <c:v>high Rs</c:v>
                </c:pt>
              </c:strCache>
            </c:strRef>
          </c:tx>
          <c:spPr>
            <a:ln w="12700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W$91:$BD$91</c:f>
                <c:numCache>
                  <c:formatCode>General</c:formatCode>
                  <c:ptCount val="8"/>
                  <c:pt idx="0">
                    <c:v>1481362.5954775168</c:v>
                  </c:pt>
                  <c:pt idx="1">
                    <c:v>798137.21812976408</c:v>
                  </c:pt>
                  <c:pt idx="2">
                    <c:v>959273.89426191442</c:v>
                  </c:pt>
                  <c:pt idx="3">
                    <c:v>959888.82502576162</c:v>
                  </c:pt>
                  <c:pt idx="4">
                    <c:v>666613.11189031496</c:v>
                  </c:pt>
                  <c:pt idx="5">
                    <c:v>672004.0920392205</c:v>
                  </c:pt>
                  <c:pt idx="6">
                    <c:v>823745.24053713516</c:v>
                  </c:pt>
                  <c:pt idx="7">
                    <c:v>421125.55487171898</c:v>
                  </c:pt>
                </c:numCache>
              </c:numRef>
            </c:plus>
            <c:minus>
              <c:numRef>
                <c:f>'Fig S3'!$AW$91:$BD$91</c:f>
                <c:numCache>
                  <c:formatCode>General</c:formatCode>
                  <c:ptCount val="8"/>
                  <c:pt idx="0">
                    <c:v>1481362.5954775168</c:v>
                  </c:pt>
                  <c:pt idx="1">
                    <c:v>798137.21812976408</c:v>
                  </c:pt>
                  <c:pt idx="2">
                    <c:v>959273.89426191442</c:v>
                  </c:pt>
                  <c:pt idx="3">
                    <c:v>959888.82502576162</c:v>
                  </c:pt>
                  <c:pt idx="4">
                    <c:v>666613.11189031496</c:v>
                  </c:pt>
                  <c:pt idx="5">
                    <c:v>672004.0920392205</c:v>
                  </c:pt>
                  <c:pt idx="6">
                    <c:v>823745.24053713516</c:v>
                  </c:pt>
                  <c:pt idx="7">
                    <c:v>421125.55487171898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O$88:$AV$8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3'!$AO$91:$AV$91</c:f>
              <c:numCache>
                <c:formatCode>0.00E+00</c:formatCode>
                <c:ptCount val="8"/>
                <c:pt idx="0">
                  <c:v>3056477.9565791213</c:v>
                </c:pt>
                <c:pt idx="1">
                  <c:v>2172029.5081508216</c:v>
                </c:pt>
                <c:pt idx="2">
                  <c:v>2177171.8943276131</c:v>
                </c:pt>
                <c:pt idx="3">
                  <c:v>1776514.729813461</c:v>
                </c:pt>
                <c:pt idx="4">
                  <c:v>1884479.4976322041</c:v>
                </c:pt>
                <c:pt idx="5">
                  <c:v>2041630.6120855939</c:v>
                </c:pt>
                <c:pt idx="6">
                  <c:v>1968785.6049453418</c:v>
                </c:pt>
                <c:pt idx="7">
                  <c:v>1389014.941911675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M$92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W$92:$BD$92</c:f>
                <c:numCache>
                  <c:formatCode>General</c:formatCode>
                  <c:ptCount val="8"/>
                  <c:pt idx="0">
                    <c:v>693746.83614033577</c:v>
                  </c:pt>
                  <c:pt idx="1">
                    <c:v>1000598.7739368244</c:v>
                  </c:pt>
                  <c:pt idx="2">
                    <c:v>563213.83408684505</c:v>
                  </c:pt>
                  <c:pt idx="3">
                    <c:v>1510146.2377733884</c:v>
                  </c:pt>
                  <c:pt idx="4">
                    <c:v>804563.26629477809</c:v>
                  </c:pt>
                  <c:pt idx="5">
                    <c:v>996704.1300919404</c:v>
                  </c:pt>
                  <c:pt idx="6">
                    <c:v>446862.56207349693</c:v>
                  </c:pt>
                  <c:pt idx="7">
                    <c:v>1032875.5037684101</c:v>
                  </c:pt>
                </c:numCache>
              </c:numRef>
            </c:plus>
            <c:minus>
              <c:numRef>
                <c:f>'Fig S3'!$AW$92:$BD$92</c:f>
                <c:numCache>
                  <c:formatCode>General</c:formatCode>
                  <c:ptCount val="8"/>
                  <c:pt idx="0">
                    <c:v>693746.83614033577</c:v>
                  </c:pt>
                  <c:pt idx="1">
                    <c:v>1000598.7739368244</c:v>
                  </c:pt>
                  <c:pt idx="2">
                    <c:v>563213.83408684505</c:v>
                  </c:pt>
                  <c:pt idx="3">
                    <c:v>1510146.2377733884</c:v>
                  </c:pt>
                  <c:pt idx="4">
                    <c:v>804563.26629477809</c:v>
                  </c:pt>
                  <c:pt idx="5">
                    <c:v>996704.1300919404</c:v>
                  </c:pt>
                  <c:pt idx="6">
                    <c:v>446862.56207349693</c:v>
                  </c:pt>
                  <c:pt idx="7">
                    <c:v>1032875.5037684101</c:v>
                  </c:pt>
                </c:numCache>
              </c:numRef>
            </c:minus>
          </c:errBars>
          <c:xVal>
            <c:numRef>
              <c:f>'Fig S3'!$AO$88:$AV$8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3'!$AO$92:$AV$92</c:f>
              <c:numCache>
                <c:formatCode>0.00E+00</c:formatCode>
                <c:ptCount val="8"/>
                <c:pt idx="0">
                  <c:v>1397366.2534425075</c:v>
                </c:pt>
                <c:pt idx="1">
                  <c:v>1518819.6203018189</c:v>
                </c:pt>
                <c:pt idx="2">
                  <c:v>983633.97551651765</c:v>
                </c:pt>
                <c:pt idx="3">
                  <c:v>2220480.2618741957</c:v>
                </c:pt>
                <c:pt idx="4">
                  <c:v>1273692.5152239155</c:v>
                </c:pt>
                <c:pt idx="5">
                  <c:v>1524760.399262676</c:v>
                </c:pt>
                <c:pt idx="6">
                  <c:v>1100142.4352424997</c:v>
                </c:pt>
                <c:pt idx="7">
                  <c:v>1436963.773548865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3857920"/>
        <c:axId val="373857360"/>
      </c:scatterChart>
      <c:valAx>
        <c:axId val="37385792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73857360"/>
        <c:crosses val="autoZero"/>
        <c:crossBetween val="midCat"/>
        <c:majorUnit val="2"/>
        <c:minorUnit val="1"/>
      </c:valAx>
      <c:valAx>
        <c:axId val="373857360"/>
        <c:scaling>
          <c:logBase val="10"/>
          <c:orientation val="minMax"/>
          <c:max val="8000000"/>
          <c:min val="10000"/>
        </c:scaling>
        <c:delete val="0"/>
        <c:axPos val="l"/>
        <c:numFmt formatCode="0.00E+00" sourceLinked="0"/>
        <c:majorTickMark val="out"/>
        <c:minorTickMark val="none"/>
        <c:tickLblPos val="none"/>
        <c:crossAx val="373857920"/>
        <c:crossesAt val="-11"/>
        <c:crossBetween val="midCat"/>
        <c:majorUnit val="10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M$93</c:f>
              <c:strCache>
                <c:ptCount val="1"/>
                <c:pt idx="0">
                  <c:v>high Rs</c:v>
                </c:pt>
              </c:strCache>
            </c:strRef>
          </c:tx>
          <c:spPr>
            <a:ln w="12700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W$93:$BD$93</c:f>
                <c:numCache>
                  <c:formatCode>General</c:formatCode>
                  <c:ptCount val="8"/>
                  <c:pt idx="0">
                    <c:v>2213921.9352330086</c:v>
                  </c:pt>
                  <c:pt idx="1">
                    <c:v>1275131.7770060692</c:v>
                  </c:pt>
                  <c:pt idx="2">
                    <c:v>1341718.9963432942</c:v>
                  </c:pt>
                  <c:pt idx="3">
                    <c:v>943964.43284794386</c:v>
                  </c:pt>
                  <c:pt idx="4">
                    <c:v>461623.68224714271</c:v>
                  </c:pt>
                  <c:pt idx="5">
                    <c:v>368988.22635980987</c:v>
                  </c:pt>
                  <c:pt idx="6">
                    <c:v>1686457.8092328568</c:v>
                  </c:pt>
                  <c:pt idx="7">
                    <c:v>601249.74587257928</c:v>
                  </c:pt>
                </c:numCache>
              </c:numRef>
            </c:plus>
            <c:minus>
              <c:numRef>
                <c:f>'Fig S3'!$AW$93:$BD$93</c:f>
                <c:numCache>
                  <c:formatCode>General</c:formatCode>
                  <c:ptCount val="8"/>
                  <c:pt idx="0">
                    <c:v>2213921.9352330086</c:v>
                  </c:pt>
                  <c:pt idx="1">
                    <c:v>1275131.7770060692</c:v>
                  </c:pt>
                  <c:pt idx="2">
                    <c:v>1341718.9963432942</c:v>
                  </c:pt>
                  <c:pt idx="3">
                    <c:v>943964.43284794386</c:v>
                  </c:pt>
                  <c:pt idx="4">
                    <c:v>461623.68224714271</c:v>
                  </c:pt>
                  <c:pt idx="5">
                    <c:v>368988.22635980987</c:v>
                  </c:pt>
                  <c:pt idx="6">
                    <c:v>1686457.8092328568</c:v>
                  </c:pt>
                  <c:pt idx="7">
                    <c:v>601249.74587257928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O$88:$AV$8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3'!$AO$93:$AV$93</c:f>
              <c:numCache>
                <c:formatCode>0.00E+00</c:formatCode>
                <c:ptCount val="8"/>
                <c:pt idx="0">
                  <c:v>3606125.7972727553</c:v>
                </c:pt>
                <c:pt idx="1">
                  <c:v>2908264.5662172772</c:v>
                </c:pt>
                <c:pt idx="2">
                  <c:v>2204050.3496570941</c:v>
                </c:pt>
                <c:pt idx="3">
                  <c:v>1969172.1095685295</c:v>
                </c:pt>
                <c:pt idx="4">
                  <c:v>1582787.438860866</c:v>
                </c:pt>
                <c:pt idx="5">
                  <c:v>1268354.8828888503</c:v>
                </c:pt>
                <c:pt idx="6">
                  <c:v>2857979.6097290893</c:v>
                </c:pt>
                <c:pt idx="7">
                  <c:v>1159489.624217911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M$94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W$94:$BD$94</c:f>
                <c:numCache>
                  <c:formatCode>General</c:formatCode>
                  <c:ptCount val="8"/>
                  <c:pt idx="0">
                    <c:v>552009.5852180965</c:v>
                  </c:pt>
                  <c:pt idx="1">
                    <c:v>932769.61105912994</c:v>
                  </c:pt>
                  <c:pt idx="2">
                    <c:v>1158334.7949455092</c:v>
                  </c:pt>
                  <c:pt idx="3">
                    <c:v>831673.41458190104</c:v>
                  </c:pt>
                  <c:pt idx="4">
                    <c:v>524168.48838186532</c:v>
                  </c:pt>
                  <c:pt idx="5">
                    <c:v>481028.91119085409</c:v>
                  </c:pt>
                  <c:pt idx="6">
                    <c:v>502360.39152324019</c:v>
                  </c:pt>
                  <c:pt idx="7">
                    <c:v>259476.50679967058</c:v>
                  </c:pt>
                </c:numCache>
              </c:numRef>
            </c:plus>
            <c:minus>
              <c:numRef>
                <c:f>'Fig S3'!$AW$94:$BD$94</c:f>
                <c:numCache>
                  <c:formatCode>General</c:formatCode>
                  <c:ptCount val="8"/>
                  <c:pt idx="0">
                    <c:v>552009.5852180965</c:v>
                  </c:pt>
                  <c:pt idx="1">
                    <c:v>932769.61105912994</c:v>
                  </c:pt>
                  <c:pt idx="2">
                    <c:v>1158334.7949455092</c:v>
                  </c:pt>
                  <c:pt idx="3">
                    <c:v>831673.41458190104</c:v>
                  </c:pt>
                  <c:pt idx="4">
                    <c:v>524168.48838186532</c:v>
                  </c:pt>
                  <c:pt idx="5">
                    <c:v>481028.91119085409</c:v>
                  </c:pt>
                  <c:pt idx="6">
                    <c:v>502360.39152324019</c:v>
                  </c:pt>
                  <c:pt idx="7">
                    <c:v>259476.50679967058</c:v>
                  </c:pt>
                </c:numCache>
              </c:numRef>
            </c:minus>
          </c:errBars>
          <c:xVal>
            <c:numRef>
              <c:f>'Fig S3'!$AO$88:$AV$8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3'!$AO$94:$AV$94</c:f>
              <c:numCache>
                <c:formatCode>0.00E+00</c:formatCode>
                <c:ptCount val="8"/>
                <c:pt idx="0">
                  <c:v>1097091.0815120186</c:v>
                </c:pt>
                <c:pt idx="1">
                  <c:v>1351237.2384095879</c:v>
                </c:pt>
                <c:pt idx="2">
                  <c:v>1617195.1397493999</c:v>
                </c:pt>
                <c:pt idx="3">
                  <c:v>1001669.6161284882</c:v>
                </c:pt>
                <c:pt idx="4">
                  <c:v>891309.1212838128</c:v>
                </c:pt>
                <c:pt idx="5">
                  <c:v>934882.29161451571</c:v>
                </c:pt>
                <c:pt idx="6">
                  <c:v>595727.23885079741</c:v>
                </c:pt>
                <c:pt idx="7">
                  <c:v>442825.6397705691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3868560"/>
        <c:axId val="373869680"/>
      </c:scatterChart>
      <c:valAx>
        <c:axId val="37386856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73869680"/>
        <c:crosses val="autoZero"/>
        <c:crossBetween val="midCat"/>
        <c:majorUnit val="2"/>
        <c:minorUnit val="1"/>
      </c:valAx>
      <c:valAx>
        <c:axId val="373869680"/>
        <c:scaling>
          <c:logBase val="10"/>
          <c:orientation val="minMax"/>
          <c:max val="8000000"/>
          <c:min val="10000"/>
        </c:scaling>
        <c:delete val="0"/>
        <c:axPos val="l"/>
        <c:numFmt formatCode="0.00E+00" sourceLinked="0"/>
        <c:majorTickMark val="out"/>
        <c:minorTickMark val="none"/>
        <c:tickLblPos val="none"/>
        <c:crossAx val="373868560"/>
        <c:crossesAt val="-11"/>
        <c:crossBetween val="midCat"/>
        <c:majorUnit val="10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M$95</c:f>
              <c:strCache>
                <c:ptCount val="1"/>
                <c:pt idx="0">
                  <c:v>high Rs</c:v>
                </c:pt>
              </c:strCache>
            </c:strRef>
          </c:tx>
          <c:spPr>
            <a:ln w="12700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W$95:$BD$95</c:f>
                <c:numCache>
                  <c:formatCode>General</c:formatCode>
                  <c:ptCount val="8"/>
                  <c:pt idx="0">
                    <c:v>935638.01541341818</c:v>
                  </c:pt>
                  <c:pt idx="1">
                    <c:v>604608.03767127555</c:v>
                  </c:pt>
                  <c:pt idx="2">
                    <c:v>799625.88771184965</c:v>
                  </c:pt>
                  <c:pt idx="3">
                    <c:v>808353.61022348632</c:v>
                  </c:pt>
                  <c:pt idx="4">
                    <c:v>622974.26677566068</c:v>
                  </c:pt>
                  <c:pt idx="5">
                    <c:v>600784.04679055989</c:v>
                  </c:pt>
                  <c:pt idx="6">
                    <c:v>604041.47325280681</c:v>
                  </c:pt>
                  <c:pt idx="7">
                    <c:v>903171.9501201344</c:v>
                  </c:pt>
                </c:numCache>
              </c:numRef>
            </c:plus>
            <c:minus>
              <c:numRef>
                <c:f>'Fig S3'!$AW$95:$BD$95</c:f>
                <c:numCache>
                  <c:formatCode>General</c:formatCode>
                  <c:ptCount val="8"/>
                  <c:pt idx="0">
                    <c:v>935638.01541341818</c:v>
                  </c:pt>
                  <c:pt idx="1">
                    <c:v>604608.03767127555</c:v>
                  </c:pt>
                  <c:pt idx="2">
                    <c:v>799625.88771184965</c:v>
                  </c:pt>
                  <c:pt idx="3">
                    <c:v>808353.61022348632</c:v>
                  </c:pt>
                  <c:pt idx="4">
                    <c:v>622974.26677566068</c:v>
                  </c:pt>
                  <c:pt idx="5">
                    <c:v>600784.04679055989</c:v>
                  </c:pt>
                  <c:pt idx="6">
                    <c:v>604041.47325280681</c:v>
                  </c:pt>
                  <c:pt idx="7">
                    <c:v>903171.9501201344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O$88:$AV$8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3'!$AO$95:$AV$95</c:f>
              <c:numCache>
                <c:formatCode>0.00E+00</c:formatCode>
                <c:ptCount val="8"/>
                <c:pt idx="0">
                  <c:v>2426958.1606218736</c:v>
                </c:pt>
                <c:pt idx="1">
                  <c:v>2020677.5649643776</c:v>
                </c:pt>
                <c:pt idx="2">
                  <c:v>2016098.6172789633</c:v>
                </c:pt>
                <c:pt idx="3">
                  <c:v>1766202.6993523357</c:v>
                </c:pt>
                <c:pt idx="4">
                  <c:v>2001074.0750964459</c:v>
                </c:pt>
                <c:pt idx="5">
                  <c:v>1666228.0798358296</c:v>
                </c:pt>
                <c:pt idx="6">
                  <c:v>1506970.0810460411</c:v>
                </c:pt>
                <c:pt idx="7">
                  <c:v>1336742.479665659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M$96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W$96:$BD$96</c:f>
                <c:numCache>
                  <c:formatCode>General</c:formatCode>
                  <c:ptCount val="8"/>
                  <c:pt idx="0">
                    <c:v>675994.42151432228</c:v>
                  </c:pt>
                  <c:pt idx="1">
                    <c:v>565206.23630289105</c:v>
                  </c:pt>
                  <c:pt idx="2">
                    <c:v>573282.11657850014</c:v>
                  </c:pt>
                  <c:pt idx="3">
                    <c:v>136205.86540196484</c:v>
                  </c:pt>
                  <c:pt idx="4">
                    <c:v>805971.1497039703</c:v>
                  </c:pt>
                  <c:pt idx="5">
                    <c:v>681512.8419689791</c:v>
                  </c:pt>
                  <c:pt idx="6">
                    <c:v>998126.46852126054</c:v>
                  </c:pt>
                  <c:pt idx="7">
                    <c:v>259574.76904368162</c:v>
                  </c:pt>
                </c:numCache>
              </c:numRef>
            </c:plus>
            <c:minus>
              <c:numRef>
                <c:f>'Fig S3'!$AW$96:$BD$96</c:f>
                <c:numCache>
                  <c:formatCode>General</c:formatCode>
                  <c:ptCount val="8"/>
                  <c:pt idx="0">
                    <c:v>675994.42151432228</c:v>
                  </c:pt>
                  <c:pt idx="1">
                    <c:v>565206.23630289105</c:v>
                  </c:pt>
                  <c:pt idx="2">
                    <c:v>573282.11657850014</c:v>
                  </c:pt>
                  <c:pt idx="3">
                    <c:v>136205.86540196484</c:v>
                  </c:pt>
                  <c:pt idx="4">
                    <c:v>805971.1497039703</c:v>
                  </c:pt>
                  <c:pt idx="5">
                    <c:v>681512.8419689791</c:v>
                  </c:pt>
                  <c:pt idx="6">
                    <c:v>998126.46852126054</c:v>
                  </c:pt>
                  <c:pt idx="7">
                    <c:v>259574.76904368162</c:v>
                  </c:pt>
                </c:numCache>
              </c:numRef>
            </c:minus>
          </c:errBars>
          <c:xVal>
            <c:numRef>
              <c:f>'Fig S3'!$AO$88:$AV$8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3'!$AO$96:$AV$96</c:f>
              <c:numCache>
                <c:formatCode>0.00E+00</c:formatCode>
                <c:ptCount val="8"/>
                <c:pt idx="0">
                  <c:v>1020948.6614112901</c:v>
                </c:pt>
                <c:pt idx="1">
                  <c:v>999217.89127865585</c:v>
                </c:pt>
                <c:pt idx="2">
                  <c:v>907003.45420471206</c:v>
                </c:pt>
                <c:pt idx="3">
                  <c:v>414850.43589951843</c:v>
                </c:pt>
                <c:pt idx="4">
                  <c:v>1160901.7403028947</c:v>
                </c:pt>
                <c:pt idx="5">
                  <c:v>931612.68644163583</c:v>
                </c:pt>
                <c:pt idx="6">
                  <c:v>1130937.0239434075</c:v>
                </c:pt>
                <c:pt idx="7">
                  <c:v>455763.4263368814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3870800"/>
        <c:axId val="373871360"/>
      </c:scatterChart>
      <c:valAx>
        <c:axId val="37387080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73871360"/>
        <c:crosses val="autoZero"/>
        <c:crossBetween val="midCat"/>
        <c:majorUnit val="2"/>
        <c:minorUnit val="1"/>
      </c:valAx>
      <c:valAx>
        <c:axId val="373871360"/>
        <c:scaling>
          <c:logBase val="10"/>
          <c:orientation val="minMax"/>
          <c:max val="8000000"/>
          <c:min val="10000"/>
        </c:scaling>
        <c:delete val="0"/>
        <c:axPos val="l"/>
        <c:numFmt formatCode="0.00E+00" sourceLinked="0"/>
        <c:majorTickMark val="out"/>
        <c:minorTickMark val="none"/>
        <c:tickLblPos val="none"/>
        <c:crossAx val="373870800"/>
        <c:crossesAt val="-11"/>
        <c:crossBetween val="midCat"/>
        <c:majorUnit val="10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O$346</c:f>
              <c:strCache>
                <c:ptCount val="1"/>
                <c:pt idx="0">
                  <c:v>high Rs</c:v>
                </c:pt>
              </c:strCache>
            </c:strRef>
          </c:tx>
          <c:spPr>
            <a:ln w="12700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Z$346:$BH$346</c:f>
                <c:numCache>
                  <c:formatCode>General</c:formatCode>
                  <c:ptCount val="9"/>
                  <c:pt idx="0">
                    <c:v>1.1734434298180656E-2</c:v>
                  </c:pt>
                  <c:pt idx="1">
                    <c:v>3.0440759511081127E-2</c:v>
                  </c:pt>
                  <c:pt idx="2">
                    <c:v>3.4649364543149125E-2</c:v>
                  </c:pt>
                  <c:pt idx="3">
                    <c:v>3.2561710184898882E-2</c:v>
                  </c:pt>
                  <c:pt idx="4">
                    <c:v>3.1485355413635584E-2</c:v>
                  </c:pt>
                  <c:pt idx="5">
                    <c:v>5.4711407399262522E-2</c:v>
                  </c:pt>
                  <c:pt idx="6">
                    <c:v>5.6975137977747031E-2</c:v>
                  </c:pt>
                  <c:pt idx="7">
                    <c:v>5.5086070856630191E-2</c:v>
                  </c:pt>
                  <c:pt idx="8">
                    <c:v>5.5347202779987496E-2</c:v>
                  </c:pt>
                </c:numCache>
              </c:numRef>
            </c:plus>
            <c:minus>
              <c:numRef>
                <c:f>'Fig S3'!$AZ$346:$BH$346</c:f>
                <c:numCache>
                  <c:formatCode>General</c:formatCode>
                  <c:ptCount val="9"/>
                  <c:pt idx="0">
                    <c:v>1.1734434298180656E-2</c:v>
                  </c:pt>
                  <c:pt idx="1">
                    <c:v>3.0440759511081127E-2</c:v>
                  </c:pt>
                  <c:pt idx="2">
                    <c:v>3.4649364543149125E-2</c:v>
                  </c:pt>
                  <c:pt idx="3">
                    <c:v>3.2561710184898882E-2</c:v>
                  </c:pt>
                  <c:pt idx="4">
                    <c:v>3.1485355413635584E-2</c:v>
                  </c:pt>
                  <c:pt idx="5">
                    <c:v>5.4711407399262522E-2</c:v>
                  </c:pt>
                  <c:pt idx="6">
                    <c:v>5.6975137977747031E-2</c:v>
                  </c:pt>
                  <c:pt idx="7">
                    <c:v>5.5086070856630191E-2</c:v>
                  </c:pt>
                  <c:pt idx="8">
                    <c:v>5.5347202779987496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Q$345:$AY$345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Q$346:$AY$346</c:f>
              <c:numCache>
                <c:formatCode>0.000</c:formatCode>
                <c:ptCount val="9"/>
                <c:pt idx="0">
                  <c:v>0.48022852512997788</c:v>
                </c:pt>
                <c:pt idx="1">
                  <c:v>0.48689906437794084</c:v>
                </c:pt>
                <c:pt idx="2">
                  <c:v>0.5042945527022713</c:v>
                </c:pt>
                <c:pt idx="3">
                  <c:v>0.49002275864911438</c:v>
                </c:pt>
                <c:pt idx="4">
                  <c:v>0.54892764924236248</c:v>
                </c:pt>
                <c:pt idx="5">
                  <c:v>0.50264372069238605</c:v>
                </c:pt>
                <c:pt idx="6">
                  <c:v>0.49345143491544341</c:v>
                </c:pt>
                <c:pt idx="7">
                  <c:v>0.48442101174407348</c:v>
                </c:pt>
                <c:pt idx="8">
                  <c:v>0.4998714084786177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O$347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Z$347:$BH$347</c:f>
                <c:numCache>
                  <c:formatCode>General</c:formatCode>
                  <c:ptCount val="9"/>
                  <c:pt idx="0">
                    <c:v>6.62523383917831E-2</c:v>
                  </c:pt>
                  <c:pt idx="1">
                    <c:v>7.218568810742837E-2</c:v>
                  </c:pt>
                  <c:pt idx="2">
                    <c:v>7.8879229173749274E-2</c:v>
                  </c:pt>
                  <c:pt idx="3">
                    <c:v>6.9218515167524197E-2</c:v>
                  </c:pt>
                  <c:pt idx="4">
                    <c:v>6.6026671035875201E-2</c:v>
                  </c:pt>
                  <c:pt idx="5">
                    <c:v>6.5347919883006825E-2</c:v>
                  </c:pt>
                  <c:pt idx="6">
                    <c:v>7.1791430000956974E-2</c:v>
                  </c:pt>
                  <c:pt idx="7">
                    <c:v>5.8125101375644542E-2</c:v>
                  </c:pt>
                  <c:pt idx="8">
                    <c:v>6.8492279702421818E-2</c:v>
                  </c:pt>
                </c:numCache>
              </c:numRef>
            </c:plus>
            <c:minus>
              <c:numRef>
                <c:f>'Fig S3'!$AZ$347:$BH$347</c:f>
                <c:numCache>
                  <c:formatCode>General</c:formatCode>
                  <c:ptCount val="9"/>
                  <c:pt idx="0">
                    <c:v>6.62523383917831E-2</c:v>
                  </c:pt>
                  <c:pt idx="1">
                    <c:v>7.218568810742837E-2</c:v>
                  </c:pt>
                  <c:pt idx="2">
                    <c:v>7.8879229173749274E-2</c:v>
                  </c:pt>
                  <c:pt idx="3">
                    <c:v>6.9218515167524197E-2</c:v>
                  </c:pt>
                  <c:pt idx="4">
                    <c:v>6.6026671035875201E-2</c:v>
                  </c:pt>
                  <c:pt idx="5">
                    <c:v>6.5347919883006825E-2</c:v>
                  </c:pt>
                  <c:pt idx="6">
                    <c:v>7.1791430000956974E-2</c:v>
                  </c:pt>
                  <c:pt idx="7">
                    <c:v>5.8125101375644542E-2</c:v>
                  </c:pt>
                  <c:pt idx="8">
                    <c:v>6.8492279702421818E-2</c:v>
                  </c:pt>
                </c:numCache>
              </c:numRef>
            </c:minus>
          </c:errBars>
          <c:xVal>
            <c:numRef>
              <c:f>'Fig S3'!$AQ$345:$AY$345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Q$347:$AY$347</c:f>
              <c:numCache>
                <c:formatCode>0.000</c:formatCode>
                <c:ptCount val="9"/>
                <c:pt idx="0">
                  <c:v>0.5335575435894675</c:v>
                </c:pt>
                <c:pt idx="1">
                  <c:v>0.5351729590508677</c:v>
                </c:pt>
                <c:pt idx="2">
                  <c:v>0.53565922823485757</c:v>
                </c:pt>
                <c:pt idx="3">
                  <c:v>0.48539026292725251</c:v>
                </c:pt>
                <c:pt idx="4">
                  <c:v>0.57788127278585433</c:v>
                </c:pt>
                <c:pt idx="5">
                  <c:v>0.55502599773896621</c:v>
                </c:pt>
                <c:pt idx="6">
                  <c:v>0.52932608995939112</c:v>
                </c:pt>
                <c:pt idx="7">
                  <c:v>0.52546441490318219</c:v>
                </c:pt>
                <c:pt idx="8">
                  <c:v>0.5183023106513703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0075504"/>
        <c:axId val="280076624"/>
      </c:scatterChart>
      <c:valAx>
        <c:axId val="28007550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80076624"/>
        <c:crosses val="autoZero"/>
        <c:crossBetween val="midCat"/>
        <c:majorUnit val="2"/>
        <c:minorUnit val="1"/>
      </c:valAx>
      <c:valAx>
        <c:axId val="280076624"/>
        <c:scaling>
          <c:orientation val="minMax"/>
          <c:max val="1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280075504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O$348</c:f>
              <c:strCache>
                <c:ptCount val="1"/>
                <c:pt idx="0">
                  <c:v>high Rs</c:v>
                </c:pt>
              </c:strCache>
            </c:strRef>
          </c:tx>
          <c:spPr>
            <a:ln w="12700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Z$348:$BH$348</c:f>
                <c:numCache>
                  <c:formatCode>General</c:formatCode>
                  <c:ptCount val="9"/>
                  <c:pt idx="0">
                    <c:v>2.8373680097218454E-2</c:v>
                  </c:pt>
                  <c:pt idx="1">
                    <c:v>2.1718503965658643E-2</c:v>
                  </c:pt>
                  <c:pt idx="2">
                    <c:v>4.9162066944156667E-2</c:v>
                  </c:pt>
                  <c:pt idx="3">
                    <c:v>6.3337120479084033E-2</c:v>
                  </c:pt>
                  <c:pt idx="4">
                    <c:v>4.3360046080972783E-2</c:v>
                  </c:pt>
                  <c:pt idx="5">
                    <c:v>4.6038051929999359E-2</c:v>
                  </c:pt>
                  <c:pt idx="6">
                    <c:v>3.0043711494410433E-2</c:v>
                  </c:pt>
                  <c:pt idx="7">
                    <c:v>1.9218197533587344E-2</c:v>
                  </c:pt>
                  <c:pt idx="8">
                    <c:v>9.4663559481541745E-2</c:v>
                  </c:pt>
                </c:numCache>
              </c:numRef>
            </c:plus>
            <c:minus>
              <c:numRef>
                <c:f>'Fig S3'!$AZ$348:$BH$348</c:f>
                <c:numCache>
                  <c:formatCode>General</c:formatCode>
                  <c:ptCount val="9"/>
                  <c:pt idx="0">
                    <c:v>2.8373680097218454E-2</c:v>
                  </c:pt>
                  <c:pt idx="1">
                    <c:v>2.1718503965658643E-2</c:v>
                  </c:pt>
                  <c:pt idx="2">
                    <c:v>4.9162066944156667E-2</c:v>
                  </c:pt>
                  <c:pt idx="3">
                    <c:v>6.3337120479084033E-2</c:v>
                  </c:pt>
                  <c:pt idx="4">
                    <c:v>4.3360046080972783E-2</c:v>
                  </c:pt>
                  <c:pt idx="5">
                    <c:v>4.6038051929999359E-2</c:v>
                  </c:pt>
                  <c:pt idx="6">
                    <c:v>3.0043711494410433E-2</c:v>
                  </c:pt>
                  <c:pt idx="7">
                    <c:v>1.9218197533587344E-2</c:v>
                  </c:pt>
                  <c:pt idx="8">
                    <c:v>9.4663559481541745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Q$345:$AY$345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Q$348:$AY$348</c:f>
              <c:numCache>
                <c:formatCode>0.000</c:formatCode>
                <c:ptCount val="9"/>
                <c:pt idx="0">
                  <c:v>0.51582362260808379</c:v>
                </c:pt>
                <c:pt idx="1">
                  <c:v>0.51708996834581478</c:v>
                </c:pt>
                <c:pt idx="2">
                  <c:v>0.52182203702782393</c:v>
                </c:pt>
                <c:pt idx="3">
                  <c:v>0.43481733828688751</c:v>
                </c:pt>
                <c:pt idx="4">
                  <c:v>0.50389769899514714</c:v>
                </c:pt>
                <c:pt idx="5">
                  <c:v>0.52960570851904309</c:v>
                </c:pt>
                <c:pt idx="6">
                  <c:v>0.54670994855622923</c:v>
                </c:pt>
                <c:pt idx="7">
                  <c:v>0.51977491257254871</c:v>
                </c:pt>
                <c:pt idx="8">
                  <c:v>0.6301861873691004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O$349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Z$349:$BH$349</c:f>
                <c:numCache>
                  <c:formatCode>General</c:formatCode>
                  <c:ptCount val="9"/>
                  <c:pt idx="0">
                    <c:v>4.2338341620690327E-2</c:v>
                  </c:pt>
                  <c:pt idx="1">
                    <c:v>4.3275398387877258E-2</c:v>
                  </c:pt>
                  <c:pt idx="2">
                    <c:v>5.9069629284624697E-2</c:v>
                  </c:pt>
                  <c:pt idx="3">
                    <c:v>4.2442943533107569E-2</c:v>
                  </c:pt>
                  <c:pt idx="4">
                    <c:v>4.7964109397015842E-2</c:v>
                  </c:pt>
                  <c:pt idx="5">
                    <c:v>0.10587088796409173</c:v>
                  </c:pt>
                  <c:pt idx="6">
                    <c:v>0.12281227562729087</c:v>
                  </c:pt>
                  <c:pt idx="7">
                    <c:v>0.11603302878600739</c:v>
                  </c:pt>
                  <c:pt idx="8">
                    <c:v>0.1245703070986795</c:v>
                  </c:pt>
                </c:numCache>
              </c:numRef>
            </c:plus>
            <c:minus>
              <c:numRef>
                <c:f>'Fig S3'!$AZ$349:$BH$349</c:f>
                <c:numCache>
                  <c:formatCode>General</c:formatCode>
                  <c:ptCount val="9"/>
                  <c:pt idx="0">
                    <c:v>4.2338341620690327E-2</c:v>
                  </c:pt>
                  <c:pt idx="1">
                    <c:v>4.3275398387877258E-2</c:v>
                  </c:pt>
                  <c:pt idx="2">
                    <c:v>5.9069629284624697E-2</c:v>
                  </c:pt>
                  <c:pt idx="3">
                    <c:v>4.2442943533107569E-2</c:v>
                  </c:pt>
                  <c:pt idx="4">
                    <c:v>4.7964109397015842E-2</c:v>
                  </c:pt>
                  <c:pt idx="5">
                    <c:v>0.10587088796409173</c:v>
                  </c:pt>
                  <c:pt idx="6">
                    <c:v>0.12281227562729087</c:v>
                  </c:pt>
                  <c:pt idx="7">
                    <c:v>0.11603302878600739</c:v>
                  </c:pt>
                  <c:pt idx="8">
                    <c:v>0.1245703070986795</c:v>
                  </c:pt>
                </c:numCache>
              </c:numRef>
            </c:minus>
          </c:errBars>
          <c:xVal>
            <c:numRef>
              <c:f>'Fig S3'!$AQ$345:$AY$345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Q$349:$AY$349</c:f>
              <c:numCache>
                <c:formatCode>0.000</c:formatCode>
                <c:ptCount val="9"/>
                <c:pt idx="0">
                  <c:v>0.59402979595604821</c:v>
                </c:pt>
                <c:pt idx="1">
                  <c:v>0.56928759487915803</c:v>
                </c:pt>
                <c:pt idx="2">
                  <c:v>0.60458736972646965</c:v>
                </c:pt>
                <c:pt idx="3">
                  <c:v>0.55152215361936219</c:v>
                </c:pt>
                <c:pt idx="4">
                  <c:v>0.58382012983805487</c:v>
                </c:pt>
                <c:pt idx="5">
                  <c:v>0.63473188571047401</c:v>
                </c:pt>
                <c:pt idx="6">
                  <c:v>0.72394501001169809</c:v>
                </c:pt>
                <c:pt idx="7">
                  <c:v>0.57148632716239756</c:v>
                </c:pt>
                <c:pt idx="8">
                  <c:v>0.7164598282909487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0068224"/>
        <c:axId val="280074944"/>
      </c:scatterChart>
      <c:valAx>
        <c:axId val="28006822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80074944"/>
        <c:crosses val="autoZero"/>
        <c:crossBetween val="midCat"/>
        <c:majorUnit val="2"/>
        <c:minorUnit val="1"/>
      </c:valAx>
      <c:valAx>
        <c:axId val="280074944"/>
        <c:scaling>
          <c:orientation val="minMax"/>
          <c:max val="1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280068224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O$350</c:f>
              <c:strCache>
                <c:ptCount val="1"/>
                <c:pt idx="0">
                  <c:v>high Rs</c:v>
                </c:pt>
              </c:strCache>
            </c:strRef>
          </c:tx>
          <c:spPr>
            <a:ln w="12700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Z$350:$BH$350</c:f>
                <c:numCache>
                  <c:formatCode>General</c:formatCode>
                  <c:ptCount val="9"/>
                  <c:pt idx="0">
                    <c:v>5.8832712633003624E-2</c:v>
                  </c:pt>
                  <c:pt idx="1">
                    <c:v>3.7030450441986322E-2</c:v>
                  </c:pt>
                  <c:pt idx="2">
                    <c:v>3.267268495049773E-2</c:v>
                  </c:pt>
                  <c:pt idx="3">
                    <c:v>4.9739064545826855E-2</c:v>
                  </c:pt>
                  <c:pt idx="4">
                    <c:v>4.5642310760295381E-2</c:v>
                  </c:pt>
                  <c:pt idx="5">
                    <c:v>4.8203230805764156E-2</c:v>
                  </c:pt>
                  <c:pt idx="6">
                    <c:v>0.15879273612408934</c:v>
                  </c:pt>
                  <c:pt idx="7">
                    <c:v>0.1450433213928505</c:v>
                  </c:pt>
                  <c:pt idx="8">
                    <c:v>0.13683416902543685</c:v>
                  </c:pt>
                </c:numCache>
              </c:numRef>
            </c:plus>
            <c:minus>
              <c:numRef>
                <c:f>'Fig S3'!$AZ$350:$BH$350</c:f>
                <c:numCache>
                  <c:formatCode>General</c:formatCode>
                  <c:ptCount val="9"/>
                  <c:pt idx="0">
                    <c:v>5.8832712633003624E-2</c:v>
                  </c:pt>
                  <c:pt idx="1">
                    <c:v>3.7030450441986322E-2</c:v>
                  </c:pt>
                  <c:pt idx="2">
                    <c:v>3.267268495049773E-2</c:v>
                  </c:pt>
                  <c:pt idx="3">
                    <c:v>4.9739064545826855E-2</c:v>
                  </c:pt>
                  <c:pt idx="4">
                    <c:v>4.5642310760295381E-2</c:v>
                  </c:pt>
                  <c:pt idx="5">
                    <c:v>4.8203230805764156E-2</c:v>
                  </c:pt>
                  <c:pt idx="6">
                    <c:v>0.15879273612408934</c:v>
                  </c:pt>
                  <c:pt idx="7">
                    <c:v>0.1450433213928505</c:v>
                  </c:pt>
                  <c:pt idx="8">
                    <c:v>0.13683416902543685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Q$345:$AY$345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Q$350:$AY$350</c:f>
              <c:numCache>
                <c:formatCode>0.000</c:formatCode>
                <c:ptCount val="9"/>
                <c:pt idx="0">
                  <c:v>0.44962679171308811</c:v>
                </c:pt>
                <c:pt idx="1">
                  <c:v>0.45420699925639985</c:v>
                </c:pt>
                <c:pt idx="2">
                  <c:v>0.49876992160749634</c:v>
                </c:pt>
                <c:pt idx="3">
                  <c:v>0.43637502189785782</c:v>
                </c:pt>
                <c:pt idx="4">
                  <c:v>0.40470090144228782</c:v>
                </c:pt>
                <c:pt idx="5">
                  <c:v>0.48031375981636754</c:v>
                </c:pt>
                <c:pt idx="6">
                  <c:v>0.51080499524907552</c:v>
                </c:pt>
                <c:pt idx="7">
                  <c:v>0.51745202612916574</c:v>
                </c:pt>
                <c:pt idx="8">
                  <c:v>0.5112147907011395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O$351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Z$351:$BH$351</c:f>
                <c:numCache>
                  <c:formatCode>General</c:formatCode>
                  <c:ptCount val="9"/>
                  <c:pt idx="0">
                    <c:v>8.241769216240917E-2</c:v>
                  </c:pt>
                  <c:pt idx="1">
                    <c:v>6.2833203063113616E-2</c:v>
                  </c:pt>
                  <c:pt idx="2">
                    <c:v>6.0134420131611958E-2</c:v>
                  </c:pt>
                  <c:pt idx="3">
                    <c:v>0.11372615858681263</c:v>
                  </c:pt>
                  <c:pt idx="4">
                    <c:v>6.7316501109764615E-2</c:v>
                  </c:pt>
                  <c:pt idx="5">
                    <c:v>6.8097524761294909E-2</c:v>
                  </c:pt>
                  <c:pt idx="6">
                    <c:v>6.1040122618970273E-2</c:v>
                  </c:pt>
                  <c:pt idx="7">
                    <c:v>0.10748246466769794</c:v>
                  </c:pt>
                  <c:pt idx="8">
                    <c:v>9.5987482102128152E-2</c:v>
                  </c:pt>
                </c:numCache>
              </c:numRef>
            </c:plus>
            <c:minus>
              <c:numRef>
                <c:f>'Fig S3'!$AZ$351:$BH$351</c:f>
                <c:numCache>
                  <c:formatCode>General</c:formatCode>
                  <c:ptCount val="9"/>
                  <c:pt idx="0">
                    <c:v>8.241769216240917E-2</c:v>
                  </c:pt>
                  <c:pt idx="1">
                    <c:v>6.2833203063113616E-2</c:v>
                  </c:pt>
                  <c:pt idx="2">
                    <c:v>6.0134420131611958E-2</c:v>
                  </c:pt>
                  <c:pt idx="3">
                    <c:v>0.11372615858681263</c:v>
                  </c:pt>
                  <c:pt idx="4">
                    <c:v>6.7316501109764615E-2</c:v>
                  </c:pt>
                  <c:pt idx="5">
                    <c:v>6.8097524761294909E-2</c:v>
                  </c:pt>
                  <c:pt idx="6">
                    <c:v>6.1040122618970273E-2</c:v>
                  </c:pt>
                  <c:pt idx="7">
                    <c:v>0.10748246466769794</c:v>
                  </c:pt>
                  <c:pt idx="8">
                    <c:v>9.5987482102128152E-2</c:v>
                  </c:pt>
                </c:numCache>
              </c:numRef>
            </c:minus>
          </c:errBars>
          <c:xVal>
            <c:numRef>
              <c:f>'Fig S3'!$AQ$345:$AY$345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Q$351:$AY$351</c:f>
              <c:numCache>
                <c:formatCode>0.000</c:formatCode>
                <c:ptCount val="9"/>
                <c:pt idx="0">
                  <c:v>0.39967841488993772</c:v>
                </c:pt>
                <c:pt idx="1">
                  <c:v>0.53206714083582907</c:v>
                </c:pt>
                <c:pt idx="2">
                  <c:v>0.57518578152335365</c:v>
                </c:pt>
                <c:pt idx="3">
                  <c:v>0.4853213662666046</c:v>
                </c:pt>
                <c:pt idx="4">
                  <c:v>0.5574326457133999</c:v>
                </c:pt>
                <c:pt idx="5">
                  <c:v>0.61232053549925369</c:v>
                </c:pt>
                <c:pt idx="6">
                  <c:v>0.60269831834877174</c:v>
                </c:pt>
                <c:pt idx="7">
                  <c:v>0.66579800287207092</c:v>
                </c:pt>
                <c:pt idx="8">
                  <c:v>0.6831986863766397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0069904"/>
        <c:axId val="280070464"/>
      </c:scatterChart>
      <c:valAx>
        <c:axId val="28006990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80070464"/>
        <c:crosses val="autoZero"/>
        <c:crossBetween val="midCat"/>
        <c:majorUnit val="2"/>
        <c:minorUnit val="1"/>
      </c:valAx>
      <c:valAx>
        <c:axId val="280070464"/>
        <c:scaling>
          <c:orientation val="minMax"/>
          <c:max val="1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280069904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O$352</c:f>
              <c:strCache>
                <c:ptCount val="1"/>
                <c:pt idx="0">
                  <c:v>high Rs</c:v>
                </c:pt>
              </c:strCache>
            </c:strRef>
          </c:tx>
          <c:spPr>
            <a:ln w="12700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Z$352:$BH$352</c:f>
                <c:numCache>
                  <c:formatCode>General</c:formatCode>
                  <c:ptCount val="9"/>
                  <c:pt idx="0">
                    <c:v>5.0233660759637082E-2</c:v>
                  </c:pt>
                  <c:pt idx="1">
                    <c:v>4.6355481148463558E-2</c:v>
                  </c:pt>
                  <c:pt idx="2">
                    <c:v>9.9476743359629111E-2</c:v>
                  </c:pt>
                  <c:pt idx="3">
                    <c:v>3.2995354317759941E-2</c:v>
                  </c:pt>
                  <c:pt idx="4">
                    <c:v>0.1345382828881693</c:v>
                  </c:pt>
                  <c:pt idx="5">
                    <c:v>0.13959487530247996</c:v>
                  </c:pt>
                  <c:pt idx="6">
                    <c:v>0.15132132336717505</c:v>
                  </c:pt>
                  <c:pt idx="7">
                    <c:v>0.17655007775444448</c:v>
                  </c:pt>
                  <c:pt idx="8">
                    <c:v>0.15870165973013592</c:v>
                  </c:pt>
                </c:numCache>
              </c:numRef>
            </c:plus>
            <c:minus>
              <c:numRef>
                <c:f>'Fig S3'!$AZ$352:$BH$352</c:f>
                <c:numCache>
                  <c:formatCode>General</c:formatCode>
                  <c:ptCount val="9"/>
                  <c:pt idx="0">
                    <c:v>5.0233660759637082E-2</c:v>
                  </c:pt>
                  <c:pt idx="1">
                    <c:v>4.6355481148463558E-2</c:v>
                  </c:pt>
                  <c:pt idx="2">
                    <c:v>9.9476743359629111E-2</c:v>
                  </c:pt>
                  <c:pt idx="3">
                    <c:v>3.2995354317759941E-2</c:v>
                  </c:pt>
                  <c:pt idx="4">
                    <c:v>0.1345382828881693</c:v>
                  </c:pt>
                  <c:pt idx="5">
                    <c:v>0.13959487530247996</c:v>
                  </c:pt>
                  <c:pt idx="6">
                    <c:v>0.15132132336717505</c:v>
                  </c:pt>
                  <c:pt idx="7">
                    <c:v>0.17655007775444448</c:v>
                  </c:pt>
                  <c:pt idx="8">
                    <c:v>0.1587016597301359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Q$345:$AY$345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Q$352:$AY$352</c:f>
              <c:numCache>
                <c:formatCode>0.000</c:formatCode>
                <c:ptCount val="9"/>
                <c:pt idx="0">
                  <c:v>0.47974684665567563</c:v>
                </c:pt>
                <c:pt idx="1">
                  <c:v>0.46044370671737217</c:v>
                </c:pt>
                <c:pt idx="2">
                  <c:v>0.65232483044032763</c:v>
                </c:pt>
                <c:pt idx="3">
                  <c:v>0.47117195125080802</c:v>
                </c:pt>
                <c:pt idx="4">
                  <c:v>0.53933350917443179</c:v>
                </c:pt>
                <c:pt idx="5">
                  <c:v>0.78564322938770981</c:v>
                </c:pt>
                <c:pt idx="6">
                  <c:v>0.75580411202156572</c:v>
                </c:pt>
                <c:pt idx="7">
                  <c:v>0.72061041163639084</c:v>
                </c:pt>
                <c:pt idx="8">
                  <c:v>0.7469580235247914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O$353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Z$353:$BH$353</c:f>
                <c:numCache>
                  <c:formatCode>General</c:formatCode>
                  <c:ptCount val="9"/>
                  <c:pt idx="0">
                    <c:v>5.1156125189531304E-2</c:v>
                  </c:pt>
                  <c:pt idx="1">
                    <c:v>4.3340215008592302E-2</c:v>
                  </c:pt>
                  <c:pt idx="2">
                    <c:v>5.1428471903488912E-2</c:v>
                  </c:pt>
                  <c:pt idx="3">
                    <c:v>8.0037084651211912E-2</c:v>
                  </c:pt>
                  <c:pt idx="4">
                    <c:v>5.0969515639079234E-2</c:v>
                  </c:pt>
                  <c:pt idx="5">
                    <c:v>0.11661593011649336</c:v>
                  </c:pt>
                  <c:pt idx="6">
                    <c:v>0.12680758402308631</c:v>
                  </c:pt>
                  <c:pt idx="7">
                    <c:v>0.14933045105467968</c:v>
                  </c:pt>
                  <c:pt idx="8">
                    <c:v>0.18251891239026466</c:v>
                  </c:pt>
                </c:numCache>
              </c:numRef>
            </c:plus>
            <c:minus>
              <c:numRef>
                <c:f>'Fig S3'!$AZ$353:$BH$353</c:f>
                <c:numCache>
                  <c:formatCode>General</c:formatCode>
                  <c:ptCount val="9"/>
                  <c:pt idx="0">
                    <c:v>5.1156125189531304E-2</c:v>
                  </c:pt>
                  <c:pt idx="1">
                    <c:v>4.3340215008592302E-2</c:v>
                  </c:pt>
                  <c:pt idx="2">
                    <c:v>5.1428471903488912E-2</c:v>
                  </c:pt>
                  <c:pt idx="3">
                    <c:v>8.0037084651211912E-2</c:v>
                  </c:pt>
                  <c:pt idx="4">
                    <c:v>5.0969515639079234E-2</c:v>
                  </c:pt>
                  <c:pt idx="5">
                    <c:v>0.11661593011649336</c:v>
                  </c:pt>
                  <c:pt idx="6">
                    <c:v>0.12680758402308631</c:v>
                  </c:pt>
                  <c:pt idx="7">
                    <c:v>0.14933045105467968</c:v>
                  </c:pt>
                  <c:pt idx="8">
                    <c:v>0.18251891239026466</c:v>
                  </c:pt>
                </c:numCache>
              </c:numRef>
            </c:minus>
          </c:errBars>
          <c:xVal>
            <c:numRef>
              <c:f>'Fig S3'!$AQ$345:$AY$345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Q$353:$AY$353</c:f>
              <c:numCache>
                <c:formatCode>0.000</c:formatCode>
                <c:ptCount val="9"/>
                <c:pt idx="0">
                  <c:v>0.58194319362101044</c:v>
                </c:pt>
                <c:pt idx="1">
                  <c:v>0.56890965194503862</c:v>
                </c:pt>
                <c:pt idx="2">
                  <c:v>0.55992271887990441</c:v>
                </c:pt>
                <c:pt idx="3">
                  <c:v>0.58174570159568173</c:v>
                </c:pt>
                <c:pt idx="4">
                  <c:v>0.47413116394440935</c:v>
                </c:pt>
                <c:pt idx="5">
                  <c:v>0.81077287013084176</c:v>
                </c:pt>
                <c:pt idx="6">
                  <c:v>0.79334821979519199</c:v>
                </c:pt>
                <c:pt idx="7">
                  <c:v>0.75730467537734936</c:v>
                </c:pt>
                <c:pt idx="8">
                  <c:v>0.7022581888448875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0069344"/>
        <c:axId val="280077744"/>
      </c:scatterChart>
      <c:valAx>
        <c:axId val="28006934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80077744"/>
        <c:crosses val="autoZero"/>
        <c:crossBetween val="midCat"/>
        <c:majorUnit val="2"/>
        <c:minorUnit val="1"/>
      </c:valAx>
      <c:valAx>
        <c:axId val="280077744"/>
        <c:scaling>
          <c:orientation val="minMax"/>
          <c:max val="1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280069344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K$196</c:f>
              <c:strCache>
                <c:ptCount val="1"/>
                <c:pt idx="0">
                  <c:v>high R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rgbClr val="C0C0C0"/>
                </a:solidFill>
              </a:ln>
            </c:spPr>
          </c:marker>
          <c:trendline>
            <c:spPr>
              <a:ln>
                <a:solidFill>
                  <a:srgbClr val="C0C0C0"/>
                </a:solidFill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3'!$AX$198:$BB$198</c:f>
                <c:numCache>
                  <c:formatCode>General</c:formatCode>
                  <c:ptCount val="5"/>
                  <c:pt idx="0">
                    <c:v>0.47827597317805082</c:v>
                  </c:pt>
                  <c:pt idx="1">
                    <c:v>0.46877340654808269</c:v>
                  </c:pt>
                  <c:pt idx="2">
                    <c:v>0.38641755064670402</c:v>
                  </c:pt>
                  <c:pt idx="3">
                    <c:v>0.34475197674490626</c:v>
                  </c:pt>
                  <c:pt idx="4">
                    <c:v>0.59959022621367608</c:v>
                  </c:pt>
                </c:numCache>
              </c:numRef>
            </c:plus>
            <c:minus>
              <c:numRef>
                <c:f>'Fig S3'!$AX$198:$BB$198</c:f>
                <c:numCache>
                  <c:formatCode>General</c:formatCode>
                  <c:ptCount val="5"/>
                  <c:pt idx="0">
                    <c:v>0.47827597317805082</c:v>
                  </c:pt>
                  <c:pt idx="1">
                    <c:v>0.46877340654808269</c:v>
                  </c:pt>
                  <c:pt idx="2">
                    <c:v>0.38641755064670402</c:v>
                  </c:pt>
                  <c:pt idx="3">
                    <c:v>0.34475197674490626</c:v>
                  </c:pt>
                  <c:pt idx="4">
                    <c:v>0.59959022621367608</c:v>
                  </c:pt>
                </c:numCache>
              </c:numRef>
            </c:minus>
            <c:spPr>
              <a:ln>
                <a:solidFill>
                  <a:prstClr val="white">
                    <a:lumMod val="65000"/>
                  </a:prstClr>
                </a:solidFill>
              </a:ln>
            </c:spPr>
          </c:errBars>
          <c:xVal>
            <c:numRef>
              <c:f>'Fig S3'!$AP$191:$AT$191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3'!$AP$198:$AT$198</c:f>
              <c:numCache>
                <c:formatCode>0.000</c:formatCode>
                <c:ptCount val="5"/>
                <c:pt idx="0">
                  <c:v>1.7455829675106354</c:v>
                </c:pt>
                <c:pt idx="1">
                  <c:v>2.4429142830047255</c:v>
                </c:pt>
                <c:pt idx="2">
                  <c:v>1.3887064534861153</c:v>
                </c:pt>
                <c:pt idx="3">
                  <c:v>1.2356447560007302</c:v>
                </c:pt>
                <c:pt idx="4">
                  <c:v>1.375579037530516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K$197</c:f>
              <c:strCache>
                <c:ptCount val="1"/>
                <c:pt idx="0">
                  <c:v>low R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3'!$AX$199:$BB$199</c:f>
                <c:numCache>
                  <c:formatCode>General</c:formatCode>
                  <c:ptCount val="5"/>
                  <c:pt idx="0">
                    <c:v>0.82438941807039257</c:v>
                  </c:pt>
                  <c:pt idx="1">
                    <c:v>0.82492646354517485</c:v>
                  </c:pt>
                  <c:pt idx="2">
                    <c:v>0.42195693787660504</c:v>
                  </c:pt>
                  <c:pt idx="3">
                    <c:v>0.72140583264100278</c:v>
                  </c:pt>
                  <c:pt idx="4">
                    <c:v>0.49089751868726744</c:v>
                  </c:pt>
                </c:numCache>
              </c:numRef>
            </c:plus>
            <c:minus>
              <c:numRef>
                <c:f>'Fig S3'!$AX$199:$BB$199</c:f>
                <c:numCache>
                  <c:formatCode>General</c:formatCode>
                  <c:ptCount val="5"/>
                  <c:pt idx="0">
                    <c:v>0.82438941807039257</c:v>
                  </c:pt>
                  <c:pt idx="1">
                    <c:v>0.82492646354517485</c:v>
                  </c:pt>
                  <c:pt idx="2">
                    <c:v>0.42195693787660504</c:v>
                  </c:pt>
                  <c:pt idx="3">
                    <c:v>0.72140583264100278</c:v>
                  </c:pt>
                  <c:pt idx="4">
                    <c:v>0.49089751868726744</c:v>
                  </c:pt>
                </c:numCache>
              </c:numRef>
            </c:minus>
          </c:errBars>
          <c:xVal>
            <c:numRef>
              <c:f>'Fig S3'!$AP$191:$AT$191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3'!$AP$199:$AT$199</c:f>
              <c:numCache>
                <c:formatCode>0.000</c:formatCode>
                <c:ptCount val="5"/>
                <c:pt idx="0">
                  <c:v>2.8957076578011076</c:v>
                </c:pt>
                <c:pt idx="1">
                  <c:v>2.8156969232595261</c:v>
                </c:pt>
                <c:pt idx="2">
                  <c:v>1.6386119949398563</c:v>
                </c:pt>
                <c:pt idx="3">
                  <c:v>1.972941090073268</c:v>
                </c:pt>
                <c:pt idx="4">
                  <c:v>1.6254265970360045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S3'!$AJ$186</c:f>
              <c:strCache>
                <c:ptCount val="1"/>
                <c:pt idx="0">
                  <c:v>high before stres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U$198:$AW$198</c:f>
                <c:numCache>
                  <c:formatCode>General</c:formatCode>
                  <c:ptCount val="3"/>
                  <c:pt idx="0">
                    <c:v>0.10269553164376909</c:v>
                  </c:pt>
                  <c:pt idx="1">
                    <c:v>0.41916688489975262</c:v>
                  </c:pt>
                  <c:pt idx="2">
                    <c:v>0.31206628175105317</c:v>
                  </c:pt>
                </c:numCache>
              </c:numRef>
            </c:plus>
            <c:minus>
              <c:numRef>
                <c:f>'Fig S3'!$AU$198:$AW$198</c:f>
                <c:numCache>
                  <c:formatCode>General</c:formatCode>
                  <c:ptCount val="3"/>
                  <c:pt idx="0">
                    <c:v>0.10269553164376909</c:v>
                  </c:pt>
                  <c:pt idx="1">
                    <c:v>0.41916688489975262</c:v>
                  </c:pt>
                  <c:pt idx="2">
                    <c:v>0.31206628175105317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M$191:$AO$191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3'!$AM$198:$AO$198</c:f>
              <c:numCache>
                <c:formatCode>0.000</c:formatCode>
                <c:ptCount val="3"/>
                <c:pt idx="0">
                  <c:v>2.0274813407755881</c:v>
                </c:pt>
                <c:pt idx="1">
                  <c:v>2.0822589611291797</c:v>
                </c:pt>
                <c:pt idx="2">
                  <c:v>1.9134504082731969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S3'!$AJ$187</c:f>
              <c:strCache>
                <c:ptCount val="1"/>
                <c:pt idx="0">
                  <c:v>low below  stres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U$199:$AW$199</c:f>
                <c:numCache>
                  <c:formatCode>General</c:formatCode>
                  <c:ptCount val="3"/>
                  <c:pt idx="0">
                    <c:v>0.3131204196513071</c:v>
                  </c:pt>
                  <c:pt idx="1">
                    <c:v>0.72018139517940649</c:v>
                  </c:pt>
                  <c:pt idx="2">
                    <c:v>0.63429991399123664</c:v>
                  </c:pt>
                </c:numCache>
              </c:numRef>
            </c:plus>
            <c:minus>
              <c:numRef>
                <c:f>'Fig S3'!$AU$199:$AW$199</c:f>
                <c:numCache>
                  <c:formatCode>General</c:formatCode>
                  <c:ptCount val="3"/>
                  <c:pt idx="0">
                    <c:v>0.3131204196513071</c:v>
                  </c:pt>
                  <c:pt idx="1">
                    <c:v>0.72018139517940649</c:v>
                  </c:pt>
                  <c:pt idx="2">
                    <c:v>0.63429991399123664</c:v>
                  </c:pt>
                </c:numCache>
              </c:numRef>
            </c:minus>
          </c:errBars>
          <c:xVal>
            <c:numRef>
              <c:f>'Fig S3'!$AM$191:$AO$191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3'!$AM$199:$AO$199</c:f>
              <c:numCache>
                <c:formatCode>0.000</c:formatCode>
                <c:ptCount val="3"/>
                <c:pt idx="0">
                  <c:v>2.3239708264042056</c:v>
                </c:pt>
                <c:pt idx="1">
                  <c:v>2.6116222374920808</c:v>
                </c:pt>
                <c:pt idx="2">
                  <c:v>3.645748988932725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80080544"/>
        <c:axId val="373576912"/>
      </c:scatterChart>
      <c:valAx>
        <c:axId val="28008054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73576912"/>
        <c:crosses val="autoZero"/>
        <c:crossBetween val="midCat"/>
        <c:majorUnit val="2"/>
        <c:minorUnit val="1"/>
      </c:valAx>
      <c:valAx>
        <c:axId val="373576912"/>
        <c:scaling>
          <c:orientation val="minMax"/>
          <c:max val="6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280080544"/>
        <c:crossesAt val="-11"/>
        <c:crossBetween val="midCat"/>
        <c:majorUnit val="1"/>
        <c:min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K$196</c:f>
              <c:strCache>
                <c:ptCount val="1"/>
                <c:pt idx="0">
                  <c:v>high R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rgbClr val="C0C0C0"/>
                </a:solidFill>
              </a:ln>
            </c:spPr>
          </c:marker>
          <c:trendline>
            <c:spPr>
              <a:ln>
                <a:solidFill>
                  <a:srgbClr val="C0C0C0"/>
                </a:solidFill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3'!$AX$196:$BB$196</c:f>
                <c:numCache>
                  <c:formatCode>General</c:formatCode>
                  <c:ptCount val="5"/>
                  <c:pt idx="0">
                    <c:v>0.23698531005144555</c:v>
                  </c:pt>
                  <c:pt idx="1">
                    <c:v>0.16123715823821166</c:v>
                  </c:pt>
                  <c:pt idx="2">
                    <c:v>0.28361083585803598</c:v>
                  </c:pt>
                  <c:pt idx="3">
                    <c:v>0.54953561705652998</c:v>
                  </c:pt>
                  <c:pt idx="4">
                    <c:v>0.37479633600529655</c:v>
                  </c:pt>
                </c:numCache>
              </c:numRef>
            </c:plus>
            <c:minus>
              <c:numRef>
                <c:f>'Fig S3'!$AX$196:$BB$196</c:f>
                <c:numCache>
                  <c:formatCode>General</c:formatCode>
                  <c:ptCount val="5"/>
                  <c:pt idx="0">
                    <c:v>0.23698531005144555</c:v>
                  </c:pt>
                  <c:pt idx="1">
                    <c:v>0.16123715823821166</c:v>
                  </c:pt>
                  <c:pt idx="2">
                    <c:v>0.28361083585803598</c:v>
                  </c:pt>
                  <c:pt idx="3">
                    <c:v>0.54953561705652998</c:v>
                  </c:pt>
                  <c:pt idx="4">
                    <c:v>0.37479633600529655</c:v>
                  </c:pt>
                </c:numCache>
              </c:numRef>
            </c:minus>
            <c:spPr>
              <a:ln>
                <a:solidFill>
                  <a:prstClr val="white">
                    <a:lumMod val="65000"/>
                  </a:prstClr>
                </a:solidFill>
              </a:ln>
            </c:spPr>
          </c:errBars>
          <c:xVal>
            <c:numRef>
              <c:f>'Fig S3'!$AP$191:$AT$191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3'!$AP$196:$AT$196</c:f>
              <c:numCache>
                <c:formatCode>0.000</c:formatCode>
                <c:ptCount val="5"/>
                <c:pt idx="0">
                  <c:v>2.4983637993227452</c:v>
                </c:pt>
                <c:pt idx="1">
                  <c:v>2.0254354521792521</c:v>
                </c:pt>
                <c:pt idx="2">
                  <c:v>2.3812127679281581</c:v>
                </c:pt>
                <c:pt idx="3">
                  <c:v>1.8557268478446265</c:v>
                </c:pt>
                <c:pt idx="4">
                  <c:v>1.280838460707112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K$197</c:f>
              <c:strCache>
                <c:ptCount val="1"/>
                <c:pt idx="0">
                  <c:v>low R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3'!$AX$197:$BB$197</c:f>
                <c:numCache>
                  <c:formatCode>General</c:formatCode>
                  <c:ptCount val="5"/>
                  <c:pt idx="0">
                    <c:v>0.728459571722614</c:v>
                  </c:pt>
                  <c:pt idx="1">
                    <c:v>0.51399879168683504</c:v>
                  </c:pt>
                  <c:pt idx="2">
                    <c:v>0.24010548225673228</c:v>
                  </c:pt>
                  <c:pt idx="3">
                    <c:v>1.0584065789739237</c:v>
                  </c:pt>
                  <c:pt idx="4">
                    <c:v>0.45362365366134833</c:v>
                  </c:pt>
                </c:numCache>
              </c:numRef>
            </c:plus>
            <c:minus>
              <c:numRef>
                <c:f>'Fig S3'!$AX$197:$BB$197</c:f>
                <c:numCache>
                  <c:formatCode>General</c:formatCode>
                  <c:ptCount val="5"/>
                  <c:pt idx="0">
                    <c:v>0.728459571722614</c:v>
                  </c:pt>
                  <c:pt idx="1">
                    <c:v>0.51399879168683504</c:v>
                  </c:pt>
                  <c:pt idx="2">
                    <c:v>0.24010548225673228</c:v>
                  </c:pt>
                  <c:pt idx="3">
                    <c:v>1.0584065789739237</c:v>
                  </c:pt>
                  <c:pt idx="4">
                    <c:v>0.45362365366134833</c:v>
                  </c:pt>
                </c:numCache>
              </c:numRef>
            </c:minus>
          </c:errBars>
          <c:xVal>
            <c:numRef>
              <c:f>'Fig S3'!$AP$191:$AT$191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3'!$AP$197:$AT$197</c:f>
              <c:numCache>
                <c:formatCode>0.000</c:formatCode>
                <c:ptCount val="5"/>
                <c:pt idx="0">
                  <c:v>3.8818123973762972</c:v>
                </c:pt>
                <c:pt idx="1">
                  <c:v>2.3470431170394863</c:v>
                </c:pt>
                <c:pt idx="2">
                  <c:v>2.4723322485053005</c:v>
                </c:pt>
                <c:pt idx="3">
                  <c:v>2.9594602665228509</c:v>
                </c:pt>
                <c:pt idx="4">
                  <c:v>1.6718795351799685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S3'!$AJ$186</c:f>
              <c:strCache>
                <c:ptCount val="1"/>
                <c:pt idx="0">
                  <c:v>high before stres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U$196:$AW$196</c:f>
                <c:numCache>
                  <c:formatCode>General</c:formatCode>
                  <c:ptCount val="3"/>
                  <c:pt idx="0">
                    <c:v>0.31749443076996359</c:v>
                  </c:pt>
                  <c:pt idx="1">
                    <c:v>0.41102526187859706</c:v>
                  </c:pt>
                  <c:pt idx="2">
                    <c:v>0.31301612784473198</c:v>
                  </c:pt>
                </c:numCache>
              </c:numRef>
            </c:plus>
            <c:minus>
              <c:numRef>
                <c:f>'Fig S3'!$AU$196:$AW$196</c:f>
                <c:numCache>
                  <c:formatCode>General</c:formatCode>
                  <c:ptCount val="3"/>
                  <c:pt idx="0">
                    <c:v>0.31749443076996359</c:v>
                  </c:pt>
                  <c:pt idx="1">
                    <c:v>0.41102526187859706</c:v>
                  </c:pt>
                  <c:pt idx="2">
                    <c:v>0.31301612784473198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M$191:$AO$191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3'!$AM$196:$AO$196</c:f>
              <c:numCache>
                <c:formatCode>0.000</c:formatCode>
                <c:ptCount val="3"/>
                <c:pt idx="0">
                  <c:v>2.2720799048958638</c:v>
                </c:pt>
                <c:pt idx="1">
                  <c:v>2.0596356102990239</c:v>
                </c:pt>
                <c:pt idx="2">
                  <c:v>2.4548803628291838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S3'!$AJ$187</c:f>
              <c:strCache>
                <c:ptCount val="1"/>
                <c:pt idx="0">
                  <c:v>low below  stres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U$197:$AW$197</c:f>
                <c:numCache>
                  <c:formatCode>General</c:formatCode>
                  <c:ptCount val="3"/>
                  <c:pt idx="0">
                    <c:v>0.4270152830264779</c:v>
                  </c:pt>
                  <c:pt idx="1">
                    <c:v>0.69707711668623629</c:v>
                  </c:pt>
                  <c:pt idx="2">
                    <c:v>0.63120234869639613</c:v>
                  </c:pt>
                </c:numCache>
              </c:numRef>
            </c:plus>
            <c:minus>
              <c:numRef>
                <c:f>'Fig S3'!$AU$197:$AW$197</c:f>
                <c:numCache>
                  <c:formatCode>General</c:formatCode>
                  <c:ptCount val="3"/>
                  <c:pt idx="0">
                    <c:v>0.4270152830264779</c:v>
                  </c:pt>
                  <c:pt idx="1">
                    <c:v>0.69707711668623629</c:v>
                  </c:pt>
                  <c:pt idx="2">
                    <c:v>0.63120234869639613</c:v>
                  </c:pt>
                </c:numCache>
              </c:numRef>
            </c:minus>
          </c:errBars>
          <c:xVal>
            <c:numRef>
              <c:f>'Fig S3'!$AM$191:$AO$191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3'!$AM$197:$AO$197</c:f>
              <c:numCache>
                <c:formatCode>0.000</c:formatCode>
                <c:ptCount val="3"/>
                <c:pt idx="0">
                  <c:v>2.6477721513609822</c:v>
                </c:pt>
                <c:pt idx="1">
                  <c:v>2.6325454539611086</c:v>
                </c:pt>
                <c:pt idx="2">
                  <c:v>3.641228554496624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3581392"/>
        <c:axId val="373581952"/>
      </c:scatterChart>
      <c:valAx>
        <c:axId val="37358139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73581952"/>
        <c:crosses val="autoZero"/>
        <c:crossBetween val="midCat"/>
        <c:majorUnit val="2"/>
        <c:minorUnit val="1"/>
      </c:valAx>
      <c:valAx>
        <c:axId val="373581952"/>
        <c:scaling>
          <c:orientation val="minMax"/>
          <c:max val="6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73581392"/>
        <c:crossesAt val="-11"/>
        <c:crossBetween val="midCat"/>
        <c:majorUnit val="1"/>
        <c:min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K$194</c:f>
              <c:strCache>
                <c:ptCount val="1"/>
                <c:pt idx="0">
                  <c:v>high R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rgbClr val="C0C0C0"/>
                </a:solidFill>
              </a:ln>
            </c:spPr>
          </c:marker>
          <c:trendline>
            <c:spPr>
              <a:ln>
                <a:solidFill>
                  <a:srgbClr val="C0C0C0"/>
                </a:solidFill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3'!$AX$194:$BB$194</c:f>
                <c:numCache>
                  <c:formatCode>General</c:formatCode>
                  <c:ptCount val="5"/>
                  <c:pt idx="0">
                    <c:v>0.26372488669809929</c:v>
                  </c:pt>
                  <c:pt idx="1">
                    <c:v>0.43859397956802587</c:v>
                  </c:pt>
                  <c:pt idx="2">
                    <c:v>0.35592060950442972</c:v>
                  </c:pt>
                  <c:pt idx="3">
                    <c:v>0.20241508919362314</c:v>
                  </c:pt>
                  <c:pt idx="4">
                    <c:v>0.4496199909963649</c:v>
                  </c:pt>
                </c:numCache>
              </c:numRef>
            </c:plus>
            <c:minus>
              <c:numRef>
                <c:f>'Fig S3'!$AX$194:$BB$194</c:f>
                <c:numCache>
                  <c:formatCode>General</c:formatCode>
                  <c:ptCount val="5"/>
                  <c:pt idx="0">
                    <c:v>0.26372488669809929</c:v>
                  </c:pt>
                  <c:pt idx="1">
                    <c:v>0.43859397956802587</c:v>
                  </c:pt>
                  <c:pt idx="2">
                    <c:v>0.35592060950442972</c:v>
                  </c:pt>
                  <c:pt idx="3">
                    <c:v>0.20241508919362314</c:v>
                  </c:pt>
                  <c:pt idx="4">
                    <c:v>0.4496199909963649</c:v>
                  </c:pt>
                </c:numCache>
              </c:numRef>
            </c:minus>
            <c:spPr>
              <a:ln>
                <a:solidFill>
                  <a:prstClr val="white">
                    <a:lumMod val="65000"/>
                  </a:prstClr>
                </a:solidFill>
              </a:ln>
            </c:spPr>
          </c:errBars>
          <c:xVal>
            <c:numRef>
              <c:f>'Fig S3'!$AP$191:$AT$191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3'!$AP$194:$AT$194</c:f>
              <c:numCache>
                <c:formatCode>0.000</c:formatCode>
                <c:ptCount val="5"/>
                <c:pt idx="0">
                  <c:v>3.0046600060493853</c:v>
                </c:pt>
                <c:pt idx="1">
                  <c:v>1.6889557840811773</c:v>
                </c:pt>
                <c:pt idx="2">
                  <c:v>2.6736282632439865</c:v>
                </c:pt>
                <c:pt idx="3">
                  <c:v>2.1135367477077462</c:v>
                </c:pt>
                <c:pt idx="4">
                  <c:v>2.033932655448400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K$195</c:f>
              <c:strCache>
                <c:ptCount val="1"/>
                <c:pt idx="0">
                  <c:v>low R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3'!$AX$195:$BB$195</c:f>
                <c:numCache>
                  <c:formatCode>General</c:formatCode>
                  <c:ptCount val="5"/>
                  <c:pt idx="0">
                    <c:v>0.65053825821876776</c:v>
                  </c:pt>
                  <c:pt idx="1">
                    <c:v>0.70174015934449474</c:v>
                  </c:pt>
                  <c:pt idx="2">
                    <c:v>0.77193106514830667</c:v>
                  </c:pt>
                  <c:pt idx="3">
                    <c:v>0.39753437180668916</c:v>
                  </c:pt>
                  <c:pt idx="4">
                    <c:v>0.4500085068309711</c:v>
                  </c:pt>
                </c:numCache>
              </c:numRef>
            </c:plus>
            <c:minus>
              <c:numRef>
                <c:f>'Fig S3'!$AX$195:$BB$195</c:f>
                <c:numCache>
                  <c:formatCode>General</c:formatCode>
                  <c:ptCount val="5"/>
                  <c:pt idx="0">
                    <c:v>0.65053825821876776</c:v>
                  </c:pt>
                  <c:pt idx="1">
                    <c:v>0.70174015934449474</c:v>
                  </c:pt>
                  <c:pt idx="2">
                    <c:v>0.77193106514830667</c:v>
                  </c:pt>
                  <c:pt idx="3">
                    <c:v>0.39753437180668916</c:v>
                  </c:pt>
                  <c:pt idx="4">
                    <c:v>0.4500085068309711</c:v>
                  </c:pt>
                </c:numCache>
              </c:numRef>
            </c:minus>
          </c:errBars>
          <c:xVal>
            <c:numRef>
              <c:f>'Fig S3'!$AP$191:$AT$191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3'!$AP$195:$AT$195</c:f>
              <c:numCache>
                <c:formatCode>0.000</c:formatCode>
                <c:ptCount val="5"/>
                <c:pt idx="0">
                  <c:v>2.745438393145057</c:v>
                </c:pt>
                <c:pt idx="1">
                  <c:v>2.0589543001881951</c:v>
                </c:pt>
                <c:pt idx="2">
                  <c:v>2.1736024900328581</c:v>
                </c:pt>
                <c:pt idx="3">
                  <c:v>3.0976889676128017</c:v>
                </c:pt>
                <c:pt idx="4">
                  <c:v>2.440482203525422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S3'!$AJ$186</c:f>
              <c:strCache>
                <c:ptCount val="1"/>
                <c:pt idx="0">
                  <c:v>high before stres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U$194:$AW$194</c:f>
                <c:numCache>
                  <c:formatCode>General</c:formatCode>
                  <c:ptCount val="3"/>
                  <c:pt idx="0">
                    <c:v>0.44099541975307233</c:v>
                  </c:pt>
                  <c:pt idx="1">
                    <c:v>0.34621287568155884</c:v>
                  </c:pt>
                  <c:pt idx="2">
                    <c:v>0.24225411204620667</c:v>
                  </c:pt>
                </c:numCache>
              </c:numRef>
            </c:plus>
            <c:minus>
              <c:numRef>
                <c:f>'Fig S3'!$AU$194:$AW$194</c:f>
                <c:numCache>
                  <c:formatCode>General</c:formatCode>
                  <c:ptCount val="3"/>
                  <c:pt idx="0">
                    <c:v>0.44099541975307233</c:v>
                  </c:pt>
                  <c:pt idx="1">
                    <c:v>0.34621287568155884</c:v>
                  </c:pt>
                  <c:pt idx="2">
                    <c:v>0.24225411204620667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M$191:$AO$191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3'!$AM$194:$AO$194</c:f>
              <c:numCache>
                <c:formatCode>0.000</c:formatCode>
                <c:ptCount val="3"/>
                <c:pt idx="0">
                  <c:v>2.4971339530390231</c:v>
                </c:pt>
                <c:pt idx="1">
                  <c:v>2.1645503230719396</c:v>
                </c:pt>
                <c:pt idx="2">
                  <c:v>2.1994918885460208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S3'!$AJ$187</c:f>
              <c:strCache>
                <c:ptCount val="1"/>
                <c:pt idx="0">
                  <c:v>low below  stres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U$195:$AW$195</c:f>
                <c:numCache>
                  <c:formatCode>General</c:formatCode>
                  <c:ptCount val="3"/>
                  <c:pt idx="0">
                    <c:v>0.84538309752474672</c:v>
                  </c:pt>
                  <c:pt idx="1">
                    <c:v>0.58789358138364589</c:v>
                  </c:pt>
                  <c:pt idx="2">
                    <c:v>0.73553375770036444</c:v>
                  </c:pt>
                </c:numCache>
              </c:numRef>
            </c:plus>
            <c:minus>
              <c:numRef>
                <c:f>'Fig S3'!$AU$195:$AW$195</c:f>
                <c:numCache>
                  <c:formatCode>General</c:formatCode>
                  <c:ptCount val="3"/>
                  <c:pt idx="0">
                    <c:v>0.84538309752474672</c:v>
                  </c:pt>
                  <c:pt idx="1">
                    <c:v>0.58789358138364589</c:v>
                  </c:pt>
                  <c:pt idx="2">
                    <c:v>0.73553375770036444</c:v>
                  </c:pt>
                </c:numCache>
              </c:numRef>
            </c:minus>
          </c:errBars>
          <c:xVal>
            <c:numRef>
              <c:f>'Fig S3'!$AM$191:$AO$191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3'!$AM$195:$AO$195</c:f>
              <c:numCache>
                <c:formatCode>0.000</c:formatCode>
                <c:ptCount val="3"/>
                <c:pt idx="0">
                  <c:v>2.5073800736641774</c:v>
                </c:pt>
                <c:pt idx="1">
                  <c:v>2.1241121700484498</c:v>
                </c:pt>
                <c:pt idx="2">
                  <c:v>4.107850639715398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3584752"/>
        <c:axId val="373574112"/>
      </c:scatterChart>
      <c:valAx>
        <c:axId val="37358475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73574112"/>
        <c:crosses val="autoZero"/>
        <c:crossBetween val="midCat"/>
        <c:majorUnit val="2"/>
        <c:minorUnit val="1"/>
      </c:valAx>
      <c:valAx>
        <c:axId val="373574112"/>
        <c:scaling>
          <c:orientation val="minMax"/>
          <c:max val="6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73584752"/>
        <c:crossesAt val="-11"/>
        <c:crossBetween val="midCat"/>
        <c:majorUnit val="1"/>
        <c:min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6801368680654736E-2"/>
          <c:y val="0.13401559454191034"/>
          <c:w val="0.86036114785335505"/>
          <c:h val="0.73196881091617938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3'!$AQ$33</c:f>
              <c:strCache>
                <c:ptCount val="1"/>
                <c:pt idx="0">
                  <c:v>high Rs</c:v>
                </c:pt>
              </c:strCache>
            </c:strRef>
          </c:tx>
          <c:spPr>
            <a:ln w="12700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BC$33:$BL$33</c:f>
                <c:numCache>
                  <c:formatCode>General</c:formatCode>
                  <c:ptCount val="10"/>
                  <c:pt idx="0">
                    <c:v>1.8338692420671661E-2</c:v>
                  </c:pt>
                  <c:pt idx="1">
                    <c:v>1.6202356061388121E-2</c:v>
                  </c:pt>
                  <c:pt idx="2">
                    <c:v>1.563986676605655E-2</c:v>
                  </c:pt>
                  <c:pt idx="3">
                    <c:v>1.6033649130500517E-2</c:v>
                  </c:pt>
                  <c:pt idx="4">
                    <c:v>1.5595235428168448E-2</c:v>
                  </c:pt>
                  <c:pt idx="5">
                    <c:v>1.5057737354596137E-2</c:v>
                  </c:pt>
                  <c:pt idx="6">
                    <c:v>3.6356373817530256E-2</c:v>
                  </c:pt>
                  <c:pt idx="7">
                    <c:v>1.9906176675594946E-2</c:v>
                  </c:pt>
                  <c:pt idx="8">
                    <c:v>1.694510749862627E-2</c:v>
                  </c:pt>
                  <c:pt idx="9">
                    <c:v>1.8905977198759145E-2</c:v>
                  </c:pt>
                </c:numCache>
              </c:numRef>
            </c:plus>
            <c:minus>
              <c:numRef>
                <c:f>'Fig S3'!$BC$33:$BL$33</c:f>
                <c:numCache>
                  <c:formatCode>General</c:formatCode>
                  <c:ptCount val="10"/>
                  <c:pt idx="0">
                    <c:v>1.8338692420671661E-2</c:v>
                  </c:pt>
                  <c:pt idx="1">
                    <c:v>1.6202356061388121E-2</c:v>
                  </c:pt>
                  <c:pt idx="2">
                    <c:v>1.563986676605655E-2</c:v>
                  </c:pt>
                  <c:pt idx="3">
                    <c:v>1.6033649130500517E-2</c:v>
                  </c:pt>
                  <c:pt idx="4">
                    <c:v>1.5595235428168448E-2</c:v>
                  </c:pt>
                  <c:pt idx="5">
                    <c:v>1.5057737354596137E-2</c:v>
                  </c:pt>
                  <c:pt idx="6">
                    <c:v>3.6356373817530256E-2</c:v>
                  </c:pt>
                  <c:pt idx="7">
                    <c:v>1.9906176675594946E-2</c:v>
                  </c:pt>
                  <c:pt idx="8">
                    <c:v>1.694510749862627E-2</c:v>
                  </c:pt>
                  <c:pt idx="9">
                    <c:v>1.8905977198759145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S$30:$BB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3'!$AS$33:$BB$33</c:f>
              <c:numCache>
                <c:formatCode>0.00E+00</c:formatCode>
                <c:ptCount val="10"/>
                <c:pt idx="0">
                  <c:v>9.1018000000000002E-2</c:v>
                </c:pt>
                <c:pt idx="1">
                  <c:v>9.3906799999999999E-2</c:v>
                </c:pt>
                <c:pt idx="2">
                  <c:v>7.8174400000000005E-2</c:v>
                </c:pt>
                <c:pt idx="3">
                  <c:v>8.8268199999999991E-2</c:v>
                </c:pt>
                <c:pt idx="4">
                  <c:v>7.8261399999999995E-2</c:v>
                </c:pt>
                <c:pt idx="5">
                  <c:v>8.6010799999999998E-2</c:v>
                </c:pt>
                <c:pt idx="6">
                  <c:v>0.1026726</c:v>
                </c:pt>
                <c:pt idx="7">
                  <c:v>8.8982199999999997E-2</c:v>
                </c:pt>
                <c:pt idx="8">
                  <c:v>0.1029788</c:v>
                </c:pt>
                <c:pt idx="9">
                  <c:v>0.1181321999999999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Q$34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BC$34:$BL$34</c:f>
                <c:numCache>
                  <c:formatCode>General</c:formatCode>
                  <c:ptCount val="10"/>
                  <c:pt idx="0">
                    <c:v>3.2544958648614085E-2</c:v>
                  </c:pt>
                  <c:pt idx="1">
                    <c:v>2.5693189039899266E-2</c:v>
                  </c:pt>
                  <c:pt idx="2">
                    <c:v>2.4310670781366766E-2</c:v>
                  </c:pt>
                  <c:pt idx="3">
                    <c:v>3.0009512889082365E-2</c:v>
                  </c:pt>
                  <c:pt idx="4">
                    <c:v>3.3057977054562801E-2</c:v>
                  </c:pt>
                  <c:pt idx="5">
                    <c:v>2.5068681006387237E-2</c:v>
                  </c:pt>
                  <c:pt idx="6">
                    <c:v>3.100911571070674E-2</c:v>
                  </c:pt>
                  <c:pt idx="7">
                    <c:v>3.9217472348941608E-2</c:v>
                  </c:pt>
                  <c:pt idx="8">
                    <c:v>3.3414771823850602E-2</c:v>
                  </c:pt>
                  <c:pt idx="9">
                    <c:v>3.7929260095076987E-2</c:v>
                  </c:pt>
                </c:numCache>
              </c:numRef>
            </c:plus>
            <c:minus>
              <c:numRef>
                <c:f>'Fig S3'!$BC$34:$BL$34</c:f>
                <c:numCache>
                  <c:formatCode>General</c:formatCode>
                  <c:ptCount val="10"/>
                  <c:pt idx="0">
                    <c:v>3.2544958648614085E-2</c:v>
                  </c:pt>
                  <c:pt idx="1">
                    <c:v>2.5693189039899266E-2</c:v>
                  </c:pt>
                  <c:pt idx="2">
                    <c:v>2.4310670781366766E-2</c:v>
                  </c:pt>
                  <c:pt idx="3">
                    <c:v>3.0009512889082365E-2</c:v>
                  </c:pt>
                  <c:pt idx="4">
                    <c:v>3.3057977054562801E-2</c:v>
                  </c:pt>
                  <c:pt idx="5">
                    <c:v>2.5068681006387237E-2</c:v>
                  </c:pt>
                  <c:pt idx="6">
                    <c:v>3.100911571070674E-2</c:v>
                  </c:pt>
                  <c:pt idx="7">
                    <c:v>3.9217472348941608E-2</c:v>
                  </c:pt>
                  <c:pt idx="8">
                    <c:v>3.3414771823850602E-2</c:v>
                  </c:pt>
                  <c:pt idx="9">
                    <c:v>3.7929260095076987E-2</c:v>
                  </c:pt>
                </c:numCache>
              </c:numRef>
            </c:minus>
          </c:errBars>
          <c:xVal>
            <c:numRef>
              <c:f>'Fig S3'!$AS$30:$BB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3'!$AS$34:$BB$34</c:f>
              <c:numCache>
                <c:formatCode>0.00E+00</c:formatCode>
                <c:ptCount val="10"/>
                <c:pt idx="0">
                  <c:v>0.14576119999999998</c:v>
                </c:pt>
                <c:pt idx="1">
                  <c:v>9.8978200000000002E-2</c:v>
                </c:pt>
                <c:pt idx="2">
                  <c:v>9.4340800000000002E-2</c:v>
                </c:pt>
                <c:pt idx="3">
                  <c:v>0.10331679999999999</c:v>
                </c:pt>
                <c:pt idx="4">
                  <c:v>0.10748519999999999</c:v>
                </c:pt>
                <c:pt idx="5">
                  <c:v>0.100671</c:v>
                </c:pt>
                <c:pt idx="6">
                  <c:v>0.1005906</c:v>
                </c:pt>
                <c:pt idx="7">
                  <c:v>0.1207778</c:v>
                </c:pt>
                <c:pt idx="8">
                  <c:v>0.11496619999999999</c:v>
                </c:pt>
                <c:pt idx="9">
                  <c:v>0.126204399999999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037008"/>
        <c:axId val="205038688"/>
      </c:scatterChart>
      <c:scatterChart>
        <c:scatterStyle val="smoothMarker"/>
        <c:varyColors val="0"/>
        <c:ser>
          <c:idx val="2"/>
          <c:order val="2"/>
          <c:tx>
            <c:strRef>
              <c:f>'Fig S3'!$J$21</c:f>
              <c:strCache>
                <c:ptCount val="1"/>
                <c:pt idx="0">
                  <c:v>High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  <a:prstDash val="dashDot"/>
            </a:ln>
          </c:spPr>
          <c:marker>
            <c:symbol val="none"/>
          </c:marker>
          <c:xVal>
            <c:numRef>
              <c:f>'Fig S3'!$X$11:$AG$11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3'!$X$12:$AG$12</c:f>
              <c:numCache>
                <c:formatCode>General</c:formatCode>
                <c:ptCount val="10"/>
                <c:pt idx="0">
                  <c:v>0.52751199999999998</c:v>
                </c:pt>
                <c:pt idx="1">
                  <c:v>0.52751199999999998</c:v>
                </c:pt>
                <c:pt idx="2">
                  <c:v>0.52751199999999998</c:v>
                </c:pt>
                <c:pt idx="3">
                  <c:v>0.52751199999999998</c:v>
                </c:pt>
                <c:pt idx="4">
                  <c:v>0.52751199999999998</c:v>
                </c:pt>
                <c:pt idx="5">
                  <c:v>0.52751199999999998</c:v>
                </c:pt>
                <c:pt idx="6">
                  <c:v>0.52751199999999998</c:v>
                </c:pt>
                <c:pt idx="7">
                  <c:v>0.52751199999999998</c:v>
                </c:pt>
                <c:pt idx="8">
                  <c:v>0.52751199999999998</c:v>
                </c:pt>
                <c:pt idx="9">
                  <c:v>0.52751199999999998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'Fig S3'!$J$22</c:f>
              <c:strCache>
                <c:ptCount val="1"/>
                <c:pt idx="0">
                  <c:v>Low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  <a:prstDash val="dash"/>
            </a:ln>
          </c:spPr>
          <c:marker>
            <c:symbol val="none"/>
          </c:marker>
          <c:xVal>
            <c:numRef>
              <c:f>'Fig S3'!$X$11:$AG$11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3'!$X$13:$AG$13</c:f>
              <c:numCache>
                <c:formatCode>General</c:formatCode>
                <c:ptCount val="10"/>
                <c:pt idx="0">
                  <c:v>0.33785800000000005</c:v>
                </c:pt>
                <c:pt idx="1">
                  <c:v>0.33785800000000005</c:v>
                </c:pt>
                <c:pt idx="2">
                  <c:v>0.33785800000000005</c:v>
                </c:pt>
                <c:pt idx="3">
                  <c:v>0.33785800000000005</c:v>
                </c:pt>
                <c:pt idx="4">
                  <c:v>0.33785800000000005</c:v>
                </c:pt>
                <c:pt idx="5">
                  <c:v>0.33785800000000005</c:v>
                </c:pt>
                <c:pt idx="6">
                  <c:v>0.33785800000000005</c:v>
                </c:pt>
                <c:pt idx="7">
                  <c:v>0.33785800000000005</c:v>
                </c:pt>
                <c:pt idx="8">
                  <c:v>0.33785800000000005</c:v>
                </c:pt>
                <c:pt idx="9">
                  <c:v>0.3378580000000000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037008"/>
        <c:axId val="205038688"/>
      </c:scatterChart>
      <c:valAx>
        <c:axId val="20503700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05038688"/>
        <c:crosses val="autoZero"/>
        <c:crossBetween val="midCat"/>
        <c:majorUnit val="2"/>
        <c:minorUnit val="1"/>
      </c:valAx>
      <c:valAx>
        <c:axId val="205038688"/>
        <c:scaling>
          <c:orientation val="minMax"/>
          <c:max val="0.6000000000000002"/>
          <c:min val="0"/>
        </c:scaling>
        <c:delete val="0"/>
        <c:axPos val="l"/>
        <c:numFmt formatCode="0.0E+00" sourceLinked="0"/>
        <c:majorTickMark val="out"/>
        <c:minorTickMark val="none"/>
        <c:tickLblPos val="none"/>
        <c:crossAx val="205037008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K$192</c:f>
              <c:strCache>
                <c:ptCount val="1"/>
                <c:pt idx="0">
                  <c:v>high R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rgbClr val="C0C0C0"/>
                </a:solidFill>
              </a:ln>
            </c:spPr>
          </c:marker>
          <c:trendline>
            <c:spPr>
              <a:ln>
                <a:solidFill>
                  <a:srgbClr val="C0C0C0"/>
                </a:solidFill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3'!$AX$192:$BB$192</c:f>
                <c:numCache>
                  <c:formatCode>General</c:formatCode>
                  <c:ptCount val="5"/>
                  <c:pt idx="0">
                    <c:v>0.37249919325531883</c:v>
                  </c:pt>
                  <c:pt idx="1">
                    <c:v>0.37719327217918358</c:v>
                  </c:pt>
                  <c:pt idx="2">
                    <c:v>0.3825640436211068</c:v>
                  </c:pt>
                  <c:pt idx="3">
                    <c:v>0.38030025308353915</c:v>
                  </c:pt>
                  <c:pt idx="4">
                    <c:v>0.36753282557072314</c:v>
                  </c:pt>
                </c:numCache>
              </c:numRef>
            </c:plus>
            <c:minus>
              <c:numRef>
                <c:f>'Fig S3'!$AX$192:$BB$192</c:f>
                <c:numCache>
                  <c:formatCode>General</c:formatCode>
                  <c:ptCount val="5"/>
                  <c:pt idx="0">
                    <c:v>0.37249919325531883</c:v>
                  </c:pt>
                  <c:pt idx="1">
                    <c:v>0.37719327217918358</c:v>
                  </c:pt>
                  <c:pt idx="2">
                    <c:v>0.3825640436211068</c:v>
                  </c:pt>
                  <c:pt idx="3">
                    <c:v>0.38030025308353915</c:v>
                  </c:pt>
                  <c:pt idx="4">
                    <c:v>0.36753282557072314</c:v>
                  </c:pt>
                </c:numCache>
              </c:numRef>
            </c:minus>
            <c:spPr>
              <a:ln>
                <a:solidFill>
                  <a:prstClr val="white">
                    <a:lumMod val="65000"/>
                  </a:prstClr>
                </a:solidFill>
              </a:ln>
            </c:spPr>
          </c:errBars>
          <c:xVal>
            <c:numRef>
              <c:f>'Fig S3'!$AP$191:$AT$191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3'!$AP$192:$AT$192</c:f>
              <c:numCache>
                <c:formatCode>0.000</c:formatCode>
                <c:ptCount val="5"/>
                <c:pt idx="0">
                  <c:v>3.123290587865756</c:v>
                </c:pt>
                <c:pt idx="1">
                  <c:v>2.7970828445554048</c:v>
                </c:pt>
                <c:pt idx="2">
                  <c:v>2.6108802993622486</c:v>
                </c:pt>
                <c:pt idx="3">
                  <c:v>2.8693871092817251</c:v>
                </c:pt>
                <c:pt idx="4">
                  <c:v>2.978282363153278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K$193</c:f>
              <c:strCache>
                <c:ptCount val="1"/>
                <c:pt idx="0">
                  <c:v>low R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noFill/>
              </a:ln>
            </c:spPr>
          </c:marker>
          <c:trendline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Fig S3'!$AX$193:$BB$193</c:f>
                <c:numCache>
                  <c:formatCode>General</c:formatCode>
                  <c:ptCount val="5"/>
                  <c:pt idx="0">
                    <c:v>0.90250922081495055</c:v>
                  </c:pt>
                  <c:pt idx="1">
                    <c:v>0.63984482824151734</c:v>
                  </c:pt>
                  <c:pt idx="2">
                    <c:v>0.49457622082478631</c:v>
                  </c:pt>
                  <c:pt idx="3">
                    <c:v>0.765722181557695</c:v>
                  </c:pt>
                  <c:pt idx="4">
                    <c:v>0.23929655117904911</c:v>
                  </c:pt>
                </c:numCache>
              </c:numRef>
            </c:plus>
            <c:minus>
              <c:numRef>
                <c:f>'Fig S3'!$AX$193:$BB$193</c:f>
                <c:numCache>
                  <c:formatCode>General</c:formatCode>
                  <c:ptCount val="5"/>
                  <c:pt idx="0">
                    <c:v>0.90250922081495055</c:v>
                  </c:pt>
                  <c:pt idx="1">
                    <c:v>0.63984482824151734</c:v>
                  </c:pt>
                  <c:pt idx="2">
                    <c:v>0.49457622082478631</c:v>
                  </c:pt>
                  <c:pt idx="3">
                    <c:v>0.765722181557695</c:v>
                  </c:pt>
                  <c:pt idx="4">
                    <c:v>0.23929655117904911</c:v>
                  </c:pt>
                </c:numCache>
              </c:numRef>
            </c:minus>
          </c:errBars>
          <c:xVal>
            <c:numRef>
              <c:f>'Fig S3'!$AP$191:$AT$191</c:f>
              <c:numCache>
                <c:formatCode>General</c:formatCode>
                <c:ptCount val="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1</c:v>
                </c:pt>
              </c:numCache>
            </c:numRef>
          </c:xVal>
          <c:yVal>
            <c:numRef>
              <c:f>'Fig S3'!$AP$193:$AT$193</c:f>
              <c:numCache>
                <c:formatCode>0.000</c:formatCode>
                <c:ptCount val="5"/>
                <c:pt idx="0">
                  <c:v>2.7215720566517305</c:v>
                </c:pt>
                <c:pt idx="1">
                  <c:v>2.9618367787353295</c:v>
                </c:pt>
                <c:pt idx="2">
                  <c:v>2.9797996009416181</c:v>
                </c:pt>
                <c:pt idx="3">
                  <c:v>3.6293530488679631</c:v>
                </c:pt>
                <c:pt idx="4">
                  <c:v>2.8330673841800129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 S3'!$AJ$186</c:f>
              <c:strCache>
                <c:ptCount val="1"/>
                <c:pt idx="0">
                  <c:v>high before stress</c:v>
                </c:pt>
              </c:strCache>
            </c:strRef>
          </c:tx>
          <c:spPr>
            <a:ln w="28575">
              <a:noFill/>
            </a:ln>
          </c:spPr>
          <c:marker>
            <c:symbol val="x"/>
            <c:size val="5"/>
            <c:spPr>
              <a:noFill/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U$192:$AW$192</c:f>
                <c:numCache>
                  <c:formatCode>General</c:formatCode>
                  <c:ptCount val="3"/>
                  <c:pt idx="0">
                    <c:v>0.16776581764566381</c:v>
                  </c:pt>
                  <c:pt idx="1">
                    <c:v>0.53568301222935411</c:v>
                  </c:pt>
                  <c:pt idx="2">
                    <c:v>0.44455981312280329</c:v>
                  </c:pt>
                </c:numCache>
              </c:numRef>
            </c:plus>
            <c:minus>
              <c:numRef>
                <c:f>'Fig S3'!$AU$192:$AW$192</c:f>
                <c:numCache>
                  <c:formatCode>General</c:formatCode>
                  <c:ptCount val="3"/>
                  <c:pt idx="0">
                    <c:v>0.16776581764566381</c:v>
                  </c:pt>
                  <c:pt idx="1">
                    <c:v>0.53568301222935411</c:v>
                  </c:pt>
                  <c:pt idx="2">
                    <c:v>0.44455981312280329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M$191:$AO$191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3'!$AM$192:$AO$192</c:f>
              <c:numCache>
                <c:formatCode>0.000</c:formatCode>
                <c:ptCount val="3"/>
                <c:pt idx="0">
                  <c:v>2.5453757401398023</c:v>
                </c:pt>
                <c:pt idx="1">
                  <c:v>2.9356882085987541</c:v>
                </c:pt>
                <c:pt idx="2">
                  <c:v>2.3986858787626084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 S3'!$AJ$187</c:f>
              <c:strCache>
                <c:ptCount val="1"/>
                <c:pt idx="0">
                  <c:v>low below  stress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U$193:$AW$193</c:f>
                <c:numCache>
                  <c:formatCode>General</c:formatCode>
                  <c:ptCount val="3"/>
                  <c:pt idx="0">
                    <c:v>0.15202795706971417</c:v>
                  </c:pt>
                  <c:pt idx="1">
                    <c:v>0.64444302366779016</c:v>
                  </c:pt>
                  <c:pt idx="2">
                    <c:v>0.92938434712441076</c:v>
                  </c:pt>
                </c:numCache>
              </c:numRef>
            </c:plus>
            <c:minus>
              <c:numRef>
                <c:f>'Fig S3'!$AU$193:$AW$193</c:f>
                <c:numCache>
                  <c:formatCode>General</c:formatCode>
                  <c:ptCount val="3"/>
                  <c:pt idx="0">
                    <c:v>0.15202795706971417</c:v>
                  </c:pt>
                  <c:pt idx="1">
                    <c:v>0.64444302366779016</c:v>
                  </c:pt>
                  <c:pt idx="2">
                    <c:v>0.92938434712441076</c:v>
                  </c:pt>
                </c:numCache>
              </c:numRef>
            </c:minus>
          </c:errBars>
          <c:xVal>
            <c:numRef>
              <c:f>'Fig S3'!$AM$191:$AO$191</c:f>
              <c:numCache>
                <c:formatCode>General</c:formatCode>
                <c:ptCount val="3"/>
                <c:pt idx="0">
                  <c:v>-5</c:v>
                </c:pt>
                <c:pt idx="1">
                  <c:v>-3</c:v>
                </c:pt>
                <c:pt idx="2">
                  <c:v>0</c:v>
                </c:pt>
              </c:numCache>
            </c:numRef>
          </c:xVal>
          <c:yVal>
            <c:numRef>
              <c:f>'Fig S3'!$AM$193:$AO$193</c:f>
              <c:numCache>
                <c:formatCode>0.000</c:formatCode>
                <c:ptCount val="3"/>
                <c:pt idx="0">
                  <c:v>2.6231457379405674</c:v>
                </c:pt>
                <c:pt idx="1">
                  <c:v>3.3195750215297686</c:v>
                </c:pt>
                <c:pt idx="2">
                  <c:v>4.133660784095588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5062704"/>
        <c:axId val="345058784"/>
      </c:scatterChart>
      <c:valAx>
        <c:axId val="34506270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45058784"/>
        <c:crosses val="autoZero"/>
        <c:crossBetween val="midCat"/>
        <c:majorUnit val="2"/>
        <c:minorUnit val="1"/>
      </c:valAx>
      <c:valAx>
        <c:axId val="345058784"/>
        <c:scaling>
          <c:orientation val="minMax"/>
          <c:max val="6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45062704"/>
        <c:crossesAt val="-11"/>
        <c:crossBetween val="midCat"/>
        <c:majorUnit val="1"/>
        <c:min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N$299</c:f>
              <c:strCache>
                <c:ptCount val="1"/>
                <c:pt idx="0">
                  <c:v>high R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299:$BG$299</c:f>
                <c:numCache>
                  <c:formatCode>General</c:formatCode>
                  <c:ptCount val="9"/>
                  <c:pt idx="0">
                    <c:v>3.6118442404359061E-2</c:v>
                  </c:pt>
                  <c:pt idx="1">
                    <c:v>3.7213763843865856E-2</c:v>
                  </c:pt>
                  <c:pt idx="2">
                    <c:v>3.6777217256080921E-2</c:v>
                  </c:pt>
                  <c:pt idx="3">
                    <c:v>3.5316503771336584E-2</c:v>
                  </c:pt>
                  <c:pt idx="4">
                    <c:v>6.2598564747349969E-2</c:v>
                  </c:pt>
                  <c:pt idx="5">
                    <c:v>4.685417559077136E-2</c:v>
                  </c:pt>
                  <c:pt idx="6">
                    <c:v>4.4190328722734491E-2</c:v>
                  </c:pt>
                  <c:pt idx="7">
                    <c:v>5.8332658793014844E-2</c:v>
                  </c:pt>
                  <c:pt idx="8">
                    <c:v>4.9886475711981092E-2</c:v>
                  </c:pt>
                </c:numCache>
              </c:numRef>
            </c:plus>
            <c:minus>
              <c:numRef>
                <c:f>'Fig S3'!$AY$299:$BG$299</c:f>
                <c:numCache>
                  <c:formatCode>General</c:formatCode>
                  <c:ptCount val="9"/>
                  <c:pt idx="0">
                    <c:v>3.6118442404359061E-2</c:v>
                  </c:pt>
                  <c:pt idx="1">
                    <c:v>3.7213763843865856E-2</c:v>
                  </c:pt>
                  <c:pt idx="2">
                    <c:v>3.6777217256080921E-2</c:v>
                  </c:pt>
                  <c:pt idx="3">
                    <c:v>3.5316503771336584E-2</c:v>
                  </c:pt>
                  <c:pt idx="4">
                    <c:v>6.2598564747349969E-2</c:v>
                  </c:pt>
                  <c:pt idx="5">
                    <c:v>4.685417559077136E-2</c:v>
                  </c:pt>
                  <c:pt idx="6">
                    <c:v>4.4190328722734491E-2</c:v>
                  </c:pt>
                  <c:pt idx="7">
                    <c:v>5.8332658793014844E-2</c:v>
                  </c:pt>
                  <c:pt idx="8">
                    <c:v>4.9886475711981092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P$292:$AX$2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299:$AX$299</c:f>
              <c:numCache>
                <c:formatCode>0.000</c:formatCode>
                <c:ptCount val="9"/>
                <c:pt idx="0">
                  <c:v>0.30089217721744366</c:v>
                </c:pt>
                <c:pt idx="1">
                  <c:v>0.31693492201675466</c:v>
                </c:pt>
                <c:pt idx="2">
                  <c:v>0.26740950745931585</c:v>
                </c:pt>
                <c:pt idx="3">
                  <c:v>0.3045238263605331</c:v>
                </c:pt>
                <c:pt idx="4">
                  <c:v>0.19858194382947364</c:v>
                </c:pt>
                <c:pt idx="5">
                  <c:v>7.5539759336414325E-2</c:v>
                </c:pt>
                <c:pt idx="6">
                  <c:v>7.1278748850045995E-2</c:v>
                </c:pt>
                <c:pt idx="7">
                  <c:v>9.3670684513756861E-2</c:v>
                </c:pt>
                <c:pt idx="8">
                  <c:v>7.9886147035313895E-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N$300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300:$BG$300</c:f>
                <c:numCache>
                  <c:formatCode>General</c:formatCode>
                  <c:ptCount val="9"/>
                  <c:pt idx="0">
                    <c:v>3.7641211504365217E-2</c:v>
                  </c:pt>
                  <c:pt idx="1">
                    <c:v>3.2208130169181726E-2</c:v>
                  </c:pt>
                  <c:pt idx="2">
                    <c:v>3.4539106729106019E-2</c:v>
                  </c:pt>
                  <c:pt idx="3">
                    <c:v>5.496612323392553E-2</c:v>
                  </c:pt>
                  <c:pt idx="4">
                    <c:v>2.0055353637441996E-2</c:v>
                  </c:pt>
                  <c:pt idx="5">
                    <c:v>5.9249692439597254E-2</c:v>
                  </c:pt>
                  <c:pt idx="6">
                    <c:v>4.8254125713095494E-2</c:v>
                  </c:pt>
                  <c:pt idx="7">
                    <c:v>5.0777332455202863E-2</c:v>
                  </c:pt>
                  <c:pt idx="8">
                    <c:v>4.8918830179935521E-2</c:v>
                  </c:pt>
                </c:numCache>
              </c:numRef>
            </c:plus>
            <c:minus>
              <c:numRef>
                <c:f>'Fig S3'!$AY$300:$BG$300</c:f>
                <c:numCache>
                  <c:formatCode>General</c:formatCode>
                  <c:ptCount val="9"/>
                  <c:pt idx="0">
                    <c:v>3.7641211504365217E-2</c:v>
                  </c:pt>
                  <c:pt idx="1">
                    <c:v>3.2208130169181726E-2</c:v>
                  </c:pt>
                  <c:pt idx="2">
                    <c:v>3.4539106729106019E-2</c:v>
                  </c:pt>
                  <c:pt idx="3">
                    <c:v>5.496612323392553E-2</c:v>
                  </c:pt>
                  <c:pt idx="4">
                    <c:v>2.0055353637441996E-2</c:v>
                  </c:pt>
                  <c:pt idx="5">
                    <c:v>5.9249692439597254E-2</c:v>
                  </c:pt>
                  <c:pt idx="6">
                    <c:v>4.8254125713095494E-2</c:v>
                  </c:pt>
                  <c:pt idx="7">
                    <c:v>5.0777332455202863E-2</c:v>
                  </c:pt>
                  <c:pt idx="8">
                    <c:v>4.8918830179935521E-2</c:v>
                  </c:pt>
                </c:numCache>
              </c:numRef>
            </c:minus>
          </c:errBars>
          <c:xVal>
            <c:numRef>
              <c:f>'Fig S3'!$AP$292:$AX$2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300:$AX$300</c:f>
              <c:numCache>
                <c:formatCode>0.000</c:formatCode>
                <c:ptCount val="9"/>
                <c:pt idx="0">
                  <c:v>0.25119760745990755</c:v>
                </c:pt>
                <c:pt idx="1">
                  <c:v>0.26236388216930062</c:v>
                </c:pt>
                <c:pt idx="2">
                  <c:v>0.23535169884747945</c:v>
                </c:pt>
                <c:pt idx="3">
                  <c:v>0.25049405561133031</c:v>
                </c:pt>
                <c:pt idx="4">
                  <c:v>0.2066735590551172</c:v>
                </c:pt>
                <c:pt idx="5">
                  <c:v>0.13678164394858933</c:v>
                </c:pt>
                <c:pt idx="6">
                  <c:v>7.6595384175651218E-2</c:v>
                </c:pt>
                <c:pt idx="7">
                  <c:v>8.2908902691511396E-2</c:v>
                </c:pt>
                <c:pt idx="8">
                  <c:v>7.8104512353983815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5059904"/>
        <c:axId val="345057104"/>
      </c:scatterChart>
      <c:valAx>
        <c:axId val="34505990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45057104"/>
        <c:crosses val="autoZero"/>
        <c:crossBetween val="midCat"/>
        <c:majorUnit val="2"/>
        <c:minorUnit val="1"/>
      </c:valAx>
      <c:valAx>
        <c:axId val="345057104"/>
        <c:scaling>
          <c:orientation val="minMax"/>
          <c:max val="0.5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45059904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N$297</c:f>
              <c:strCache>
                <c:ptCount val="1"/>
                <c:pt idx="0">
                  <c:v>high R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297:$BG$297</c:f>
                <c:numCache>
                  <c:formatCode>General</c:formatCode>
                  <c:ptCount val="9"/>
                  <c:pt idx="0">
                    <c:v>4.1357070175928941E-2</c:v>
                  </c:pt>
                  <c:pt idx="1">
                    <c:v>4.3737261721535442E-2</c:v>
                  </c:pt>
                  <c:pt idx="2">
                    <c:v>3.9637333463192419E-2</c:v>
                  </c:pt>
                  <c:pt idx="3">
                    <c:v>5.1129743905280529E-2</c:v>
                  </c:pt>
                  <c:pt idx="4">
                    <c:v>4.7723854652668908E-2</c:v>
                  </c:pt>
                  <c:pt idx="5">
                    <c:v>4.0357089642162877E-2</c:v>
                  </c:pt>
                  <c:pt idx="6">
                    <c:v>8.6105521909178362E-2</c:v>
                  </c:pt>
                  <c:pt idx="7">
                    <c:v>8.7029706291664233E-2</c:v>
                  </c:pt>
                  <c:pt idx="8">
                    <c:v>8.1731566294283103E-2</c:v>
                  </c:pt>
                </c:numCache>
              </c:numRef>
            </c:plus>
            <c:minus>
              <c:numRef>
                <c:f>'Fig S3'!$AY$297:$BG$297</c:f>
                <c:numCache>
                  <c:formatCode>General</c:formatCode>
                  <c:ptCount val="9"/>
                  <c:pt idx="0">
                    <c:v>4.1357070175928941E-2</c:v>
                  </c:pt>
                  <c:pt idx="1">
                    <c:v>4.3737261721535442E-2</c:v>
                  </c:pt>
                  <c:pt idx="2">
                    <c:v>3.9637333463192419E-2</c:v>
                  </c:pt>
                  <c:pt idx="3">
                    <c:v>5.1129743905280529E-2</c:v>
                  </c:pt>
                  <c:pt idx="4">
                    <c:v>4.7723854652668908E-2</c:v>
                  </c:pt>
                  <c:pt idx="5">
                    <c:v>4.0357089642162877E-2</c:v>
                  </c:pt>
                  <c:pt idx="6">
                    <c:v>8.6105521909178362E-2</c:v>
                  </c:pt>
                  <c:pt idx="7">
                    <c:v>8.7029706291664233E-2</c:v>
                  </c:pt>
                  <c:pt idx="8">
                    <c:v>8.1731566294283103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P$292:$AX$2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297:$AX$297</c:f>
              <c:numCache>
                <c:formatCode>0.000</c:formatCode>
                <c:ptCount val="9"/>
                <c:pt idx="0">
                  <c:v>0.31732545551679847</c:v>
                </c:pt>
                <c:pt idx="1">
                  <c:v>0.33118933648126553</c:v>
                </c:pt>
                <c:pt idx="2">
                  <c:v>0.30047701339813387</c:v>
                </c:pt>
                <c:pt idx="3">
                  <c:v>0.34313301793894191</c:v>
                </c:pt>
                <c:pt idx="4">
                  <c:v>0.32985941584530221</c:v>
                </c:pt>
                <c:pt idx="5">
                  <c:v>0.27001898739586488</c:v>
                </c:pt>
                <c:pt idx="6">
                  <c:v>0.24085503768235897</c:v>
                </c:pt>
                <c:pt idx="7">
                  <c:v>0.244297393528498</c:v>
                </c:pt>
                <c:pt idx="8">
                  <c:v>0.2512265967134866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N$298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298:$BG$298</c:f>
                <c:numCache>
                  <c:formatCode>General</c:formatCode>
                  <c:ptCount val="9"/>
                  <c:pt idx="0">
                    <c:v>4.5993940750354172E-2</c:v>
                  </c:pt>
                  <c:pt idx="1">
                    <c:v>3.5884013529125368E-2</c:v>
                  </c:pt>
                  <c:pt idx="2">
                    <c:v>3.2783135639747787E-2</c:v>
                  </c:pt>
                  <c:pt idx="3">
                    <c:v>6.8029799378178296E-2</c:v>
                  </c:pt>
                  <c:pt idx="4">
                    <c:v>3.2314505692722789E-2</c:v>
                  </c:pt>
                  <c:pt idx="5">
                    <c:v>3.2621765202675623E-2</c:v>
                  </c:pt>
                  <c:pt idx="6">
                    <c:v>3.725957154688983E-2</c:v>
                  </c:pt>
                  <c:pt idx="7">
                    <c:v>3.8756112732802231E-2</c:v>
                  </c:pt>
                  <c:pt idx="8">
                    <c:v>5.4248824888987336E-2</c:v>
                  </c:pt>
                </c:numCache>
              </c:numRef>
            </c:plus>
            <c:minus>
              <c:numRef>
                <c:f>'Fig S3'!$AY$298:$BG$298</c:f>
                <c:numCache>
                  <c:formatCode>General</c:formatCode>
                  <c:ptCount val="9"/>
                  <c:pt idx="0">
                    <c:v>4.5993940750354172E-2</c:v>
                  </c:pt>
                  <c:pt idx="1">
                    <c:v>3.5884013529125368E-2</c:v>
                  </c:pt>
                  <c:pt idx="2">
                    <c:v>3.2783135639747787E-2</c:v>
                  </c:pt>
                  <c:pt idx="3">
                    <c:v>6.8029799378178296E-2</c:v>
                  </c:pt>
                  <c:pt idx="4">
                    <c:v>3.2314505692722789E-2</c:v>
                  </c:pt>
                  <c:pt idx="5">
                    <c:v>3.2621765202675623E-2</c:v>
                  </c:pt>
                  <c:pt idx="6">
                    <c:v>3.725957154688983E-2</c:v>
                  </c:pt>
                  <c:pt idx="7">
                    <c:v>3.8756112732802231E-2</c:v>
                  </c:pt>
                  <c:pt idx="8">
                    <c:v>5.4248824888987336E-2</c:v>
                  </c:pt>
                </c:numCache>
              </c:numRef>
            </c:minus>
          </c:errBars>
          <c:xVal>
            <c:numRef>
              <c:f>'Fig S3'!$AP$292:$AX$2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298:$AX$298</c:f>
              <c:numCache>
                <c:formatCode>0.000</c:formatCode>
                <c:ptCount val="9"/>
                <c:pt idx="0">
                  <c:v>0.35860897261270475</c:v>
                </c:pt>
                <c:pt idx="1">
                  <c:v>0.2849713963205775</c:v>
                </c:pt>
                <c:pt idx="2">
                  <c:v>0.25570011521194458</c:v>
                </c:pt>
                <c:pt idx="3">
                  <c:v>0.30650152119304319</c:v>
                </c:pt>
                <c:pt idx="4">
                  <c:v>0.24845059793132429</c:v>
                </c:pt>
                <c:pt idx="5">
                  <c:v>0.21389501757109514</c:v>
                </c:pt>
                <c:pt idx="6">
                  <c:v>0.20632798900477139</c:v>
                </c:pt>
                <c:pt idx="7">
                  <c:v>0.22272883968480101</c:v>
                </c:pt>
                <c:pt idx="8">
                  <c:v>0.174316102636256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0228656"/>
        <c:axId val="350229216"/>
      </c:scatterChart>
      <c:valAx>
        <c:axId val="350228656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50229216"/>
        <c:crosses val="autoZero"/>
        <c:crossBetween val="midCat"/>
        <c:majorUnit val="2"/>
        <c:minorUnit val="1"/>
      </c:valAx>
      <c:valAx>
        <c:axId val="350229216"/>
        <c:scaling>
          <c:orientation val="minMax"/>
          <c:max val="0.5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50228656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N$295</c:f>
              <c:strCache>
                <c:ptCount val="1"/>
                <c:pt idx="0">
                  <c:v>high R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295:$BG$295</c:f>
                <c:numCache>
                  <c:formatCode>General</c:formatCode>
                  <c:ptCount val="9"/>
                  <c:pt idx="0">
                    <c:v>2.5695004984539211E-2</c:v>
                  </c:pt>
                  <c:pt idx="1">
                    <c:v>2.3411612480074367E-2</c:v>
                  </c:pt>
                  <c:pt idx="2">
                    <c:v>4.6598857111013213E-2</c:v>
                  </c:pt>
                  <c:pt idx="3">
                    <c:v>5.3508535417945043E-2</c:v>
                  </c:pt>
                  <c:pt idx="4">
                    <c:v>1.9441206922472008E-2</c:v>
                  </c:pt>
                  <c:pt idx="5">
                    <c:v>2.090224936995266E-2</c:v>
                  </c:pt>
                  <c:pt idx="6">
                    <c:v>2.3107799993568389E-2</c:v>
                  </c:pt>
                  <c:pt idx="7">
                    <c:v>3.7459552063124908E-2</c:v>
                  </c:pt>
                  <c:pt idx="8">
                    <c:v>4.8980631797253101E-2</c:v>
                  </c:pt>
                </c:numCache>
              </c:numRef>
            </c:plus>
            <c:minus>
              <c:numRef>
                <c:f>'Fig S3'!$AY$295:$BG$295</c:f>
                <c:numCache>
                  <c:formatCode>General</c:formatCode>
                  <c:ptCount val="9"/>
                  <c:pt idx="0">
                    <c:v>2.5695004984539211E-2</c:v>
                  </c:pt>
                  <c:pt idx="1">
                    <c:v>2.3411612480074367E-2</c:v>
                  </c:pt>
                  <c:pt idx="2">
                    <c:v>4.6598857111013213E-2</c:v>
                  </c:pt>
                  <c:pt idx="3">
                    <c:v>5.3508535417945043E-2</c:v>
                  </c:pt>
                  <c:pt idx="4">
                    <c:v>1.9441206922472008E-2</c:v>
                  </c:pt>
                  <c:pt idx="5">
                    <c:v>2.090224936995266E-2</c:v>
                  </c:pt>
                  <c:pt idx="6">
                    <c:v>2.3107799993568389E-2</c:v>
                  </c:pt>
                  <c:pt idx="7">
                    <c:v>3.7459552063124908E-2</c:v>
                  </c:pt>
                  <c:pt idx="8">
                    <c:v>4.8980631797253101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P$292:$AX$2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295:$AX$295</c:f>
              <c:numCache>
                <c:formatCode>0.000</c:formatCode>
                <c:ptCount val="9"/>
                <c:pt idx="0">
                  <c:v>0.26726394353799821</c:v>
                </c:pt>
                <c:pt idx="1">
                  <c:v>0.25733363353071448</c:v>
                </c:pt>
                <c:pt idx="2">
                  <c:v>0.26481060594696154</c:v>
                </c:pt>
                <c:pt idx="3">
                  <c:v>0.31297373839140025</c:v>
                </c:pt>
                <c:pt idx="4">
                  <c:v>0.21292939740425756</c:v>
                </c:pt>
                <c:pt idx="5">
                  <c:v>0.2102785678592595</c:v>
                </c:pt>
                <c:pt idx="6">
                  <c:v>0.20401998284160872</c:v>
                </c:pt>
                <c:pt idx="7">
                  <c:v>0.23683600285899079</c:v>
                </c:pt>
                <c:pt idx="8">
                  <c:v>0.1837570552228331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N$296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296:$BG$296</c:f>
                <c:numCache>
                  <c:formatCode>General</c:formatCode>
                  <c:ptCount val="9"/>
                  <c:pt idx="0">
                    <c:v>1.3907935771043449E-2</c:v>
                  </c:pt>
                  <c:pt idx="1">
                    <c:v>1.8350730426197677E-2</c:v>
                  </c:pt>
                  <c:pt idx="2">
                    <c:v>1.8564268082516669E-2</c:v>
                  </c:pt>
                  <c:pt idx="3">
                    <c:v>2.2423340720914214E-2</c:v>
                  </c:pt>
                  <c:pt idx="4">
                    <c:v>2.0718653859630187E-2</c:v>
                  </c:pt>
                  <c:pt idx="5">
                    <c:v>4.2858091955760153E-2</c:v>
                  </c:pt>
                  <c:pt idx="6">
                    <c:v>4.9065608044716089E-2</c:v>
                  </c:pt>
                  <c:pt idx="7">
                    <c:v>4.7770525965796624E-2</c:v>
                  </c:pt>
                  <c:pt idx="8">
                    <c:v>5.1236820591176069E-2</c:v>
                  </c:pt>
                </c:numCache>
              </c:numRef>
            </c:plus>
            <c:minus>
              <c:numRef>
                <c:f>'Fig S3'!$AY$296:$BG$296</c:f>
                <c:numCache>
                  <c:formatCode>General</c:formatCode>
                  <c:ptCount val="9"/>
                  <c:pt idx="0">
                    <c:v>1.3907935771043449E-2</c:v>
                  </c:pt>
                  <c:pt idx="1">
                    <c:v>1.8350730426197677E-2</c:v>
                  </c:pt>
                  <c:pt idx="2">
                    <c:v>1.8564268082516669E-2</c:v>
                  </c:pt>
                  <c:pt idx="3">
                    <c:v>2.2423340720914214E-2</c:v>
                  </c:pt>
                  <c:pt idx="4">
                    <c:v>2.0718653859630187E-2</c:v>
                  </c:pt>
                  <c:pt idx="5">
                    <c:v>4.2858091955760153E-2</c:v>
                  </c:pt>
                  <c:pt idx="6">
                    <c:v>4.9065608044716089E-2</c:v>
                  </c:pt>
                  <c:pt idx="7">
                    <c:v>4.7770525965796624E-2</c:v>
                  </c:pt>
                  <c:pt idx="8">
                    <c:v>5.1236820591176069E-2</c:v>
                  </c:pt>
                </c:numCache>
              </c:numRef>
            </c:minus>
          </c:errBars>
          <c:xVal>
            <c:numRef>
              <c:f>'Fig S3'!$AP$292:$AX$2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296:$AX$296</c:f>
              <c:numCache>
                <c:formatCode>0.000</c:formatCode>
                <c:ptCount val="9"/>
                <c:pt idx="0">
                  <c:v>0.21775580213964255</c:v>
                </c:pt>
                <c:pt idx="1">
                  <c:v>0.23333514465755761</c:v>
                </c:pt>
                <c:pt idx="2">
                  <c:v>0.20725982774359925</c:v>
                </c:pt>
                <c:pt idx="3">
                  <c:v>0.25267245758100726</c:v>
                </c:pt>
                <c:pt idx="4">
                  <c:v>0.1772203964418208</c:v>
                </c:pt>
                <c:pt idx="5">
                  <c:v>0.15989932918563518</c:v>
                </c:pt>
                <c:pt idx="6">
                  <c:v>0.11705442554206336</c:v>
                </c:pt>
                <c:pt idx="7">
                  <c:v>0.18671191789686475</c:v>
                </c:pt>
                <c:pt idx="8">
                  <c:v>0.1213433677857340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0223056"/>
        <c:axId val="350227536"/>
      </c:scatterChart>
      <c:valAx>
        <c:axId val="350223056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50227536"/>
        <c:crosses val="autoZero"/>
        <c:crossBetween val="midCat"/>
        <c:majorUnit val="2"/>
        <c:minorUnit val="1"/>
      </c:valAx>
      <c:valAx>
        <c:axId val="350227536"/>
        <c:scaling>
          <c:orientation val="minMax"/>
          <c:max val="0.5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50223056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N$293</c:f>
              <c:strCache>
                <c:ptCount val="1"/>
                <c:pt idx="0">
                  <c:v>high R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293:$BG$293</c:f>
                <c:numCache>
                  <c:formatCode>General</c:formatCode>
                  <c:ptCount val="9"/>
                  <c:pt idx="0">
                    <c:v>3.3991544500139172E-2</c:v>
                  </c:pt>
                  <c:pt idx="1">
                    <c:v>3.5214109725273793E-2</c:v>
                  </c:pt>
                  <c:pt idx="2">
                    <c:v>3.4697376772418992E-2</c:v>
                  </c:pt>
                  <c:pt idx="3">
                    <c:v>4.2716338763508659E-2</c:v>
                  </c:pt>
                  <c:pt idx="4">
                    <c:v>3.5458197501632961E-2</c:v>
                  </c:pt>
                  <c:pt idx="5">
                    <c:v>4.1428402577435734E-2</c:v>
                  </c:pt>
                  <c:pt idx="6">
                    <c:v>4.4324254771661888E-2</c:v>
                  </c:pt>
                  <c:pt idx="7">
                    <c:v>4.4656337545879839E-2</c:v>
                  </c:pt>
                  <c:pt idx="8">
                    <c:v>4.2040365052216734E-2</c:v>
                  </c:pt>
                </c:numCache>
              </c:numRef>
            </c:plus>
            <c:minus>
              <c:numRef>
                <c:f>'Fig S3'!$AY$293:$BG$293</c:f>
                <c:numCache>
                  <c:formatCode>General</c:formatCode>
                  <c:ptCount val="9"/>
                  <c:pt idx="0">
                    <c:v>3.3991544500139172E-2</c:v>
                  </c:pt>
                  <c:pt idx="1">
                    <c:v>3.5214109725273793E-2</c:v>
                  </c:pt>
                  <c:pt idx="2">
                    <c:v>3.4697376772418992E-2</c:v>
                  </c:pt>
                  <c:pt idx="3">
                    <c:v>4.2716338763508659E-2</c:v>
                  </c:pt>
                  <c:pt idx="4">
                    <c:v>3.5458197501632961E-2</c:v>
                  </c:pt>
                  <c:pt idx="5">
                    <c:v>4.1428402577435734E-2</c:v>
                  </c:pt>
                  <c:pt idx="6">
                    <c:v>4.4324254771661888E-2</c:v>
                  </c:pt>
                  <c:pt idx="7">
                    <c:v>4.4656337545879839E-2</c:v>
                  </c:pt>
                  <c:pt idx="8">
                    <c:v>4.2040365052216734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P$292:$AX$2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293:$AX$293</c:f>
              <c:numCache>
                <c:formatCode>0.000</c:formatCode>
                <c:ptCount val="9"/>
                <c:pt idx="0">
                  <c:v>0.29277351155393821</c:v>
                </c:pt>
                <c:pt idx="1">
                  <c:v>0.28382749579267613</c:v>
                </c:pt>
                <c:pt idx="2">
                  <c:v>0.27130449402195955</c:v>
                </c:pt>
                <c:pt idx="3">
                  <c:v>0.30195141610706949</c:v>
                </c:pt>
                <c:pt idx="4">
                  <c:v>0.2530612918128447</c:v>
                </c:pt>
                <c:pt idx="5">
                  <c:v>0.27025442563137386</c:v>
                </c:pt>
                <c:pt idx="6">
                  <c:v>0.27850812196348268</c:v>
                </c:pt>
                <c:pt idx="7">
                  <c:v>0.28092903710661138</c:v>
                </c:pt>
                <c:pt idx="8">
                  <c:v>0.2636124034576537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N$294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294:$BG$294</c:f>
                <c:numCache>
                  <c:formatCode>General</c:formatCode>
                  <c:ptCount val="9"/>
                  <c:pt idx="0">
                    <c:v>3.9446634953659535E-2</c:v>
                  </c:pt>
                  <c:pt idx="1">
                    <c:v>4.1100202502482218E-2</c:v>
                  </c:pt>
                  <c:pt idx="2">
                    <c:v>4.3959087592302153E-2</c:v>
                  </c:pt>
                  <c:pt idx="3">
                    <c:v>4.3692598535416814E-2</c:v>
                  </c:pt>
                  <c:pt idx="4">
                    <c:v>3.6775451243625017E-2</c:v>
                  </c:pt>
                  <c:pt idx="5">
                    <c:v>3.3229420880304568E-2</c:v>
                  </c:pt>
                  <c:pt idx="6">
                    <c:v>3.9449953014231244E-2</c:v>
                  </c:pt>
                  <c:pt idx="7">
                    <c:v>3.7666221095873961E-2</c:v>
                  </c:pt>
                  <c:pt idx="8">
                    <c:v>4.3481357433812672E-2</c:v>
                  </c:pt>
                </c:numCache>
              </c:numRef>
            </c:plus>
            <c:minus>
              <c:numRef>
                <c:f>'Fig S3'!$AY$294:$BG$294</c:f>
                <c:numCache>
                  <c:formatCode>General</c:formatCode>
                  <c:ptCount val="9"/>
                  <c:pt idx="0">
                    <c:v>3.9446634953659535E-2</c:v>
                  </c:pt>
                  <c:pt idx="1">
                    <c:v>4.1100202502482218E-2</c:v>
                  </c:pt>
                  <c:pt idx="2">
                    <c:v>4.3959087592302153E-2</c:v>
                  </c:pt>
                  <c:pt idx="3">
                    <c:v>4.3692598535416814E-2</c:v>
                  </c:pt>
                  <c:pt idx="4">
                    <c:v>3.6775451243625017E-2</c:v>
                  </c:pt>
                  <c:pt idx="5">
                    <c:v>3.3229420880304568E-2</c:v>
                  </c:pt>
                  <c:pt idx="6">
                    <c:v>3.9449953014231244E-2</c:v>
                  </c:pt>
                  <c:pt idx="7">
                    <c:v>3.7666221095873961E-2</c:v>
                  </c:pt>
                  <c:pt idx="8">
                    <c:v>4.3481357433812672E-2</c:v>
                  </c:pt>
                </c:numCache>
              </c:numRef>
            </c:minus>
          </c:errBars>
          <c:xVal>
            <c:numRef>
              <c:f>'Fig S3'!$AP$292:$AX$292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294:$AX$294</c:f>
              <c:numCache>
                <c:formatCode>0.000</c:formatCode>
                <c:ptCount val="9"/>
                <c:pt idx="0">
                  <c:v>0.27354797072069614</c:v>
                </c:pt>
                <c:pt idx="1">
                  <c:v>0.27119662621885943</c:v>
                </c:pt>
                <c:pt idx="2">
                  <c:v>0.26532323681585512</c:v>
                </c:pt>
                <c:pt idx="3">
                  <c:v>0.30593623210509097</c:v>
                </c:pt>
                <c:pt idx="4">
                  <c:v>0.2424882583082634</c:v>
                </c:pt>
                <c:pt idx="5">
                  <c:v>0.25215575708721782</c:v>
                </c:pt>
                <c:pt idx="6">
                  <c:v>0.26343349912540176</c:v>
                </c:pt>
                <c:pt idx="7">
                  <c:v>0.26760497973761388</c:v>
                </c:pt>
                <c:pt idx="8">
                  <c:v>0.2655144754474062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0010656"/>
        <c:axId val="200009536"/>
      </c:scatterChart>
      <c:valAx>
        <c:axId val="200010656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00009536"/>
        <c:crosses val="autoZero"/>
        <c:crossBetween val="midCat"/>
        <c:majorUnit val="2"/>
        <c:minorUnit val="1"/>
      </c:valAx>
      <c:valAx>
        <c:axId val="200009536"/>
        <c:scaling>
          <c:orientation val="minMax"/>
          <c:max val="0.5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200010656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N$403</c:f>
              <c:strCache>
                <c:ptCount val="1"/>
                <c:pt idx="0">
                  <c:v>high R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403:$BG$403</c:f>
                <c:numCache>
                  <c:formatCode>General</c:formatCode>
                  <c:ptCount val="9"/>
                  <c:pt idx="0">
                    <c:v>9.0697389243611384E-2</c:v>
                  </c:pt>
                  <c:pt idx="1">
                    <c:v>4.6944047116442143E-2</c:v>
                  </c:pt>
                  <c:pt idx="2">
                    <c:v>2.5246285315173603E-2</c:v>
                  </c:pt>
                  <c:pt idx="3">
                    <c:v>5.5185890053666496E-2</c:v>
                  </c:pt>
                  <c:pt idx="4">
                    <c:v>9.5923450572046418E-2</c:v>
                  </c:pt>
                  <c:pt idx="5">
                    <c:v>8.5165009721121815E-2</c:v>
                  </c:pt>
                  <c:pt idx="6">
                    <c:v>9.4982192009223462E-2</c:v>
                  </c:pt>
                  <c:pt idx="7">
                    <c:v>0.10424808618203649</c:v>
                  </c:pt>
                  <c:pt idx="8">
                    <c:v>7.7561577533481682E-2</c:v>
                  </c:pt>
                </c:numCache>
              </c:numRef>
            </c:plus>
            <c:minus>
              <c:numRef>
                <c:f>'Fig S3'!$AY$403:$BG$403</c:f>
                <c:numCache>
                  <c:formatCode>General</c:formatCode>
                  <c:ptCount val="9"/>
                  <c:pt idx="0">
                    <c:v>9.0697389243611384E-2</c:v>
                  </c:pt>
                  <c:pt idx="1">
                    <c:v>4.6944047116442143E-2</c:v>
                  </c:pt>
                  <c:pt idx="2">
                    <c:v>2.5246285315173603E-2</c:v>
                  </c:pt>
                  <c:pt idx="3">
                    <c:v>5.5185890053666496E-2</c:v>
                  </c:pt>
                  <c:pt idx="4">
                    <c:v>9.5923450572046418E-2</c:v>
                  </c:pt>
                  <c:pt idx="5">
                    <c:v>8.5165009721121815E-2</c:v>
                  </c:pt>
                  <c:pt idx="6">
                    <c:v>9.4982192009223462E-2</c:v>
                  </c:pt>
                  <c:pt idx="7">
                    <c:v>0.10424808618203649</c:v>
                  </c:pt>
                  <c:pt idx="8">
                    <c:v>7.7561577533481682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P$396:$AX$39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403:$AX$403</c:f>
              <c:numCache>
                <c:formatCode>0.000</c:formatCode>
                <c:ptCount val="9"/>
                <c:pt idx="0">
                  <c:v>0.31090311531695447</c:v>
                </c:pt>
                <c:pt idx="1">
                  <c:v>0.36288984066197949</c:v>
                </c:pt>
                <c:pt idx="2">
                  <c:v>0.33456705329601283</c:v>
                </c:pt>
                <c:pt idx="3">
                  <c:v>0.29317260175569537</c:v>
                </c:pt>
                <c:pt idx="4">
                  <c:v>0.63828176661328473</c:v>
                </c:pt>
                <c:pt idx="5">
                  <c:v>0.61249522459723194</c:v>
                </c:pt>
                <c:pt idx="6">
                  <c:v>0.58344583535914885</c:v>
                </c:pt>
                <c:pt idx="7">
                  <c:v>0.64726054582601056</c:v>
                </c:pt>
                <c:pt idx="8">
                  <c:v>0.6042875579819472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N$404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404:$BG$404</c:f>
                <c:numCache>
                  <c:formatCode>General</c:formatCode>
                  <c:ptCount val="9"/>
                  <c:pt idx="0">
                    <c:v>4.0415095827190328E-2</c:v>
                  </c:pt>
                  <c:pt idx="1">
                    <c:v>7.2137582039488043E-2</c:v>
                  </c:pt>
                  <c:pt idx="2">
                    <c:v>3.5174600383611913E-2</c:v>
                  </c:pt>
                  <c:pt idx="3">
                    <c:v>6.3904485252515145E-2</c:v>
                  </c:pt>
                  <c:pt idx="4">
                    <c:v>5.3838873587860978E-2</c:v>
                  </c:pt>
                  <c:pt idx="5">
                    <c:v>6.490770450828004E-2</c:v>
                  </c:pt>
                  <c:pt idx="6">
                    <c:v>7.5700579300958373E-2</c:v>
                  </c:pt>
                  <c:pt idx="7">
                    <c:v>0.10308652815405921</c:v>
                  </c:pt>
                  <c:pt idx="8">
                    <c:v>8.1839276904461716E-2</c:v>
                  </c:pt>
                </c:numCache>
              </c:numRef>
            </c:plus>
            <c:minus>
              <c:numRef>
                <c:f>'Fig S3'!$AY$404:$BG$404</c:f>
                <c:numCache>
                  <c:formatCode>General</c:formatCode>
                  <c:ptCount val="9"/>
                  <c:pt idx="0">
                    <c:v>4.0415095827190328E-2</c:v>
                  </c:pt>
                  <c:pt idx="1">
                    <c:v>7.2137582039488043E-2</c:v>
                  </c:pt>
                  <c:pt idx="2">
                    <c:v>3.5174600383611913E-2</c:v>
                  </c:pt>
                  <c:pt idx="3">
                    <c:v>6.3904485252515145E-2</c:v>
                  </c:pt>
                  <c:pt idx="4">
                    <c:v>5.3838873587860978E-2</c:v>
                  </c:pt>
                  <c:pt idx="5">
                    <c:v>6.490770450828004E-2</c:v>
                  </c:pt>
                  <c:pt idx="6">
                    <c:v>7.5700579300958373E-2</c:v>
                  </c:pt>
                  <c:pt idx="7">
                    <c:v>0.10308652815405921</c:v>
                  </c:pt>
                  <c:pt idx="8">
                    <c:v>8.1839276904461716E-2</c:v>
                  </c:pt>
                </c:numCache>
              </c:numRef>
            </c:minus>
          </c:errBars>
          <c:xVal>
            <c:numRef>
              <c:f>'Fig S3'!$AP$396:$AX$39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404:$AX$404</c:f>
              <c:numCache>
                <c:formatCode>0.000</c:formatCode>
                <c:ptCount val="9"/>
                <c:pt idx="0">
                  <c:v>0.35671424213080355</c:v>
                </c:pt>
                <c:pt idx="1">
                  <c:v>0.37626446085616222</c:v>
                </c:pt>
                <c:pt idx="2">
                  <c:v>0.3999591188122843</c:v>
                </c:pt>
                <c:pt idx="3">
                  <c:v>0.30108340984494586</c:v>
                </c:pt>
                <c:pt idx="4">
                  <c:v>0.51202985541009394</c:v>
                </c:pt>
                <c:pt idx="5">
                  <c:v>0.5657918317429782</c:v>
                </c:pt>
                <c:pt idx="6">
                  <c:v>0.6311099705578197</c:v>
                </c:pt>
                <c:pt idx="7">
                  <c:v>0.59241339549564742</c:v>
                </c:pt>
                <c:pt idx="8">
                  <c:v>0.6122641051617330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2529424"/>
        <c:axId val="272530544"/>
      </c:scatterChart>
      <c:valAx>
        <c:axId val="27252942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72530544"/>
        <c:crosses val="autoZero"/>
        <c:crossBetween val="midCat"/>
        <c:majorUnit val="2"/>
        <c:minorUnit val="1"/>
      </c:valAx>
      <c:valAx>
        <c:axId val="272530544"/>
        <c:scaling>
          <c:orientation val="minMax"/>
          <c:max val="0.8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272529424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N$401</c:f>
              <c:strCache>
                <c:ptCount val="1"/>
                <c:pt idx="0">
                  <c:v>high R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401:$BG$401</c:f>
                <c:numCache>
                  <c:formatCode>General</c:formatCode>
                  <c:ptCount val="9"/>
                  <c:pt idx="0">
                    <c:v>6.8518759043972186E-2</c:v>
                  </c:pt>
                  <c:pt idx="1">
                    <c:v>8.0711765266818308E-2</c:v>
                  </c:pt>
                  <c:pt idx="2">
                    <c:v>7.1288977264470116E-2</c:v>
                  </c:pt>
                  <c:pt idx="3">
                    <c:v>5.7518427766853557E-2</c:v>
                  </c:pt>
                  <c:pt idx="4">
                    <c:v>6.4739568676869169E-2</c:v>
                  </c:pt>
                  <c:pt idx="5">
                    <c:v>6.8618693495499275E-2</c:v>
                  </c:pt>
                  <c:pt idx="6">
                    <c:v>6.4592695546954015E-2</c:v>
                  </c:pt>
                  <c:pt idx="7">
                    <c:v>9.1212648689265499E-2</c:v>
                  </c:pt>
                  <c:pt idx="8">
                    <c:v>7.7714727956985169E-2</c:v>
                  </c:pt>
                </c:numCache>
              </c:numRef>
            </c:plus>
            <c:minus>
              <c:numRef>
                <c:f>'Fig S3'!$AY$401:$BG$401</c:f>
                <c:numCache>
                  <c:formatCode>General</c:formatCode>
                  <c:ptCount val="9"/>
                  <c:pt idx="0">
                    <c:v>6.8518759043972186E-2</c:v>
                  </c:pt>
                  <c:pt idx="1">
                    <c:v>8.0711765266818308E-2</c:v>
                  </c:pt>
                  <c:pt idx="2">
                    <c:v>7.1288977264470116E-2</c:v>
                  </c:pt>
                  <c:pt idx="3">
                    <c:v>5.7518427766853557E-2</c:v>
                  </c:pt>
                  <c:pt idx="4">
                    <c:v>6.4739568676869169E-2</c:v>
                  </c:pt>
                  <c:pt idx="5">
                    <c:v>6.8618693495499275E-2</c:v>
                  </c:pt>
                  <c:pt idx="6">
                    <c:v>6.4592695546954015E-2</c:v>
                  </c:pt>
                  <c:pt idx="7">
                    <c:v>9.1212648689265499E-2</c:v>
                  </c:pt>
                  <c:pt idx="8">
                    <c:v>7.7714727956985169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P$396:$AX$39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401:$AX$401</c:f>
              <c:numCache>
                <c:formatCode>0.000</c:formatCode>
                <c:ptCount val="9"/>
                <c:pt idx="0">
                  <c:v>0.31604129797633657</c:v>
                </c:pt>
                <c:pt idx="1">
                  <c:v>0.32046230848122803</c:v>
                </c:pt>
                <c:pt idx="2">
                  <c:v>0.33552866960610395</c:v>
                </c:pt>
                <c:pt idx="3">
                  <c:v>0.33772037470317579</c:v>
                </c:pt>
                <c:pt idx="4">
                  <c:v>0.38931767180397908</c:v>
                </c:pt>
                <c:pt idx="5">
                  <c:v>0.39279684426032541</c:v>
                </c:pt>
                <c:pt idx="6">
                  <c:v>0.43310409101640135</c:v>
                </c:pt>
                <c:pt idx="7">
                  <c:v>0.40328002663922768</c:v>
                </c:pt>
                <c:pt idx="8">
                  <c:v>0.3988279835842897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N$402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402:$BG$402</c:f>
                <c:numCache>
                  <c:formatCode>General</c:formatCode>
                  <c:ptCount val="9"/>
                  <c:pt idx="0">
                    <c:v>5.9179991617110808E-2</c:v>
                  </c:pt>
                  <c:pt idx="1">
                    <c:v>3.9328489398218314E-2</c:v>
                  </c:pt>
                  <c:pt idx="2">
                    <c:v>3.6174581754931906E-2</c:v>
                  </c:pt>
                  <c:pt idx="3">
                    <c:v>3.5174356746299394E-2</c:v>
                  </c:pt>
                  <c:pt idx="4">
                    <c:v>3.2364538301637241E-2</c:v>
                  </c:pt>
                  <c:pt idx="5">
                    <c:v>3.6019379548520275E-2</c:v>
                  </c:pt>
                  <c:pt idx="6">
                    <c:v>1.1842888135034877E-2</c:v>
                  </c:pt>
                  <c:pt idx="7">
                    <c:v>2.1184809913177508E-2</c:v>
                  </c:pt>
                  <c:pt idx="8">
                    <c:v>5.9803626769542054E-2</c:v>
                  </c:pt>
                </c:numCache>
              </c:numRef>
            </c:plus>
            <c:minus>
              <c:numRef>
                <c:f>'Fig S3'!$AY$402:$BG$402</c:f>
                <c:numCache>
                  <c:formatCode>General</c:formatCode>
                  <c:ptCount val="9"/>
                  <c:pt idx="0">
                    <c:v>5.9179991617110808E-2</c:v>
                  </c:pt>
                  <c:pt idx="1">
                    <c:v>3.9328489398218314E-2</c:v>
                  </c:pt>
                  <c:pt idx="2">
                    <c:v>3.6174581754931906E-2</c:v>
                  </c:pt>
                  <c:pt idx="3">
                    <c:v>3.5174356746299394E-2</c:v>
                  </c:pt>
                  <c:pt idx="4">
                    <c:v>3.2364538301637241E-2</c:v>
                  </c:pt>
                  <c:pt idx="5">
                    <c:v>3.6019379548520275E-2</c:v>
                  </c:pt>
                  <c:pt idx="6">
                    <c:v>1.1842888135034877E-2</c:v>
                  </c:pt>
                  <c:pt idx="7">
                    <c:v>2.1184809913177508E-2</c:v>
                  </c:pt>
                  <c:pt idx="8">
                    <c:v>5.9803626769542054E-2</c:v>
                  </c:pt>
                </c:numCache>
              </c:numRef>
            </c:minus>
          </c:errBars>
          <c:xVal>
            <c:numRef>
              <c:f>'Fig S3'!$AP$396:$AX$39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402:$AX$402</c:f>
              <c:numCache>
                <c:formatCode>0.000</c:formatCode>
                <c:ptCount val="9"/>
                <c:pt idx="0">
                  <c:v>0.35526324791889757</c:v>
                </c:pt>
                <c:pt idx="1">
                  <c:v>0.38916969237806437</c:v>
                </c:pt>
                <c:pt idx="2">
                  <c:v>0.41837164164272445</c:v>
                </c:pt>
                <c:pt idx="3">
                  <c:v>0.34524320023897764</c:v>
                </c:pt>
                <c:pt idx="4">
                  <c:v>0.39316895520065265</c:v>
                </c:pt>
                <c:pt idx="5">
                  <c:v>0.40249170482779639</c:v>
                </c:pt>
                <c:pt idx="6">
                  <c:v>0.38900923388316028</c:v>
                </c:pt>
                <c:pt idx="7">
                  <c:v>0.41119885927543942</c:v>
                </c:pt>
                <c:pt idx="8">
                  <c:v>0.3254693548362084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9615744"/>
        <c:axId val="349616864"/>
      </c:scatterChart>
      <c:valAx>
        <c:axId val="34961574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49616864"/>
        <c:crosses val="autoZero"/>
        <c:crossBetween val="midCat"/>
        <c:majorUnit val="2"/>
        <c:minorUnit val="1"/>
      </c:valAx>
      <c:valAx>
        <c:axId val="349616864"/>
        <c:scaling>
          <c:orientation val="minMax"/>
          <c:max val="0.8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49615744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N$399</c:f>
              <c:strCache>
                <c:ptCount val="1"/>
                <c:pt idx="0">
                  <c:v>high R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399:$BG$399</c:f>
                <c:numCache>
                  <c:formatCode>General</c:formatCode>
                  <c:ptCount val="9"/>
                  <c:pt idx="0">
                    <c:v>5.0881049992267204E-2</c:v>
                  </c:pt>
                  <c:pt idx="1">
                    <c:v>4.9613698908295069E-2</c:v>
                  </c:pt>
                  <c:pt idx="2">
                    <c:v>6.2706608882888662E-2</c:v>
                  </c:pt>
                  <c:pt idx="3">
                    <c:v>4.9887390130209472E-2</c:v>
                  </c:pt>
                  <c:pt idx="4">
                    <c:v>4.7346822674876859E-2</c:v>
                  </c:pt>
                  <c:pt idx="5">
                    <c:v>5.5914538424434231E-2</c:v>
                  </c:pt>
                  <c:pt idx="6">
                    <c:v>4.6884638833643202E-2</c:v>
                  </c:pt>
                  <c:pt idx="7">
                    <c:v>4.4662373435646399E-2</c:v>
                  </c:pt>
                  <c:pt idx="8">
                    <c:v>7.1898675831990638E-2</c:v>
                  </c:pt>
                </c:numCache>
              </c:numRef>
            </c:plus>
            <c:minus>
              <c:numRef>
                <c:f>'Fig S3'!$AY$399:$BG$399</c:f>
                <c:numCache>
                  <c:formatCode>General</c:formatCode>
                  <c:ptCount val="9"/>
                  <c:pt idx="0">
                    <c:v>5.0881049992267204E-2</c:v>
                  </c:pt>
                  <c:pt idx="1">
                    <c:v>4.9613698908295069E-2</c:v>
                  </c:pt>
                  <c:pt idx="2">
                    <c:v>6.2706608882888662E-2</c:v>
                  </c:pt>
                  <c:pt idx="3">
                    <c:v>4.9887390130209472E-2</c:v>
                  </c:pt>
                  <c:pt idx="4">
                    <c:v>4.7346822674876859E-2</c:v>
                  </c:pt>
                  <c:pt idx="5">
                    <c:v>5.5914538424434231E-2</c:v>
                  </c:pt>
                  <c:pt idx="6">
                    <c:v>4.6884638833643202E-2</c:v>
                  </c:pt>
                  <c:pt idx="7">
                    <c:v>4.4662373435646399E-2</c:v>
                  </c:pt>
                  <c:pt idx="8">
                    <c:v>7.1898675831990638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P$396:$AX$39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399:$AX$399</c:f>
              <c:numCache>
                <c:formatCode>0.000</c:formatCode>
                <c:ptCount val="9"/>
                <c:pt idx="0">
                  <c:v>0.35532689489694225</c:v>
                </c:pt>
                <c:pt idx="1">
                  <c:v>0.40620612111710752</c:v>
                </c:pt>
                <c:pt idx="2">
                  <c:v>0.41743808376373781</c:v>
                </c:pt>
                <c:pt idx="3">
                  <c:v>0.44834209542734821</c:v>
                </c:pt>
                <c:pt idx="4">
                  <c:v>0.47405006274100614</c:v>
                </c:pt>
                <c:pt idx="5">
                  <c:v>0.34163199428964541</c:v>
                </c:pt>
                <c:pt idx="6">
                  <c:v>0.46408551463938325</c:v>
                </c:pt>
                <c:pt idx="7">
                  <c:v>0.53750289601292567</c:v>
                </c:pt>
                <c:pt idx="8">
                  <c:v>0.5693257679746015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N$400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400:$BG$400</c:f>
                <c:numCache>
                  <c:formatCode>General</c:formatCode>
                  <c:ptCount val="9"/>
                  <c:pt idx="0">
                    <c:v>3.6783207922251218E-2</c:v>
                  </c:pt>
                  <c:pt idx="1">
                    <c:v>3.6207781014181664E-2</c:v>
                  </c:pt>
                  <c:pt idx="2">
                    <c:v>2.1526957078829182E-2</c:v>
                  </c:pt>
                  <c:pt idx="3">
                    <c:v>3.2680173501924883E-2</c:v>
                  </c:pt>
                  <c:pt idx="4">
                    <c:v>2.8057390626139253E-2</c:v>
                  </c:pt>
                  <c:pt idx="5">
                    <c:v>3.642230193958438E-2</c:v>
                  </c:pt>
                  <c:pt idx="6">
                    <c:v>0.10557571000565907</c:v>
                  </c:pt>
                  <c:pt idx="7">
                    <c:v>4.7919218938563948E-2</c:v>
                  </c:pt>
                  <c:pt idx="8">
                    <c:v>5.2742846236240024E-2</c:v>
                  </c:pt>
                </c:numCache>
              </c:numRef>
            </c:plus>
            <c:minus>
              <c:numRef>
                <c:f>'Fig S3'!$AY$400:$BG$400</c:f>
                <c:numCache>
                  <c:formatCode>General</c:formatCode>
                  <c:ptCount val="9"/>
                  <c:pt idx="0">
                    <c:v>3.6783207922251218E-2</c:v>
                  </c:pt>
                  <c:pt idx="1">
                    <c:v>3.6207781014181664E-2</c:v>
                  </c:pt>
                  <c:pt idx="2">
                    <c:v>2.1526957078829182E-2</c:v>
                  </c:pt>
                  <c:pt idx="3">
                    <c:v>3.2680173501924883E-2</c:v>
                  </c:pt>
                  <c:pt idx="4">
                    <c:v>2.8057390626139253E-2</c:v>
                  </c:pt>
                  <c:pt idx="5">
                    <c:v>3.642230193958438E-2</c:v>
                  </c:pt>
                  <c:pt idx="6">
                    <c:v>0.10557571000565907</c:v>
                  </c:pt>
                  <c:pt idx="7">
                    <c:v>4.7919218938563948E-2</c:v>
                  </c:pt>
                  <c:pt idx="8">
                    <c:v>5.2742846236240024E-2</c:v>
                  </c:pt>
                </c:numCache>
              </c:numRef>
            </c:minus>
          </c:errBars>
          <c:xVal>
            <c:numRef>
              <c:f>'Fig S3'!$AP$396:$AX$39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400:$AX$400</c:f>
              <c:numCache>
                <c:formatCode>0.000</c:formatCode>
                <c:ptCount val="9"/>
                <c:pt idx="0">
                  <c:v>0.42345861198984014</c:v>
                </c:pt>
                <c:pt idx="1">
                  <c:v>0.47320845118593713</c:v>
                </c:pt>
                <c:pt idx="2">
                  <c:v>0.46959009265288909</c:v>
                </c:pt>
                <c:pt idx="3">
                  <c:v>0.48958928961392995</c:v>
                </c:pt>
                <c:pt idx="4">
                  <c:v>0.54306309736818648</c:v>
                </c:pt>
                <c:pt idx="5">
                  <c:v>0.49254514851449116</c:v>
                </c:pt>
                <c:pt idx="6">
                  <c:v>0.61291599781370409</c:v>
                </c:pt>
                <c:pt idx="7">
                  <c:v>0.60820608671619691</c:v>
                </c:pt>
                <c:pt idx="8">
                  <c:v>0.6115610303518532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9614064"/>
        <c:axId val="349613504"/>
      </c:scatterChart>
      <c:valAx>
        <c:axId val="34961406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49613504"/>
        <c:crosses val="autoZero"/>
        <c:crossBetween val="midCat"/>
        <c:majorUnit val="2"/>
        <c:minorUnit val="1"/>
      </c:valAx>
      <c:valAx>
        <c:axId val="349613504"/>
        <c:scaling>
          <c:orientation val="minMax"/>
          <c:max val="0.8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49614064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N$397</c:f>
              <c:strCache>
                <c:ptCount val="1"/>
                <c:pt idx="0">
                  <c:v>high R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397:$BG$397</c:f>
                <c:numCache>
                  <c:formatCode>General</c:formatCode>
                  <c:ptCount val="9"/>
                  <c:pt idx="0">
                    <c:v>6.1552105247817367E-2</c:v>
                  </c:pt>
                  <c:pt idx="1">
                    <c:v>6.6337292016422564E-2</c:v>
                  </c:pt>
                  <c:pt idx="2">
                    <c:v>7.0671082278953329E-2</c:v>
                  </c:pt>
                  <c:pt idx="3">
                    <c:v>4.6845267581319065E-2</c:v>
                  </c:pt>
                  <c:pt idx="4">
                    <c:v>7.6790432928784708E-2</c:v>
                  </c:pt>
                  <c:pt idx="5">
                    <c:v>6.6420493624498492E-2</c:v>
                  </c:pt>
                  <c:pt idx="6">
                    <c:v>8.0741647715626294E-2</c:v>
                  </c:pt>
                  <c:pt idx="7">
                    <c:v>9.8385460308734296E-2</c:v>
                  </c:pt>
                  <c:pt idx="8">
                    <c:v>7.3081585297768759E-2</c:v>
                  </c:pt>
                </c:numCache>
              </c:numRef>
            </c:plus>
            <c:minus>
              <c:numRef>
                <c:f>'Fig S3'!$AY$397:$BG$397</c:f>
                <c:numCache>
                  <c:formatCode>General</c:formatCode>
                  <c:ptCount val="9"/>
                  <c:pt idx="0">
                    <c:v>6.1552105247817367E-2</c:v>
                  </c:pt>
                  <c:pt idx="1">
                    <c:v>6.6337292016422564E-2</c:v>
                  </c:pt>
                  <c:pt idx="2">
                    <c:v>7.0671082278953329E-2</c:v>
                  </c:pt>
                  <c:pt idx="3">
                    <c:v>4.6845267581319065E-2</c:v>
                  </c:pt>
                  <c:pt idx="4">
                    <c:v>7.6790432928784708E-2</c:v>
                  </c:pt>
                  <c:pt idx="5">
                    <c:v>6.6420493624498492E-2</c:v>
                  </c:pt>
                  <c:pt idx="6">
                    <c:v>8.0741647715626294E-2</c:v>
                  </c:pt>
                  <c:pt idx="7">
                    <c:v>9.8385460308734296E-2</c:v>
                  </c:pt>
                  <c:pt idx="8">
                    <c:v>7.3081585297768759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P$396:$AX$39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397:$AX$397</c:f>
              <c:numCache>
                <c:formatCode>0.000</c:formatCode>
                <c:ptCount val="9"/>
                <c:pt idx="0">
                  <c:v>0.36141261462633767</c:v>
                </c:pt>
                <c:pt idx="1">
                  <c:v>0.38903959957163592</c:v>
                </c:pt>
                <c:pt idx="2">
                  <c:v>0.3182462889448977</c:v>
                </c:pt>
                <c:pt idx="3">
                  <c:v>0.31403553066151174</c:v>
                </c:pt>
                <c:pt idx="4">
                  <c:v>0.3063313120343496</c:v>
                </c:pt>
                <c:pt idx="5">
                  <c:v>0.38191476921283352</c:v>
                </c:pt>
                <c:pt idx="6">
                  <c:v>0.33449219825289295</c:v>
                </c:pt>
                <c:pt idx="7">
                  <c:v>0.29933644120949571</c:v>
                </c:pt>
                <c:pt idx="8">
                  <c:v>0.3601521265402333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N$398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398:$BG$398</c:f>
                <c:numCache>
                  <c:formatCode>General</c:formatCode>
                  <c:ptCount val="9"/>
                  <c:pt idx="0">
                    <c:v>3.7459704433375235E-2</c:v>
                  </c:pt>
                  <c:pt idx="1">
                    <c:v>4.2290911274799614E-2</c:v>
                  </c:pt>
                  <c:pt idx="2">
                    <c:v>5.9632963826193541E-2</c:v>
                  </c:pt>
                  <c:pt idx="3">
                    <c:v>4.8244352039511613E-2</c:v>
                  </c:pt>
                  <c:pt idx="4">
                    <c:v>5.4400211963897938E-2</c:v>
                  </c:pt>
                  <c:pt idx="5">
                    <c:v>7.2281572886357698E-2</c:v>
                  </c:pt>
                  <c:pt idx="6">
                    <c:v>5.0727051347912278E-2</c:v>
                  </c:pt>
                  <c:pt idx="7">
                    <c:v>4.5939923653551921E-2</c:v>
                  </c:pt>
                  <c:pt idx="8">
                    <c:v>4.1532748920074677E-2</c:v>
                  </c:pt>
                </c:numCache>
              </c:numRef>
            </c:plus>
            <c:minus>
              <c:numRef>
                <c:f>'Fig S3'!$AY$398:$BG$398</c:f>
                <c:numCache>
                  <c:formatCode>General</c:formatCode>
                  <c:ptCount val="9"/>
                  <c:pt idx="0">
                    <c:v>3.7459704433375235E-2</c:v>
                  </c:pt>
                  <c:pt idx="1">
                    <c:v>4.2290911274799614E-2</c:v>
                  </c:pt>
                  <c:pt idx="2">
                    <c:v>5.9632963826193541E-2</c:v>
                  </c:pt>
                  <c:pt idx="3">
                    <c:v>4.8244352039511613E-2</c:v>
                  </c:pt>
                  <c:pt idx="4">
                    <c:v>5.4400211963897938E-2</c:v>
                  </c:pt>
                  <c:pt idx="5">
                    <c:v>7.2281572886357698E-2</c:v>
                  </c:pt>
                  <c:pt idx="6">
                    <c:v>5.0727051347912278E-2</c:v>
                  </c:pt>
                  <c:pt idx="7">
                    <c:v>4.5939923653551921E-2</c:v>
                  </c:pt>
                  <c:pt idx="8">
                    <c:v>4.1532748920074677E-2</c:v>
                  </c:pt>
                </c:numCache>
              </c:numRef>
            </c:minus>
          </c:errBars>
          <c:xVal>
            <c:numRef>
              <c:f>'Fig S3'!$AP$396:$AX$39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398:$AX$398</c:f>
              <c:numCache>
                <c:formatCode>0.000</c:formatCode>
                <c:ptCount val="9"/>
                <c:pt idx="0">
                  <c:v>0.35516088375257188</c:v>
                </c:pt>
                <c:pt idx="1">
                  <c:v>0.43553169369256767</c:v>
                </c:pt>
                <c:pt idx="2">
                  <c:v>0.40583349586503059</c:v>
                </c:pt>
                <c:pt idx="3">
                  <c:v>0.44312812958262909</c:v>
                </c:pt>
                <c:pt idx="4">
                  <c:v>0.39043649188334228</c:v>
                </c:pt>
                <c:pt idx="5">
                  <c:v>0.40701647766799098</c:v>
                </c:pt>
                <c:pt idx="6">
                  <c:v>0.34837783600182443</c:v>
                </c:pt>
                <c:pt idx="7">
                  <c:v>0.3571883775872059</c:v>
                </c:pt>
                <c:pt idx="8">
                  <c:v>0.4082078549854725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2853264"/>
        <c:axId val="212852704"/>
      </c:scatterChart>
      <c:valAx>
        <c:axId val="212853264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12852704"/>
        <c:crosses val="autoZero"/>
        <c:crossBetween val="midCat"/>
        <c:majorUnit val="2"/>
        <c:minorUnit val="1"/>
      </c:valAx>
      <c:valAx>
        <c:axId val="212852704"/>
        <c:scaling>
          <c:orientation val="minMax"/>
          <c:max val="0.8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crossAx val="212853264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700"/>
      </a:pPr>
      <a:endParaRPr lang="en-US"/>
    </a:p>
  </c:txPr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N$463</c:f>
              <c:strCache>
                <c:ptCount val="1"/>
                <c:pt idx="0">
                  <c:v>high Rs</c:v>
                </c:pt>
              </c:strCache>
            </c:strRef>
          </c:tx>
          <c:spPr>
            <a:ln w="12700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463:$BG$463</c:f>
                <c:numCache>
                  <c:formatCode>General</c:formatCode>
                  <c:ptCount val="9"/>
                  <c:pt idx="0">
                    <c:v>4.8308321604928622E-2</c:v>
                  </c:pt>
                  <c:pt idx="1">
                    <c:v>3.3238774117891896E-2</c:v>
                  </c:pt>
                  <c:pt idx="2">
                    <c:v>2.2209846064476242E-2</c:v>
                  </c:pt>
                  <c:pt idx="3">
                    <c:v>4.6220372234505043E-2</c:v>
                  </c:pt>
                  <c:pt idx="4">
                    <c:v>3.6679782273208561E-2</c:v>
                  </c:pt>
                  <c:pt idx="5">
                    <c:v>4.8893010965485033E-2</c:v>
                  </c:pt>
                  <c:pt idx="6">
                    <c:v>7.5192795720175704E-2</c:v>
                  </c:pt>
                  <c:pt idx="7">
                    <c:v>5.7766903841782367E-2</c:v>
                  </c:pt>
                  <c:pt idx="8">
                    <c:v>3.2182895327841583E-2</c:v>
                  </c:pt>
                </c:numCache>
              </c:numRef>
            </c:plus>
            <c:minus>
              <c:numRef>
                <c:f>'Fig S3'!$AY$463:$BG$463</c:f>
                <c:numCache>
                  <c:formatCode>General</c:formatCode>
                  <c:ptCount val="9"/>
                  <c:pt idx="0">
                    <c:v>4.8308321604928622E-2</c:v>
                  </c:pt>
                  <c:pt idx="1">
                    <c:v>3.3238774117891896E-2</c:v>
                  </c:pt>
                  <c:pt idx="2">
                    <c:v>2.2209846064476242E-2</c:v>
                  </c:pt>
                  <c:pt idx="3">
                    <c:v>4.6220372234505043E-2</c:v>
                  </c:pt>
                  <c:pt idx="4">
                    <c:v>3.6679782273208561E-2</c:v>
                  </c:pt>
                  <c:pt idx="5">
                    <c:v>4.8893010965485033E-2</c:v>
                  </c:pt>
                  <c:pt idx="6">
                    <c:v>7.5192795720175704E-2</c:v>
                  </c:pt>
                  <c:pt idx="7">
                    <c:v>5.7766903841782367E-2</c:v>
                  </c:pt>
                  <c:pt idx="8">
                    <c:v>3.2182895327841583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P$456:$AX$45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463:$AX$463</c:f>
              <c:numCache>
                <c:formatCode>0.000</c:formatCode>
                <c:ptCount val="9"/>
                <c:pt idx="0">
                  <c:v>0.37864016239554416</c:v>
                </c:pt>
                <c:pt idx="1">
                  <c:v>0.32017523732126585</c:v>
                </c:pt>
                <c:pt idx="2">
                  <c:v>0.39802343924467132</c:v>
                </c:pt>
                <c:pt idx="3">
                  <c:v>0.40230357188377147</c:v>
                </c:pt>
                <c:pt idx="4">
                  <c:v>0.16313628955724166</c:v>
                </c:pt>
                <c:pt idx="5">
                  <c:v>0.29308007623225019</c:v>
                </c:pt>
                <c:pt idx="6">
                  <c:v>0.32745572857829364</c:v>
                </c:pt>
                <c:pt idx="7">
                  <c:v>0.23565109853179331</c:v>
                </c:pt>
                <c:pt idx="8">
                  <c:v>0.2958547582239103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N$464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464:$BG$464</c:f>
                <c:numCache>
                  <c:formatCode>General</c:formatCode>
                  <c:ptCount val="9"/>
                  <c:pt idx="0">
                    <c:v>5.4277212849966547E-2</c:v>
                  </c:pt>
                  <c:pt idx="1">
                    <c:v>5.5286808517496351E-2</c:v>
                  </c:pt>
                  <c:pt idx="2">
                    <c:v>3.4069402203387909E-2</c:v>
                  </c:pt>
                  <c:pt idx="3">
                    <c:v>0.10075727945431055</c:v>
                  </c:pt>
                  <c:pt idx="4">
                    <c:v>3.8943296574116312E-2</c:v>
                  </c:pt>
                  <c:pt idx="5">
                    <c:v>4.2925301090615028E-2</c:v>
                  </c:pt>
                  <c:pt idx="6">
                    <c:v>2.2278368257871713E-2</c:v>
                  </c:pt>
                  <c:pt idx="7">
                    <c:v>7.0724620341906894E-2</c:v>
                  </c:pt>
                  <c:pt idx="8">
                    <c:v>4.6270959047436069E-2</c:v>
                  </c:pt>
                </c:numCache>
              </c:numRef>
            </c:plus>
            <c:minus>
              <c:numRef>
                <c:f>'Fig S3'!$AY$464:$BG$464</c:f>
                <c:numCache>
                  <c:formatCode>General</c:formatCode>
                  <c:ptCount val="9"/>
                  <c:pt idx="0">
                    <c:v>5.4277212849966547E-2</c:v>
                  </c:pt>
                  <c:pt idx="1">
                    <c:v>5.5286808517496351E-2</c:v>
                  </c:pt>
                  <c:pt idx="2">
                    <c:v>3.4069402203387909E-2</c:v>
                  </c:pt>
                  <c:pt idx="3">
                    <c:v>0.10075727945431055</c:v>
                  </c:pt>
                  <c:pt idx="4">
                    <c:v>3.8943296574116312E-2</c:v>
                  </c:pt>
                  <c:pt idx="5">
                    <c:v>4.2925301090615028E-2</c:v>
                  </c:pt>
                  <c:pt idx="6">
                    <c:v>2.2278368257871713E-2</c:v>
                  </c:pt>
                  <c:pt idx="7">
                    <c:v>7.0724620341906894E-2</c:v>
                  </c:pt>
                  <c:pt idx="8">
                    <c:v>4.6270959047436069E-2</c:v>
                  </c:pt>
                </c:numCache>
              </c:numRef>
            </c:minus>
          </c:errBars>
          <c:xVal>
            <c:numRef>
              <c:f>'Fig S3'!$AP$456:$AX$45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464:$AX$464</c:f>
              <c:numCache>
                <c:formatCode>0.000</c:formatCode>
                <c:ptCount val="9"/>
                <c:pt idx="0">
                  <c:v>0.3920881504092889</c:v>
                </c:pt>
                <c:pt idx="1">
                  <c:v>0.3613716569745371</c:v>
                </c:pt>
                <c:pt idx="2">
                  <c:v>0.36468918234023628</c:v>
                </c:pt>
                <c:pt idx="3">
                  <c:v>0.44842253454372383</c:v>
                </c:pt>
                <c:pt idx="4">
                  <c:v>0.28129658553478892</c:v>
                </c:pt>
                <c:pt idx="5">
                  <c:v>0.29742652430843242</c:v>
                </c:pt>
                <c:pt idx="6">
                  <c:v>0.27314579922261628</c:v>
                </c:pt>
                <c:pt idx="7">
                  <c:v>0.30395047613996334</c:v>
                </c:pt>
                <c:pt idx="8">
                  <c:v>0.2901052543957872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5220336"/>
        <c:axId val="211412704"/>
      </c:scatterChart>
      <c:valAx>
        <c:axId val="215220336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211412704"/>
        <c:crosses val="autoZero"/>
        <c:crossBetween val="midCat"/>
        <c:majorUnit val="2"/>
        <c:minorUnit val="1"/>
      </c:valAx>
      <c:valAx>
        <c:axId val="211412704"/>
        <c:scaling>
          <c:orientation val="minMax"/>
          <c:max val="0.60000000000000009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215220336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Q$35</c:f>
              <c:strCache>
                <c:ptCount val="1"/>
                <c:pt idx="0">
                  <c:v>high Rs</c:v>
                </c:pt>
              </c:strCache>
            </c:strRef>
          </c:tx>
          <c:spPr>
            <a:ln w="12700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BC$35:$BL$35</c:f>
                <c:numCache>
                  <c:formatCode>General</c:formatCode>
                  <c:ptCount val="10"/>
                  <c:pt idx="0">
                    <c:v>1.2773677793024227E-2</c:v>
                  </c:pt>
                  <c:pt idx="1">
                    <c:v>9.8476747072595815E-3</c:v>
                  </c:pt>
                  <c:pt idx="2">
                    <c:v>3.7525995989447108E-3</c:v>
                  </c:pt>
                  <c:pt idx="3">
                    <c:v>6.8566439633395019E-3</c:v>
                  </c:pt>
                  <c:pt idx="4">
                    <c:v>6.1212607639276545E-3</c:v>
                  </c:pt>
                  <c:pt idx="5">
                    <c:v>9.0522262256308977E-3</c:v>
                  </c:pt>
                  <c:pt idx="6">
                    <c:v>1.5661338795262679E-2</c:v>
                  </c:pt>
                  <c:pt idx="7">
                    <c:v>3.86699823149688E-2</c:v>
                  </c:pt>
                  <c:pt idx="8">
                    <c:v>5.2789674730954722E-2</c:v>
                  </c:pt>
                  <c:pt idx="9">
                    <c:v>4.9223136931731616E-2</c:v>
                  </c:pt>
                </c:numCache>
              </c:numRef>
            </c:plus>
            <c:minus>
              <c:numRef>
                <c:f>'Fig S3'!$BC$35:$BL$35</c:f>
                <c:numCache>
                  <c:formatCode>General</c:formatCode>
                  <c:ptCount val="10"/>
                  <c:pt idx="0">
                    <c:v>1.2773677793024227E-2</c:v>
                  </c:pt>
                  <c:pt idx="1">
                    <c:v>9.8476747072595815E-3</c:v>
                  </c:pt>
                  <c:pt idx="2">
                    <c:v>3.7525995989447108E-3</c:v>
                  </c:pt>
                  <c:pt idx="3">
                    <c:v>6.8566439633395019E-3</c:v>
                  </c:pt>
                  <c:pt idx="4">
                    <c:v>6.1212607639276545E-3</c:v>
                  </c:pt>
                  <c:pt idx="5">
                    <c:v>9.0522262256308977E-3</c:v>
                  </c:pt>
                  <c:pt idx="6">
                    <c:v>1.5661338795262679E-2</c:v>
                  </c:pt>
                  <c:pt idx="7">
                    <c:v>3.86699823149688E-2</c:v>
                  </c:pt>
                  <c:pt idx="8">
                    <c:v>5.2789674730954722E-2</c:v>
                  </c:pt>
                  <c:pt idx="9">
                    <c:v>4.9223136931731616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S$30:$BB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3'!$AS$35:$BB$35</c:f>
              <c:numCache>
                <c:formatCode>0.00E+00</c:formatCode>
                <c:ptCount val="10"/>
                <c:pt idx="0">
                  <c:v>7.2007399999999999E-2</c:v>
                </c:pt>
                <c:pt idx="1">
                  <c:v>7.44972E-2</c:v>
                </c:pt>
                <c:pt idx="2">
                  <c:v>7.6408500000000004E-2</c:v>
                </c:pt>
                <c:pt idx="3">
                  <c:v>6.1137200000000003E-2</c:v>
                </c:pt>
                <c:pt idx="4">
                  <c:v>6.2329799999999991E-2</c:v>
                </c:pt>
                <c:pt idx="5">
                  <c:v>7.1346800000000002E-2</c:v>
                </c:pt>
                <c:pt idx="6">
                  <c:v>8.3820400000000003E-2</c:v>
                </c:pt>
                <c:pt idx="7">
                  <c:v>0.10573220000000001</c:v>
                </c:pt>
                <c:pt idx="8">
                  <c:v>0.13156300000000001</c:v>
                </c:pt>
                <c:pt idx="9">
                  <c:v>0.13692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Q$36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BC$36:$BL$36</c:f>
                <c:numCache>
                  <c:formatCode>General</c:formatCode>
                  <c:ptCount val="10"/>
                  <c:pt idx="0">
                    <c:v>2.8911254029183861E-2</c:v>
                  </c:pt>
                  <c:pt idx="1">
                    <c:v>2.786740309465523E-2</c:v>
                  </c:pt>
                  <c:pt idx="2">
                    <c:v>3.4318674247995083E-2</c:v>
                  </c:pt>
                  <c:pt idx="3">
                    <c:v>2.6689567883350983E-2</c:v>
                  </c:pt>
                  <c:pt idx="4">
                    <c:v>2.3635782056379409E-2</c:v>
                  </c:pt>
                  <c:pt idx="5">
                    <c:v>3.5824806368771903E-2</c:v>
                  </c:pt>
                  <c:pt idx="6">
                    <c:v>3.4627396184235396E-2</c:v>
                  </c:pt>
                  <c:pt idx="7">
                    <c:v>3.6440099514682994E-2</c:v>
                  </c:pt>
                  <c:pt idx="8">
                    <c:v>4.7134772605158505E-2</c:v>
                  </c:pt>
                  <c:pt idx="9">
                    <c:v>6.3422161888097128E-2</c:v>
                  </c:pt>
                </c:numCache>
              </c:numRef>
            </c:plus>
            <c:minus>
              <c:numRef>
                <c:f>'Fig S3'!$BC$36:$BL$36</c:f>
                <c:numCache>
                  <c:formatCode>General</c:formatCode>
                  <c:ptCount val="10"/>
                  <c:pt idx="0">
                    <c:v>2.8911254029183861E-2</c:v>
                  </c:pt>
                  <c:pt idx="1">
                    <c:v>2.786740309465523E-2</c:v>
                  </c:pt>
                  <c:pt idx="2">
                    <c:v>3.4318674247995083E-2</c:v>
                  </c:pt>
                  <c:pt idx="3">
                    <c:v>2.6689567883350983E-2</c:v>
                  </c:pt>
                  <c:pt idx="4">
                    <c:v>2.3635782056379409E-2</c:v>
                  </c:pt>
                  <c:pt idx="5">
                    <c:v>3.5824806368771903E-2</c:v>
                  </c:pt>
                  <c:pt idx="6">
                    <c:v>3.4627396184235396E-2</c:v>
                  </c:pt>
                  <c:pt idx="7">
                    <c:v>3.6440099514682994E-2</c:v>
                  </c:pt>
                  <c:pt idx="8">
                    <c:v>4.7134772605158505E-2</c:v>
                  </c:pt>
                  <c:pt idx="9">
                    <c:v>6.3422161888097128E-2</c:v>
                  </c:pt>
                </c:numCache>
              </c:numRef>
            </c:minus>
          </c:errBars>
          <c:xVal>
            <c:numRef>
              <c:f>'Fig S3'!$AS$30:$BB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3'!$AS$36:$BB$36</c:f>
              <c:numCache>
                <c:formatCode>0.00E+00</c:formatCode>
                <c:ptCount val="10"/>
                <c:pt idx="0">
                  <c:v>9.2307199999999992E-2</c:v>
                </c:pt>
                <c:pt idx="1">
                  <c:v>9.0962199999999993E-2</c:v>
                </c:pt>
                <c:pt idx="2">
                  <c:v>9.6721199999999993E-2</c:v>
                </c:pt>
                <c:pt idx="3">
                  <c:v>7.9812999999999995E-2</c:v>
                </c:pt>
                <c:pt idx="4">
                  <c:v>7.0947499999999997E-2</c:v>
                </c:pt>
                <c:pt idx="5">
                  <c:v>9.3849600000000005E-2</c:v>
                </c:pt>
                <c:pt idx="6">
                  <c:v>8.0482999999999999E-2</c:v>
                </c:pt>
                <c:pt idx="7">
                  <c:v>9.6264199999999994E-2</c:v>
                </c:pt>
                <c:pt idx="8">
                  <c:v>0.1117852</c:v>
                </c:pt>
                <c:pt idx="9">
                  <c:v>0.138055399999999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022448"/>
        <c:axId val="205024688"/>
      </c:scatterChart>
      <c:scatterChart>
        <c:scatterStyle val="smoothMarker"/>
        <c:varyColors val="0"/>
        <c:ser>
          <c:idx val="2"/>
          <c:order val="2"/>
          <c:tx>
            <c:strRef>
              <c:f>'Fig S3'!$J$21</c:f>
              <c:strCache>
                <c:ptCount val="1"/>
                <c:pt idx="0">
                  <c:v>High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  <a:prstDash val="dashDot"/>
            </a:ln>
          </c:spPr>
          <c:marker>
            <c:symbol val="none"/>
          </c:marker>
          <c:xVal>
            <c:numRef>
              <c:f>'Fig S3'!$AH$11:$AQ$11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3'!$AH$12:$AQ$12</c:f>
              <c:numCache>
                <c:formatCode>General</c:formatCode>
                <c:ptCount val="10"/>
                <c:pt idx="0">
                  <c:v>0.53008399999999989</c:v>
                </c:pt>
                <c:pt idx="1">
                  <c:v>0.53008399999999989</c:v>
                </c:pt>
                <c:pt idx="2">
                  <c:v>0.53008399999999989</c:v>
                </c:pt>
                <c:pt idx="3">
                  <c:v>0.53008399999999989</c:v>
                </c:pt>
                <c:pt idx="4">
                  <c:v>0.53008399999999989</c:v>
                </c:pt>
                <c:pt idx="5">
                  <c:v>0.53008399999999989</c:v>
                </c:pt>
                <c:pt idx="6">
                  <c:v>0.53008399999999989</c:v>
                </c:pt>
                <c:pt idx="7">
                  <c:v>0.53008399999999989</c:v>
                </c:pt>
                <c:pt idx="8">
                  <c:v>0.53008399999999989</c:v>
                </c:pt>
                <c:pt idx="9">
                  <c:v>0.53008399999999989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'Fig S3'!$J$22</c:f>
              <c:strCache>
                <c:ptCount val="1"/>
                <c:pt idx="0">
                  <c:v>Low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  <a:prstDash val="dash"/>
            </a:ln>
          </c:spPr>
          <c:marker>
            <c:symbol val="none"/>
          </c:marker>
          <c:xVal>
            <c:numRef>
              <c:f>'Fig S3'!$AH$11:$AQ$11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3'!$AH$13:$AQ$13</c:f>
              <c:numCache>
                <c:formatCode>General</c:formatCode>
                <c:ptCount val="10"/>
                <c:pt idx="0">
                  <c:v>0.33827600000000002</c:v>
                </c:pt>
                <c:pt idx="1">
                  <c:v>0.33827600000000002</c:v>
                </c:pt>
                <c:pt idx="2">
                  <c:v>0.33827600000000002</c:v>
                </c:pt>
                <c:pt idx="3">
                  <c:v>0.33827600000000002</c:v>
                </c:pt>
                <c:pt idx="4">
                  <c:v>0.33827600000000002</c:v>
                </c:pt>
                <c:pt idx="5">
                  <c:v>0.33827600000000002</c:v>
                </c:pt>
                <c:pt idx="6">
                  <c:v>0.33827600000000002</c:v>
                </c:pt>
                <c:pt idx="7">
                  <c:v>0.33827600000000002</c:v>
                </c:pt>
                <c:pt idx="8">
                  <c:v>0.33827600000000002</c:v>
                </c:pt>
                <c:pt idx="9">
                  <c:v>0.3382760000000000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022448"/>
        <c:axId val="205024688"/>
      </c:scatterChart>
      <c:valAx>
        <c:axId val="20502244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05024688"/>
        <c:crosses val="autoZero"/>
        <c:crossBetween val="midCat"/>
        <c:majorUnit val="2"/>
        <c:minorUnit val="1"/>
      </c:valAx>
      <c:valAx>
        <c:axId val="205024688"/>
        <c:scaling>
          <c:orientation val="minMax"/>
          <c:max val="0.6000000000000002"/>
          <c:min val="0"/>
        </c:scaling>
        <c:delete val="0"/>
        <c:axPos val="l"/>
        <c:numFmt formatCode="0.00E+00" sourceLinked="0"/>
        <c:majorTickMark val="out"/>
        <c:minorTickMark val="none"/>
        <c:tickLblPos val="none"/>
        <c:crossAx val="205022448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N$461</c:f>
              <c:strCache>
                <c:ptCount val="1"/>
                <c:pt idx="0">
                  <c:v>high Rs</c:v>
                </c:pt>
              </c:strCache>
            </c:strRef>
          </c:tx>
          <c:spPr>
            <a:ln w="12700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461:$BG$461</c:f>
                <c:numCache>
                  <c:formatCode>General</c:formatCode>
                  <c:ptCount val="9"/>
                  <c:pt idx="0">
                    <c:v>4.1392641863279317E-2</c:v>
                  </c:pt>
                  <c:pt idx="1">
                    <c:v>3.7962524256846292E-2</c:v>
                  </c:pt>
                  <c:pt idx="2">
                    <c:v>4.6394315393615895E-2</c:v>
                  </c:pt>
                  <c:pt idx="3">
                    <c:v>6.5772371396173535E-2</c:v>
                  </c:pt>
                  <c:pt idx="4">
                    <c:v>6.0432979309025525E-2</c:v>
                  </c:pt>
                  <c:pt idx="5">
                    <c:v>7.6195359134964918E-2</c:v>
                  </c:pt>
                  <c:pt idx="6">
                    <c:v>6.9632768873277698E-2</c:v>
                  </c:pt>
                  <c:pt idx="7">
                    <c:v>3.6879036943143394E-2</c:v>
                  </c:pt>
                  <c:pt idx="8">
                    <c:v>2.2060426969936587E-2</c:v>
                  </c:pt>
                </c:numCache>
              </c:numRef>
            </c:plus>
            <c:minus>
              <c:numRef>
                <c:f>'Fig S3'!$AY$461:$BG$461</c:f>
                <c:numCache>
                  <c:formatCode>General</c:formatCode>
                  <c:ptCount val="9"/>
                  <c:pt idx="0">
                    <c:v>4.1392641863279317E-2</c:v>
                  </c:pt>
                  <c:pt idx="1">
                    <c:v>3.7962524256846292E-2</c:v>
                  </c:pt>
                  <c:pt idx="2">
                    <c:v>4.6394315393615895E-2</c:v>
                  </c:pt>
                  <c:pt idx="3">
                    <c:v>6.5772371396173535E-2</c:v>
                  </c:pt>
                  <c:pt idx="4">
                    <c:v>6.0432979309025525E-2</c:v>
                  </c:pt>
                  <c:pt idx="5">
                    <c:v>7.6195359134964918E-2</c:v>
                  </c:pt>
                  <c:pt idx="6">
                    <c:v>6.9632768873277698E-2</c:v>
                  </c:pt>
                  <c:pt idx="7">
                    <c:v>3.6879036943143394E-2</c:v>
                  </c:pt>
                  <c:pt idx="8">
                    <c:v>2.2060426969936587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P$456:$AX$45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461:$AX$461</c:f>
              <c:numCache>
                <c:formatCode>0.000</c:formatCode>
                <c:ptCount val="9"/>
                <c:pt idx="0">
                  <c:v>0.36663324650686507</c:v>
                </c:pt>
                <c:pt idx="1">
                  <c:v>0.34834835503750639</c:v>
                </c:pt>
                <c:pt idx="2">
                  <c:v>0.36399431699576218</c:v>
                </c:pt>
                <c:pt idx="3">
                  <c:v>0.31914660735788231</c:v>
                </c:pt>
                <c:pt idx="4">
                  <c:v>0.28082291235071871</c:v>
                </c:pt>
                <c:pt idx="5">
                  <c:v>0.33718416834380971</c:v>
                </c:pt>
                <c:pt idx="6">
                  <c:v>0.32604087130123977</c:v>
                </c:pt>
                <c:pt idx="7">
                  <c:v>0.29134823145014982</c:v>
                </c:pt>
                <c:pt idx="8">
                  <c:v>0.2871387705238518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N$462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462:$BG$462</c:f>
                <c:numCache>
                  <c:formatCode>General</c:formatCode>
                  <c:ptCount val="9"/>
                  <c:pt idx="0">
                    <c:v>7.2042079203737813E-2</c:v>
                  </c:pt>
                  <c:pt idx="1">
                    <c:v>2.9960153585068768E-2</c:v>
                  </c:pt>
                  <c:pt idx="2">
                    <c:v>2.6021389497040654E-2</c:v>
                  </c:pt>
                  <c:pt idx="3">
                    <c:v>8.7418127441689211E-2</c:v>
                  </c:pt>
                  <c:pt idx="4">
                    <c:v>8.8400772689489048E-3</c:v>
                  </c:pt>
                  <c:pt idx="5">
                    <c:v>5.746918782598804E-2</c:v>
                  </c:pt>
                  <c:pt idx="6">
                    <c:v>3.0338234740826087E-2</c:v>
                  </c:pt>
                  <c:pt idx="7">
                    <c:v>3.8746716974115664E-2</c:v>
                  </c:pt>
                  <c:pt idx="8">
                    <c:v>3.1175855659751766E-2</c:v>
                  </c:pt>
                </c:numCache>
              </c:numRef>
            </c:plus>
            <c:minus>
              <c:numRef>
                <c:f>'Fig S3'!$AY$462:$BG$462</c:f>
                <c:numCache>
                  <c:formatCode>General</c:formatCode>
                  <c:ptCount val="9"/>
                  <c:pt idx="0">
                    <c:v>7.2042079203737813E-2</c:v>
                  </c:pt>
                  <c:pt idx="1">
                    <c:v>2.9960153585068768E-2</c:v>
                  </c:pt>
                  <c:pt idx="2">
                    <c:v>2.6021389497040654E-2</c:v>
                  </c:pt>
                  <c:pt idx="3">
                    <c:v>8.7418127441689211E-2</c:v>
                  </c:pt>
                  <c:pt idx="4">
                    <c:v>8.8400772689489048E-3</c:v>
                  </c:pt>
                  <c:pt idx="5">
                    <c:v>5.746918782598804E-2</c:v>
                  </c:pt>
                  <c:pt idx="6">
                    <c:v>3.0338234740826087E-2</c:v>
                  </c:pt>
                  <c:pt idx="7">
                    <c:v>3.8746716974115664E-2</c:v>
                  </c:pt>
                  <c:pt idx="8">
                    <c:v>3.1175855659751766E-2</c:v>
                  </c:pt>
                </c:numCache>
              </c:numRef>
            </c:minus>
          </c:errBars>
          <c:xVal>
            <c:numRef>
              <c:f>'Fig S3'!$AP$456:$AX$45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462:$AX$462</c:f>
              <c:numCache>
                <c:formatCode>0.000</c:formatCode>
                <c:ptCount val="9"/>
                <c:pt idx="0">
                  <c:v>0.28612777946839768</c:v>
                </c:pt>
                <c:pt idx="1">
                  <c:v>0.32585891130135808</c:v>
                </c:pt>
                <c:pt idx="2">
                  <c:v>0.32592824314533103</c:v>
                </c:pt>
                <c:pt idx="3">
                  <c:v>0.34825527856797917</c:v>
                </c:pt>
                <c:pt idx="4">
                  <c:v>0.35838044686802312</c:v>
                </c:pt>
                <c:pt idx="5">
                  <c:v>0.38361327760110842</c:v>
                </c:pt>
                <c:pt idx="6">
                  <c:v>0.40466277711206827</c:v>
                </c:pt>
                <c:pt idx="7">
                  <c:v>0.36607230103975957</c:v>
                </c:pt>
                <c:pt idx="8">
                  <c:v>0.4566355168684705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426848"/>
        <c:axId val="211428528"/>
      </c:scatterChart>
      <c:valAx>
        <c:axId val="21142684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211428528"/>
        <c:crosses val="autoZero"/>
        <c:crossBetween val="midCat"/>
        <c:majorUnit val="2"/>
        <c:minorUnit val="1"/>
      </c:valAx>
      <c:valAx>
        <c:axId val="211428528"/>
        <c:scaling>
          <c:orientation val="minMax"/>
          <c:max val="0.60000000000000009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211426848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N$459</c:f>
              <c:strCache>
                <c:ptCount val="1"/>
                <c:pt idx="0">
                  <c:v>high Rs</c:v>
                </c:pt>
              </c:strCache>
            </c:strRef>
          </c:tx>
          <c:spPr>
            <a:ln w="12700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459:$BG$459</c:f>
                <c:numCache>
                  <c:formatCode>General</c:formatCode>
                  <c:ptCount val="9"/>
                  <c:pt idx="0">
                    <c:v>3.1859433228251327E-2</c:v>
                  </c:pt>
                  <c:pt idx="1">
                    <c:v>3.0275641822183348E-2</c:v>
                  </c:pt>
                  <c:pt idx="2">
                    <c:v>7.4537130992754885E-2</c:v>
                  </c:pt>
                  <c:pt idx="3">
                    <c:v>4.5881533641106052E-2</c:v>
                  </c:pt>
                  <c:pt idx="4">
                    <c:v>3.1090554769595581E-2</c:v>
                  </c:pt>
                  <c:pt idx="5">
                    <c:v>5.222314503895905E-2</c:v>
                  </c:pt>
                  <c:pt idx="6">
                    <c:v>2.6403230532970539E-2</c:v>
                  </c:pt>
                  <c:pt idx="7">
                    <c:v>4.0582524136473334E-2</c:v>
                  </c:pt>
                  <c:pt idx="8">
                    <c:v>2.8280095237385141E-2</c:v>
                  </c:pt>
                </c:numCache>
              </c:numRef>
            </c:plus>
            <c:minus>
              <c:numRef>
                <c:f>'Fig S3'!$AY$459:$BG$459</c:f>
                <c:numCache>
                  <c:formatCode>General</c:formatCode>
                  <c:ptCount val="9"/>
                  <c:pt idx="0">
                    <c:v>3.1859433228251327E-2</c:v>
                  </c:pt>
                  <c:pt idx="1">
                    <c:v>3.0275641822183348E-2</c:v>
                  </c:pt>
                  <c:pt idx="2">
                    <c:v>7.4537130992754885E-2</c:v>
                  </c:pt>
                  <c:pt idx="3">
                    <c:v>4.5881533641106052E-2</c:v>
                  </c:pt>
                  <c:pt idx="4">
                    <c:v>3.1090554769595581E-2</c:v>
                  </c:pt>
                  <c:pt idx="5">
                    <c:v>5.222314503895905E-2</c:v>
                  </c:pt>
                  <c:pt idx="6">
                    <c:v>2.6403230532970539E-2</c:v>
                  </c:pt>
                  <c:pt idx="7">
                    <c:v>4.0582524136473334E-2</c:v>
                  </c:pt>
                  <c:pt idx="8">
                    <c:v>2.8280095237385141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P$456:$AX$45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459:$AX$459</c:f>
              <c:numCache>
                <c:formatCode>0.000</c:formatCode>
                <c:ptCount val="9"/>
                <c:pt idx="0">
                  <c:v>0.37740916156505955</c:v>
                </c:pt>
                <c:pt idx="1">
                  <c:v>0.33646024535217806</c:v>
                </c:pt>
                <c:pt idx="2">
                  <c:v>0.31775131028930065</c:v>
                </c:pt>
                <c:pt idx="3">
                  <c:v>0.2386841661812516</c:v>
                </c:pt>
                <c:pt idx="4">
                  <c:v>0.31302053985473632</c:v>
                </c:pt>
                <c:pt idx="5">
                  <c:v>0.44808943785109517</c:v>
                </c:pt>
                <c:pt idx="6">
                  <c:v>0.33189450251900804</c:v>
                </c:pt>
                <c:pt idx="7">
                  <c:v>0.22566110112808357</c:v>
                </c:pt>
                <c:pt idx="8">
                  <c:v>0.2469171768025653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N$460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460:$BG$460</c:f>
                <c:numCache>
                  <c:formatCode>General</c:formatCode>
                  <c:ptCount val="9"/>
                  <c:pt idx="0">
                    <c:v>3.9264255474580907E-2</c:v>
                  </c:pt>
                  <c:pt idx="1">
                    <c:v>2.9259274548484291E-2</c:v>
                  </c:pt>
                  <c:pt idx="2">
                    <c:v>2.0440185796197989E-2</c:v>
                  </c:pt>
                  <c:pt idx="3">
                    <c:v>3.6537034248849277E-2</c:v>
                  </c:pt>
                  <c:pt idx="4">
                    <c:v>2.6240645786257531E-2</c:v>
                  </c:pt>
                  <c:pt idx="5">
                    <c:v>2.9326765105103531E-2</c:v>
                  </c:pt>
                  <c:pt idx="6">
                    <c:v>5.9396331512270605E-2</c:v>
                  </c:pt>
                  <c:pt idx="7">
                    <c:v>1.6430270610603041E-2</c:v>
                  </c:pt>
                  <c:pt idx="8">
                    <c:v>2.1119245993058488E-2</c:v>
                  </c:pt>
                </c:numCache>
              </c:numRef>
            </c:plus>
            <c:minus>
              <c:numRef>
                <c:f>'Fig S3'!$AY$460:$BG$460</c:f>
                <c:numCache>
                  <c:formatCode>General</c:formatCode>
                  <c:ptCount val="9"/>
                  <c:pt idx="0">
                    <c:v>3.9264255474580907E-2</c:v>
                  </c:pt>
                  <c:pt idx="1">
                    <c:v>2.9259274548484291E-2</c:v>
                  </c:pt>
                  <c:pt idx="2">
                    <c:v>2.0440185796197989E-2</c:v>
                  </c:pt>
                  <c:pt idx="3">
                    <c:v>3.6537034248849277E-2</c:v>
                  </c:pt>
                  <c:pt idx="4">
                    <c:v>2.6240645786257531E-2</c:v>
                  </c:pt>
                  <c:pt idx="5">
                    <c:v>2.9326765105103531E-2</c:v>
                  </c:pt>
                  <c:pt idx="6">
                    <c:v>5.9396331512270605E-2</c:v>
                  </c:pt>
                  <c:pt idx="7">
                    <c:v>1.6430270610603041E-2</c:v>
                  </c:pt>
                  <c:pt idx="8">
                    <c:v>2.1119245993058488E-2</c:v>
                  </c:pt>
                </c:numCache>
              </c:numRef>
            </c:minus>
          </c:errBars>
          <c:xVal>
            <c:numRef>
              <c:f>'Fig S3'!$AP$456:$AX$45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460:$AX$460</c:f>
              <c:numCache>
                <c:formatCode>0.000</c:formatCode>
                <c:ptCount val="9"/>
                <c:pt idx="0">
                  <c:v>0.35878558587051729</c:v>
                </c:pt>
                <c:pt idx="1">
                  <c:v>0.29345640415650531</c:v>
                </c:pt>
                <c:pt idx="2">
                  <c:v>0.32315007960351172</c:v>
                </c:pt>
                <c:pt idx="3">
                  <c:v>0.25773825280506274</c:v>
                </c:pt>
                <c:pt idx="4">
                  <c:v>0.27971650618999278</c:v>
                </c:pt>
                <c:pt idx="5">
                  <c:v>0.34755552229987374</c:v>
                </c:pt>
                <c:pt idx="6">
                  <c:v>0.27002957664423255</c:v>
                </c:pt>
                <c:pt idx="7">
                  <c:v>0.20508199538693833</c:v>
                </c:pt>
                <c:pt idx="8">
                  <c:v>0.2670956018624128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4065840"/>
        <c:axId val="274064720"/>
      </c:scatterChart>
      <c:valAx>
        <c:axId val="27406584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crossAx val="274064720"/>
        <c:crosses val="autoZero"/>
        <c:crossBetween val="midCat"/>
        <c:majorUnit val="2"/>
        <c:minorUnit val="1"/>
      </c:valAx>
      <c:valAx>
        <c:axId val="274064720"/>
        <c:scaling>
          <c:orientation val="minMax"/>
          <c:max val="0.60000000000000009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274065840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700"/>
      </a:pPr>
      <a:endParaRPr lang="en-US"/>
    </a:p>
  </c:txPr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N$457</c:f>
              <c:strCache>
                <c:ptCount val="1"/>
                <c:pt idx="0">
                  <c:v>high R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457:$BG$457</c:f>
                <c:numCache>
                  <c:formatCode>General</c:formatCode>
                  <c:ptCount val="9"/>
                  <c:pt idx="0">
                    <c:v>3.3131117239132112E-2</c:v>
                  </c:pt>
                  <c:pt idx="1">
                    <c:v>5.0895715955181262E-2</c:v>
                  </c:pt>
                  <c:pt idx="2">
                    <c:v>4.938807562988197E-2</c:v>
                  </c:pt>
                  <c:pt idx="3">
                    <c:v>6.5807713759750114E-2</c:v>
                  </c:pt>
                  <c:pt idx="4">
                    <c:v>4.2703430949888876E-2</c:v>
                  </c:pt>
                  <c:pt idx="5">
                    <c:v>4.2122540642415621E-2</c:v>
                  </c:pt>
                  <c:pt idx="6">
                    <c:v>6.8405225309583026E-2</c:v>
                  </c:pt>
                  <c:pt idx="7">
                    <c:v>5.7358988719596944E-2</c:v>
                  </c:pt>
                  <c:pt idx="8">
                    <c:v>4.8855705601735758E-2</c:v>
                  </c:pt>
                </c:numCache>
              </c:numRef>
            </c:plus>
            <c:minus>
              <c:numRef>
                <c:f>'Fig S3'!$AY$457:$BG$457</c:f>
                <c:numCache>
                  <c:formatCode>General</c:formatCode>
                  <c:ptCount val="9"/>
                  <c:pt idx="0">
                    <c:v>3.3131117239132112E-2</c:v>
                  </c:pt>
                  <c:pt idx="1">
                    <c:v>5.0895715955181262E-2</c:v>
                  </c:pt>
                  <c:pt idx="2">
                    <c:v>4.938807562988197E-2</c:v>
                  </c:pt>
                  <c:pt idx="3">
                    <c:v>6.5807713759750114E-2</c:v>
                  </c:pt>
                  <c:pt idx="4">
                    <c:v>4.2703430949888876E-2</c:v>
                  </c:pt>
                  <c:pt idx="5">
                    <c:v>4.2122540642415621E-2</c:v>
                  </c:pt>
                  <c:pt idx="6">
                    <c:v>6.8405225309583026E-2</c:v>
                  </c:pt>
                  <c:pt idx="7">
                    <c:v>5.7358988719596944E-2</c:v>
                  </c:pt>
                  <c:pt idx="8">
                    <c:v>4.8855705601735758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P$456:$AX$45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457:$AX$457</c:f>
              <c:numCache>
                <c:formatCode>0.000</c:formatCode>
                <c:ptCount val="9"/>
                <c:pt idx="0">
                  <c:v>0.34581387381972406</c:v>
                </c:pt>
                <c:pt idx="1">
                  <c:v>0.327132904635688</c:v>
                </c:pt>
                <c:pt idx="2">
                  <c:v>0.41044921703314274</c:v>
                </c:pt>
                <c:pt idx="3">
                  <c:v>0.38401305323141871</c:v>
                </c:pt>
                <c:pt idx="4">
                  <c:v>0.44060739615280564</c:v>
                </c:pt>
                <c:pt idx="5">
                  <c:v>0.34783080515579268</c:v>
                </c:pt>
                <c:pt idx="6">
                  <c:v>0.38699967978362437</c:v>
                </c:pt>
                <c:pt idx="7">
                  <c:v>0.41973452168389291</c:v>
                </c:pt>
                <c:pt idx="8">
                  <c:v>0.3762354700021129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N$458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Y$458:$BG$458</c:f>
                <c:numCache>
                  <c:formatCode>General</c:formatCode>
                  <c:ptCount val="9"/>
                  <c:pt idx="0">
                    <c:v>9.8881000202816084E-3</c:v>
                  </c:pt>
                  <c:pt idx="1">
                    <c:v>1.7344285872697013E-2</c:v>
                  </c:pt>
                  <c:pt idx="2">
                    <c:v>3.9064293124767439E-2</c:v>
                  </c:pt>
                  <c:pt idx="3">
                    <c:v>2.571881912191255E-2</c:v>
                  </c:pt>
                  <c:pt idx="4">
                    <c:v>3.7824020606875099E-2</c:v>
                  </c:pt>
                  <c:pt idx="5">
                    <c:v>5.35602808669388E-2</c:v>
                  </c:pt>
                  <c:pt idx="6">
                    <c:v>1.6144068962422597E-2</c:v>
                  </c:pt>
                  <c:pt idx="7">
                    <c:v>1.8528190522451693E-2</c:v>
                  </c:pt>
                  <c:pt idx="8">
                    <c:v>1.53993441760056E-2</c:v>
                  </c:pt>
                </c:numCache>
              </c:numRef>
            </c:plus>
            <c:minus>
              <c:numRef>
                <c:f>'Fig S3'!$AY$458:$BG$458</c:f>
                <c:numCache>
                  <c:formatCode>General</c:formatCode>
                  <c:ptCount val="9"/>
                  <c:pt idx="0">
                    <c:v>9.8881000202816084E-3</c:v>
                  </c:pt>
                  <c:pt idx="1">
                    <c:v>1.7344285872697013E-2</c:v>
                  </c:pt>
                  <c:pt idx="2">
                    <c:v>3.9064293124767439E-2</c:v>
                  </c:pt>
                  <c:pt idx="3">
                    <c:v>2.571881912191255E-2</c:v>
                  </c:pt>
                  <c:pt idx="4">
                    <c:v>3.7824020606875099E-2</c:v>
                  </c:pt>
                  <c:pt idx="5">
                    <c:v>5.35602808669388E-2</c:v>
                  </c:pt>
                  <c:pt idx="6">
                    <c:v>1.6144068962422597E-2</c:v>
                  </c:pt>
                  <c:pt idx="7">
                    <c:v>1.8528190522451693E-2</c:v>
                  </c:pt>
                  <c:pt idx="8">
                    <c:v>1.53993441760056E-2</c:v>
                  </c:pt>
                </c:numCache>
              </c:numRef>
            </c:minus>
          </c:errBars>
          <c:xVal>
            <c:numRef>
              <c:f>'Fig S3'!$AP$456:$AX$456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P$458:$AX$458</c:f>
              <c:numCache>
                <c:formatCode>0.000</c:formatCode>
                <c:ptCount val="9"/>
                <c:pt idx="0">
                  <c:v>0.37129114552673198</c:v>
                </c:pt>
                <c:pt idx="1">
                  <c:v>0.29327168008857285</c:v>
                </c:pt>
                <c:pt idx="2">
                  <c:v>0.32884326731911423</c:v>
                </c:pt>
                <c:pt idx="3">
                  <c:v>0.25093563831227994</c:v>
                </c:pt>
                <c:pt idx="4">
                  <c:v>0.36707524980839429</c:v>
                </c:pt>
                <c:pt idx="5">
                  <c:v>0.34082776524479108</c:v>
                </c:pt>
                <c:pt idx="6">
                  <c:v>0.38818866487277387</c:v>
                </c:pt>
                <c:pt idx="7">
                  <c:v>0.37520664267518022</c:v>
                </c:pt>
                <c:pt idx="8">
                  <c:v>0.3262776695671212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8774592"/>
        <c:axId val="269996272"/>
      </c:scatterChart>
      <c:valAx>
        <c:axId val="218774592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269996272"/>
        <c:crosses val="autoZero"/>
        <c:crossBetween val="midCat"/>
        <c:majorUnit val="2"/>
        <c:minorUnit val="1"/>
      </c:valAx>
      <c:valAx>
        <c:axId val="269996272"/>
        <c:scaling>
          <c:orientation val="minMax"/>
          <c:max val="0.60000000000000009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218774592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6388888888888895E-2"/>
          <c:y val="0.13401559454191034"/>
          <c:w val="0.85416666666666663"/>
          <c:h val="0.73196881091617938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 S3'!$AQ$37</c:f>
              <c:strCache>
                <c:ptCount val="1"/>
                <c:pt idx="0">
                  <c:v>high Rs</c:v>
                </c:pt>
              </c:strCache>
            </c:strRef>
          </c:tx>
          <c:spPr>
            <a:ln w="12700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BC$37:$BL$37</c:f>
                <c:numCache>
                  <c:formatCode>General</c:formatCode>
                  <c:ptCount val="10"/>
                  <c:pt idx="0">
                    <c:v>1.2923026237689032E-2</c:v>
                  </c:pt>
                  <c:pt idx="1">
                    <c:v>1.0390600993205355E-2</c:v>
                  </c:pt>
                  <c:pt idx="2">
                    <c:v>1.1857071339078649E-2</c:v>
                  </c:pt>
                  <c:pt idx="3">
                    <c:v>9.0978037767364857E-3</c:v>
                  </c:pt>
                  <c:pt idx="4">
                    <c:v>1.4255116802046918E-2</c:v>
                  </c:pt>
                  <c:pt idx="5">
                    <c:v>2.6849203959521784E-2</c:v>
                  </c:pt>
                  <c:pt idx="6">
                    <c:v>4.628716873108573E-2</c:v>
                  </c:pt>
                  <c:pt idx="7">
                    <c:v>4.444011152956303E-2</c:v>
                  </c:pt>
                  <c:pt idx="8">
                    <c:v>5.2100033291352127E-2</c:v>
                  </c:pt>
                  <c:pt idx="9">
                    <c:v>4.1126541989328483E-2</c:v>
                  </c:pt>
                </c:numCache>
              </c:numRef>
            </c:plus>
            <c:minus>
              <c:numRef>
                <c:f>'Fig S3'!$BC$37:$BL$37</c:f>
                <c:numCache>
                  <c:formatCode>General</c:formatCode>
                  <c:ptCount val="10"/>
                  <c:pt idx="0">
                    <c:v>1.2923026237689032E-2</c:v>
                  </c:pt>
                  <c:pt idx="1">
                    <c:v>1.0390600993205355E-2</c:v>
                  </c:pt>
                  <c:pt idx="2">
                    <c:v>1.1857071339078649E-2</c:v>
                  </c:pt>
                  <c:pt idx="3">
                    <c:v>9.0978037767364857E-3</c:v>
                  </c:pt>
                  <c:pt idx="4">
                    <c:v>1.4255116802046918E-2</c:v>
                  </c:pt>
                  <c:pt idx="5">
                    <c:v>2.6849203959521784E-2</c:v>
                  </c:pt>
                  <c:pt idx="6">
                    <c:v>4.628716873108573E-2</c:v>
                  </c:pt>
                  <c:pt idx="7">
                    <c:v>4.444011152956303E-2</c:v>
                  </c:pt>
                  <c:pt idx="8">
                    <c:v>5.2100033291352127E-2</c:v>
                  </c:pt>
                  <c:pt idx="9">
                    <c:v>4.1126541989328483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S$30:$BB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3'!$AS$37:$BB$37</c:f>
              <c:numCache>
                <c:formatCode>0.00E+00</c:formatCode>
                <c:ptCount val="10"/>
                <c:pt idx="0">
                  <c:v>0.11448880000000002</c:v>
                </c:pt>
                <c:pt idx="1">
                  <c:v>7.5121000000000007E-2</c:v>
                </c:pt>
                <c:pt idx="2">
                  <c:v>8.3968799999999996E-2</c:v>
                </c:pt>
                <c:pt idx="3">
                  <c:v>8.4801599999999991E-2</c:v>
                </c:pt>
                <c:pt idx="4">
                  <c:v>7.7795799999999998E-2</c:v>
                </c:pt>
                <c:pt idx="5">
                  <c:v>9.6005599999999996E-2</c:v>
                </c:pt>
                <c:pt idx="6">
                  <c:v>0.13109679999999999</c:v>
                </c:pt>
                <c:pt idx="7">
                  <c:v>0.13781260000000001</c:v>
                </c:pt>
                <c:pt idx="8">
                  <c:v>0.1614836</c:v>
                </c:pt>
                <c:pt idx="9">
                  <c:v>0.1814360000000000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Q$38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BC$38:$BL$38</c:f>
                <c:numCache>
                  <c:formatCode>General</c:formatCode>
                  <c:ptCount val="10"/>
                  <c:pt idx="0">
                    <c:v>3.8165226416726504E-2</c:v>
                  </c:pt>
                  <c:pt idx="1">
                    <c:v>3.7902349214263768E-2</c:v>
                  </c:pt>
                  <c:pt idx="2">
                    <c:v>3.2759688214938805E-2</c:v>
                  </c:pt>
                  <c:pt idx="3">
                    <c:v>3.6135424132836741E-2</c:v>
                  </c:pt>
                  <c:pt idx="4">
                    <c:v>3.19982035823888E-2</c:v>
                  </c:pt>
                  <c:pt idx="5">
                    <c:v>4.0511393598097793E-2</c:v>
                  </c:pt>
                  <c:pt idx="6">
                    <c:v>4.465872313960622E-2</c:v>
                  </c:pt>
                  <c:pt idx="7">
                    <c:v>5.1968931890697942E-2</c:v>
                  </c:pt>
                  <c:pt idx="8">
                    <c:v>6.4777394092846913E-2</c:v>
                  </c:pt>
                  <c:pt idx="9">
                    <c:v>7.1912760000294812E-2</c:v>
                  </c:pt>
                </c:numCache>
              </c:numRef>
            </c:plus>
            <c:minus>
              <c:numRef>
                <c:f>'Fig S3'!$BC$38:$BL$38</c:f>
                <c:numCache>
                  <c:formatCode>General</c:formatCode>
                  <c:ptCount val="10"/>
                  <c:pt idx="0">
                    <c:v>3.8165226416726504E-2</c:v>
                  </c:pt>
                  <c:pt idx="1">
                    <c:v>3.7902349214263768E-2</c:v>
                  </c:pt>
                  <c:pt idx="2">
                    <c:v>3.2759688214938805E-2</c:v>
                  </c:pt>
                  <c:pt idx="3">
                    <c:v>3.6135424132836741E-2</c:v>
                  </c:pt>
                  <c:pt idx="4">
                    <c:v>3.19982035823888E-2</c:v>
                  </c:pt>
                  <c:pt idx="5">
                    <c:v>4.0511393598097793E-2</c:v>
                  </c:pt>
                  <c:pt idx="6">
                    <c:v>4.465872313960622E-2</c:v>
                  </c:pt>
                  <c:pt idx="7">
                    <c:v>5.1968931890697942E-2</c:v>
                  </c:pt>
                  <c:pt idx="8">
                    <c:v>6.4777394092846913E-2</c:v>
                  </c:pt>
                  <c:pt idx="9">
                    <c:v>7.1912760000294812E-2</c:v>
                  </c:pt>
                </c:numCache>
              </c:numRef>
            </c:minus>
          </c:errBars>
          <c:xVal>
            <c:numRef>
              <c:f>'Fig S3'!$AS$30:$BB$30</c:f>
              <c:numCache>
                <c:formatCode>General</c:formatCode>
                <c:ptCount val="10"/>
                <c:pt idx="0">
                  <c:v>-9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1</c:v>
                </c:pt>
              </c:numCache>
            </c:numRef>
          </c:xVal>
          <c:yVal>
            <c:numRef>
              <c:f>'Fig S3'!$AS$38:$BB$38</c:f>
              <c:numCache>
                <c:formatCode>0.00E+00</c:formatCode>
                <c:ptCount val="10"/>
                <c:pt idx="0">
                  <c:v>0.12617780000000001</c:v>
                </c:pt>
                <c:pt idx="1">
                  <c:v>0.10412139999999999</c:v>
                </c:pt>
                <c:pt idx="2">
                  <c:v>8.8593199999999983E-2</c:v>
                </c:pt>
                <c:pt idx="3">
                  <c:v>9.8772399999999996E-2</c:v>
                </c:pt>
                <c:pt idx="4">
                  <c:v>9.0810000000000002E-2</c:v>
                </c:pt>
                <c:pt idx="5">
                  <c:v>0.11546140000000001</c:v>
                </c:pt>
                <c:pt idx="6">
                  <c:v>0.12125939999999999</c:v>
                </c:pt>
                <c:pt idx="7">
                  <c:v>0.13453839999999997</c:v>
                </c:pt>
                <c:pt idx="8">
                  <c:v>0.16482940000000001</c:v>
                </c:pt>
                <c:pt idx="9">
                  <c:v>0.1967055999999999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035328"/>
        <c:axId val="205033648"/>
      </c:scatterChart>
      <c:scatterChart>
        <c:scatterStyle val="smoothMarker"/>
        <c:varyColors val="0"/>
        <c:ser>
          <c:idx val="2"/>
          <c:order val="2"/>
          <c:tx>
            <c:strRef>
              <c:f>'Fig S3'!$J$21</c:f>
              <c:strCache>
                <c:ptCount val="1"/>
                <c:pt idx="0">
                  <c:v>High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  <a:prstDash val="dashDot"/>
            </a:ln>
          </c:spPr>
          <c:marker>
            <c:symbol val="none"/>
          </c:marker>
          <c:xVal>
            <c:numRef>
              <c:f>'Fig S3'!$AR$11:$BA$11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3'!$AR$12:$BA$12</c:f>
              <c:numCache>
                <c:formatCode>General</c:formatCode>
                <c:ptCount val="10"/>
                <c:pt idx="0">
                  <c:v>0.46789400000000009</c:v>
                </c:pt>
                <c:pt idx="1">
                  <c:v>0.46789400000000009</c:v>
                </c:pt>
                <c:pt idx="2">
                  <c:v>0.46789400000000009</c:v>
                </c:pt>
                <c:pt idx="3">
                  <c:v>0.46789400000000009</c:v>
                </c:pt>
                <c:pt idx="4">
                  <c:v>0.46789400000000009</c:v>
                </c:pt>
                <c:pt idx="5">
                  <c:v>0.46789400000000009</c:v>
                </c:pt>
                <c:pt idx="6">
                  <c:v>0.46789400000000009</c:v>
                </c:pt>
                <c:pt idx="7">
                  <c:v>0.46789400000000009</c:v>
                </c:pt>
                <c:pt idx="8">
                  <c:v>0.46789400000000009</c:v>
                </c:pt>
                <c:pt idx="9">
                  <c:v>0.46789400000000009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'Fig S3'!$J$22</c:f>
              <c:strCache>
                <c:ptCount val="1"/>
                <c:pt idx="0">
                  <c:v>Low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  <a:prstDash val="dash"/>
            </a:ln>
          </c:spPr>
          <c:marker>
            <c:symbol val="none"/>
          </c:marker>
          <c:xVal>
            <c:numRef>
              <c:f>'Fig S3'!$AR$11:$BA$11</c:f>
              <c:numCache>
                <c:formatCode>General</c:formatCode>
                <c:ptCount val="10"/>
                <c:pt idx="0">
                  <c:v>-11</c:v>
                </c:pt>
                <c:pt idx="1">
                  <c:v>-4</c:v>
                </c:pt>
                <c:pt idx="2">
                  <c:v>-2</c:v>
                </c:pt>
                <c:pt idx="3">
                  <c:v>-1</c:v>
                </c:pt>
                <c:pt idx="4">
                  <c:v>0</c:v>
                </c:pt>
                <c:pt idx="5">
                  <c:v>2</c:v>
                </c:pt>
                <c:pt idx="6">
                  <c:v>4</c:v>
                </c:pt>
                <c:pt idx="7">
                  <c:v>6</c:v>
                </c:pt>
                <c:pt idx="8">
                  <c:v>8</c:v>
                </c:pt>
                <c:pt idx="9">
                  <c:v>12</c:v>
                </c:pt>
              </c:numCache>
            </c:numRef>
          </c:xVal>
          <c:yVal>
            <c:numRef>
              <c:f>'Fig S3'!$AR$13:$BA$13</c:f>
              <c:numCache>
                <c:formatCode>General</c:formatCode>
                <c:ptCount val="10"/>
                <c:pt idx="0">
                  <c:v>0.38059199999999993</c:v>
                </c:pt>
                <c:pt idx="1">
                  <c:v>0.38059199999999993</c:v>
                </c:pt>
                <c:pt idx="2">
                  <c:v>0.38059199999999993</c:v>
                </c:pt>
                <c:pt idx="3">
                  <c:v>0.38059199999999993</c:v>
                </c:pt>
                <c:pt idx="4">
                  <c:v>0.38059199999999993</c:v>
                </c:pt>
                <c:pt idx="5">
                  <c:v>0.38059199999999993</c:v>
                </c:pt>
                <c:pt idx="6">
                  <c:v>0.38059199999999993</c:v>
                </c:pt>
                <c:pt idx="7">
                  <c:v>0.38059199999999993</c:v>
                </c:pt>
                <c:pt idx="8">
                  <c:v>0.38059199999999993</c:v>
                </c:pt>
                <c:pt idx="9">
                  <c:v>0.3805919999999999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035328"/>
        <c:axId val="205033648"/>
      </c:scatterChart>
      <c:valAx>
        <c:axId val="205035328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205033648"/>
        <c:crosses val="autoZero"/>
        <c:crossBetween val="midCat"/>
        <c:majorUnit val="2"/>
        <c:minorUnit val="1"/>
      </c:valAx>
      <c:valAx>
        <c:axId val="205033648"/>
        <c:scaling>
          <c:orientation val="minMax"/>
          <c:max val="0.6000000000000002"/>
          <c:min val="0"/>
        </c:scaling>
        <c:delete val="0"/>
        <c:axPos val="l"/>
        <c:numFmt formatCode="0.00E+00" sourceLinked="0"/>
        <c:majorTickMark val="out"/>
        <c:minorTickMark val="none"/>
        <c:tickLblPos val="none"/>
        <c:crossAx val="205035328"/>
        <c:crossesAt val="-11"/>
        <c:crossBetween val="midCat"/>
        <c:majorUnit val="0.1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P$238</c:f>
              <c:strCache>
                <c:ptCount val="1"/>
                <c:pt idx="0">
                  <c:v>high R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BA$238:$BI$238</c:f>
                <c:numCache>
                  <c:formatCode>General</c:formatCode>
                  <c:ptCount val="9"/>
                  <c:pt idx="0">
                    <c:v>5.9252424975117901E-2</c:v>
                  </c:pt>
                  <c:pt idx="1">
                    <c:v>5.9123665568033348E-2</c:v>
                  </c:pt>
                  <c:pt idx="2">
                    <c:v>5.8221017954509888E-2</c:v>
                  </c:pt>
                  <c:pt idx="3">
                    <c:v>5.649734013953539E-2</c:v>
                  </c:pt>
                  <c:pt idx="4">
                    <c:v>5.982381223424442E-2</c:v>
                  </c:pt>
                  <c:pt idx="5">
                    <c:v>5.936150716930326E-2</c:v>
                  </c:pt>
                  <c:pt idx="6">
                    <c:v>6.0750967448182383E-2</c:v>
                  </c:pt>
                  <c:pt idx="7">
                    <c:v>6.283664338976469E-2</c:v>
                  </c:pt>
                  <c:pt idx="8">
                    <c:v>6.9643362328169436E-2</c:v>
                  </c:pt>
                </c:numCache>
              </c:numRef>
            </c:plus>
            <c:minus>
              <c:numRef>
                <c:f>'Fig S3'!$BA$238:$BI$238</c:f>
                <c:numCache>
                  <c:formatCode>General</c:formatCode>
                  <c:ptCount val="9"/>
                  <c:pt idx="0">
                    <c:v>5.9252424975117901E-2</c:v>
                  </c:pt>
                  <c:pt idx="1">
                    <c:v>5.9123665568033348E-2</c:v>
                  </c:pt>
                  <c:pt idx="2">
                    <c:v>5.8221017954509888E-2</c:v>
                  </c:pt>
                  <c:pt idx="3">
                    <c:v>5.649734013953539E-2</c:v>
                  </c:pt>
                  <c:pt idx="4">
                    <c:v>5.982381223424442E-2</c:v>
                  </c:pt>
                  <c:pt idx="5">
                    <c:v>5.936150716930326E-2</c:v>
                  </c:pt>
                  <c:pt idx="6">
                    <c:v>6.0750967448182383E-2</c:v>
                  </c:pt>
                  <c:pt idx="7">
                    <c:v>6.283664338976469E-2</c:v>
                  </c:pt>
                  <c:pt idx="8">
                    <c:v>6.9643362328169436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R$237:$AZ$237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R$238:$AZ$238</c:f>
              <c:numCache>
                <c:formatCode>0.000</c:formatCode>
                <c:ptCount val="9"/>
                <c:pt idx="0">
                  <c:v>0.56136708068740282</c:v>
                </c:pt>
                <c:pt idx="1">
                  <c:v>0.55341338818866315</c:v>
                </c:pt>
                <c:pt idx="2">
                  <c:v>0.54854268890126556</c:v>
                </c:pt>
                <c:pt idx="3">
                  <c:v>0.58390415572378362</c:v>
                </c:pt>
                <c:pt idx="4">
                  <c:v>0.55789599580394134</c:v>
                </c:pt>
                <c:pt idx="5">
                  <c:v>0.5428629490724497</c:v>
                </c:pt>
                <c:pt idx="6">
                  <c:v>0.54925327113103661</c:v>
                </c:pt>
                <c:pt idx="7">
                  <c:v>0.53846693295769299</c:v>
                </c:pt>
                <c:pt idx="8">
                  <c:v>0.5296766723613595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P$239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solidFill>
                  <a:sysClr val="windowText" lastClr="000000"/>
                </a:solidFill>
              </a:ln>
            </c:spPr>
          </c:marker>
          <c:dPt>
            <c:idx val="2"/>
            <c:marker>
              <c:spPr>
                <a:solidFill>
                  <a:sysClr val="windowText" lastClr="000000"/>
                </a:solidFill>
                <a:ln w="15875">
                  <a:noFill/>
                </a:ln>
              </c:spPr>
            </c:marker>
            <c:bubble3D val="0"/>
          </c:dPt>
          <c:errBars>
            <c:errDir val="y"/>
            <c:errBarType val="both"/>
            <c:errValType val="cust"/>
            <c:noEndCap val="0"/>
            <c:plus>
              <c:numRef>
                <c:f>'Fig S3'!$BA$239:$BI$239</c:f>
                <c:numCache>
                  <c:formatCode>General</c:formatCode>
                  <c:ptCount val="9"/>
                  <c:pt idx="0">
                    <c:v>3.1686240312539957E-2</c:v>
                  </c:pt>
                  <c:pt idx="1">
                    <c:v>3.7620354412544507E-2</c:v>
                  </c:pt>
                  <c:pt idx="2">
                    <c:v>3.6904290581197617E-2</c:v>
                  </c:pt>
                  <c:pt idx="3">
                    <c:v>4.0187432719772403E-2</c:v>
                  </c:pt>
                  <c:pt idx="4">
                    <c:v>3.6553677793755644E-2</c:v>
                  </c:pt>
                  <c:pt idx="5">
                    <c:v>3.839505159572814E-2</c:v>
                  </c:pt>
                  <c:pt idx="6">
                    <c:v>3.2202966894491321E-2</c:v>
                  </c:pt>
                  <c:pt idx="7">
                    <c:v>3.1278719516712732E-2</c:v>
                  </c:pt>
                  <c:pt idx="8">
                    <c:v>3.7022806769715262E-2</c:v>
                  </c:pt>
                </c:numCache>
              </c:numRef>
            </c:plus>
            <c:minus>
              <c:numRef>
                <c:f>'Fig S3'!$BA$239:$BI$239</c:f>
                <c:numCache>
                  <c:formatCode>General</c:formatCode>
                  <c:ptCount val="9"/>
                  <c:pt idx="0">
                    <c:v>3.1686240312539957E-2</c:v>
                  </c:pt>
                  <c:pt idx="1">
                    <c:v>3.7620354412544507E-2</c:v>
                  </c:pt>
                  <c:pt idx="2">
                    <c:v>3.6904290581197617E-2</c:v>
                  </c:pt>
                  <c:pt idx="3">
                    <c:v>4.0187432719772403E-2</c:v>
                  </c:pt>
                  <c:pt idx="4">
                    <c:v>3.6553677793755644E-2</c:v>
                  </c:pt>
                  <c:pt idx="5">
                    <c:v>3.839505159572814E-2</c:v>
                  </c:pt>
                  <c:pt idx="6">
                    <c:v>3.2202966894491321E-2</c:v>
                  </c:pt>
                  <c:pt idx="7">
                    <c:v>3.1278719516712732E-2</c:v>
                  </c:pt>
                  <c:pt idx="8">
                    <c:v>3.7022806769715262E-2</c:v>
                  </c:pt>
                </c:numCache>
              </c:numRef>
            </c:minus>
          </c:errBars>
          <c:xVal>
            <c:numRef>
              <c:f>'Fig S3'!$AR$237:$AZ$237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R$239:$AZ$239</c:f>
              <c:numCache>
                <c:formatCode>0.000</c:formatCode>
                <c:ptCount val="9"/>
                <c:pt idx="0">
                  <c:v>0.58902823716513775</c:v>
                </c:pt>
                <c:pt idx="1">
                  <c:v>0.5900484916778127</c:v>
                </c:pt>
                <c:pt idx="2">
                  <c:v>0.57817193885895291</c:v>
                </c:pt>
                <c:pt idx="3">
                  <c:v>0.59810927907353428</c:v>
                </c:pt>
                <c:pt idx="4">
                  <c:v>0.58166907959954073</c:v>
                </c:pt>
                <c:pt idx="5">
                  <c:v>0.57665897852295378</c:v>
                </c:pt>
                <c:pt idx="6">
                  <c:v>0.56519581343601522</c:v>
                </c:pt>
                <c:pt idx="7">
                  <c:v>0.56330845932938467</c:v>
                </c:pt>
                <c:pt idx="8">
                  <c:v>0.550620304942827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3848960"/>
        <c:axId val="373878080"/>
      </c:scatterChart>
      <c:valAx>
        <c:axId val="37384896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73878080"/>
        <c:crosses val="autoZero"/>
        <c:crossBetween val="midCat"/>
        <c:majorUnit val="2"/>
        <c:minorUnit val="1"/>
      </c:valAx>
      <c:valAx>
        <c:axId val="373878080"/>
        <c:scaling>
          <c:orientation val="minMax"/>
          <c:max val="0.8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 baseline="0"/>
            </a:pPr>
            <a:endParaRPr lang="en-US"/>
          </a:p>
        </c:txPr>
        <c:crossAx val="373848960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P$240</c:f>
              <c:strCache>
                <c:ptCount val="1"/>
                <c:pt idx="0">
                  <c:v>high R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BA$240:$BI$240</c:f>
                <c:numCache>
                  <c:formatCode>General</c:formatCode>
                  <c:ptCount val="9"/>
                  <c:pt idx="0">
                    <c:v>6.4959884475310217E-2</c:v>
                  </c:pt>
                  <c:pt idx="1">
                    <c:v>5.8298642636878076E-2</c:v>
                  </c:pt>
                  <c:pt idx="2">
                    <c:v>6.4236916746393549E-2</c:v>
                  </c:pt>
                  <c:pt idx="3">
                    <c:v>5.4617473142582022E-2</c:v>
                  </c:pt>
                  <c:pt idx="4">
                    <c:v>4.1509932297080832E-2</c:v>
                  </c:pt>
                  <c:pt idx="5">
                    <c:v>3.7274890347460565E-2</c:v>
                  </c:pt>
                  <c:pt idx="6">
                    <c:v>4.6640803820456413E-2</c:v>
                  </c:pt>
                  <c:pt idx="7">
                    <c:v>6.9437163417222655E-2</c:v>
                  </c:pt>
                  <c:pt idx="8">
                    <c:v>6.2761110704455905E-2</c:v>
                  </c:pt>
                </c:numCache>
              </c:numRef>
            </c:plus>
            <c:minus>
              <c:numRef>
                <c:f>'Fig S3'!$BA$240:$BI$240</c:f>
                <c:numCache>
                  <c:formatCode>General</c:formatCode>
                  <c:ptCount val="9"/>
                  <c:pt idx="0">
                    <c:v>6.4959884475310217E-2</c:v>
                  </c:pt>
                  <c:pt idx="1">
                    <c:v>5.8298642636878076E-2</c:v>
                  </c:pt>
                  <c:pt idx="2">
                    <c:v>6.4236916746393549E-2</c:v>
                  </c:pt>
                  <c:pt idx="3">
                    <c:v>5.4617473142582022E-2</c:v>
                  </c:pt>
                  <c:pt idx="4">
                    <c:v>4.1509932297080832E-2</c:v>
                  </c:pt>
                  <c:pt idx="5">
                    <c:v>3.7274890347460565E-2</c:v>
                  </c:pt>
                  <c:pt idx="6">
                    <c:v>4.6640803820456413E-2</c:v>
                  </c:pt>
                  <c:pt idx="7">
                    <c:v>6.9437163417222655E-2</c:v>
                  </c:pt>
                  <c:pt idx="8">
                    <c:v>6.2761110704455905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R$237:$AZ$237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R$240:$AZ$240</c:f>
              <c:numCache>
                <c:formatCode>0.000</c:formatCode>
                <c:ptCount val="9"/>
                <c:pt idx="0">
                  <c:v>0.56295035519382952</c:v>
                </c:pt>
                <c:pt idx="1">
                  <c:v>0.53972110320057687</c:v>
                </c:pt>
                <c:pt idx="2">
                  <c:v>0.5525248273281701</c:v>
                </c:pt>
                <c:pt idx="3">
                  <c:v>0.54918969928170058</c:v>
                </c:pt>
                <c:pt idx="4">
                  <c:v>0.43663158254210355</c:v>
                </c:pt>
                <c:pt idx="5">
                  <c:v>0.4525118670063189</c:v>
                </c:pt>
                <c:pt idx="6">
                  <c:v>0.45253311980575006</c:v>
                </c:pt>
                <c:pt idx="7">
                  <c:v>0.48964747924496005</c:v>
                </c:pt>
                <c:pt idx="8">
                  <c:v>0.4610093363187884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P$241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BA$241:$BI$241</c:f>
                <c:numCache>
                  <c:formatCode>General</c:formatCode>
                  <c:ptCount val="9"/>
                  <c:pt idx="0">
                    <c:v>2.723099714309319E-2</c:v>
                  </c:pt>
                  <c:pt idx="1">
                    <c:v>3.0621298985173198E-2</c:v>
                  </c:pt>
                  <c:pt idx="2">
                    <c:v>3.5011618672875541E-2</c:v>
                  </c:pt>
                  <c:pt idx="3">
                    <c:v>2.5099247770881367E-2</c:v>
                  </c:pt>
                  <c:pt idx="4">
                    <c:v>2.510897687510957E-2</c:v>
                  </c:pt>
                  <c:pt idx="5">
                    <c:v>2.8213977103058167E-2</c:v>
                  </c:pt>
                  <c:pt idx="6">
                    <c:v>3.3534757486585826E-2</c:v>
                  </c:pt>
                  <c:pt idx="7">
                    <c:v>3.0618976170831171E-2</c:v>
                  </c:pt>
                  <c:pt idx="8">
                    <c:v>3.3703975250717659E-2</c:v>
                  </c:pt>
                </c:numCache>
              </c:numRef>
            </c:plus>
            <c:minus>
              <c:numRef>
                <c:f>'Fig S3'!$BA$241:$BI$241</c:f>
                <c:numCache>
                  <c:formatCode>General</c:formatCode>
                  <c:ptCount val="9"/>
                  <c:pt idx="0">
                    <c:v>2.723099714309319E-2</c:v>
                  </c:pt>
                  <c:pt idx="1">
                    <c:v>3.0621298985173198E-2</c:v>
                  </c:pt>
                  <c:pt idx="2">
                    <c:v>3.5011618672875541E-2</c:v>
                  </c:pt>
                  <c:pt idx="3">
                    <c:v>2.5099247770881367E-2</c:v>
                  </c:pt>
                  <c:pt idx="4">
                    <c:v>2.510897687510957E-2</c:v>
                  </c:pt>
                  <c:pt idx="5">
                    <c:v>2.8213977103058167E-2</c:v>
                  </c:pt>
                  <c:pt idx="6">
                    <c:v>3.3534757486585826E-2</c:v>
                  </c:pt>
                  <c:pt idx="7">
                    <c:v>3.0618976170831171E-2</c:v>
                  </c:pt>
                  <c:pt idx="8">
                    <c:v>3.3703975250717659E-2</c:v>
                  </c:pt>
                </c:numCache>
              </c:numRef>
            </c:minus>
          </c:errBars>
          <c:xVal>
            <c:numRef>
              <c:f>'Fig S3'!$AR$237:$AZ$237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R$241:$AZ$241</c:f>
              <c:numCache>
                <c:formatCode>0.000</c:formatCode>
                <c:ptCount val="9"/>
                <c:pt idx="0">
                  <c:v>0.5450472309036023</c:v>
                </c:pt>
                <c:pt idx="1">
                  <c:v>0.54854223844384131</c:v>
                </c:pt>
                <c:pt idx="2">
                  <c:v>0.54083198995795545</c:v>
                </c:pt>
                <c:pt idx="3">
                  <c:v>0.56734780966156817</c:v>
                </c:pt>
                <c:pt idx="4">
                  <c:v>0.42788234102755107</c:v>
                </c:pt>
                <c:pt idx="5">
                  <c:v>0.42804198049667558</c:v>
                </c:pt>
                <c:pt idx="6">
                  <c:v>0.41604136720934604</c:v>
                </c:pt>
                <c:pt idx="7">
                  <c:v>0.4180360357379363</c:v>
                </c:pt>
                <c:pt idx="8">
                  <c:v>0.4151468520215269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3851200"/>
        <c:axId val="373854560"/>
      </c:scatterChart>
      <c:valAx>
        <c:axId val="37385120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73854560"/>
        <c:crosses val="autoZero"/>
        <c:crossBetween val="midCat"/>
        <c:majorUnit val="2"/>
        <c:minorUnit val="1"/>
      </c:valAx>
      <c:valAx>
        <c:axId val="373854560"/>
        <c:scaling>
          <c:orientation val="minMax"/>
          <c:max val="0.8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73851200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P$242</c:f>
              <c:strCache>
                <c:ptCount val="1"/>
                <c:pt idx="0">
                  <c:v>high R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BA$242:$BI$242</c:f>
                <c:numCache>
                  <c:formatCode>General</c:formatCode>
                  <c:ptCount val="9"/>
                  <c:pt idx="0">
                    <c:v>4.7366996211518263E-2</c:v>
                  </c:pt>
                  <c:pt idx="1">
                    <c:v>5.3255749301763813E-2</c:v>
                  </c:pt>
                  <c:pt idx="2">
                    <c:v>5.0344148650432886E-2</c:v>
                  </c:pt>
                  <c:pt idx="3">
                    <c:v>5.3237161235901026E-2</c:v>
                  </c:pt>
                  <c:pt idx="4">
                    <c:v>4.9089267036877375E-2</c:v>
                  </c:pt>
                  <c:pt idx="5">
                    <c:v>4.6029821704579608E-2</c:v>
                  </c:pt>
                  <c:pt idx="6">
                    <c:v>5.5349622964291849E-2</c:v>
                  </c:pt>
                  <c:pt idx="7">
                    <c:v>0.11241366400353579</c:v>
                  </c:pt>
                  <c:pt idx="8">
                    <c:v>0.11225756199887664</c:v>
                  </c:pt>
                </c:numCache>
              </c:numRef>
            </c:plus>
            <c:minus>
              <c:numRef>
                <c:f>'Fig S3'!$BA$242:$BI$242</c:f>
                <c:numCache>
                  <c:formatCode>General</c:formatCode>
                  <c:ptCount val="9"/>
                  <c:pt idx="0">
                    <c:v>4.7366996211518263E-2</c:v>
                  </c:pt>
                  <c:pt idx="1">
                    <c:v>5.3255749301763813E-2</c:v>
                  </c:pt>
                  <c:pt idx="2">
                    <c:v>5.0344148650432886E-2</c:v>
                  </c:pt>
                  <c:pt idx="3">
                    <c:v>5.3237161235901026E-2</c:v>
                  </c:pt>
                  <c:pt idx="4">
                    <c:v>4.9089267036877375E-2</c:v>
                  </c:pt>
                  <c:pt idx="5">
                    <c:v>4.6029821704579608E-2</c:v>
                  </c:pt>
                  <c:pt idx="6">
                    <c:v>5.5349622964291849E-2</c:v>
                  </c:pt>
                  <c:pt idx="7">
                    <c:v>0.11241366400353579</c:v>
                  </c:pt>
                  <c:pt idx="8">
                    <c:v>0.11225756199887664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R$237:$AZ$237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R$242:$AZ$242</c:f>
              <c:numCache>
                <c:formatCode>0.000</c:formatCode>
                <c:ptCount val="9"/>
                <c:pt idx="0">
                  <c:v>0.57681685993625209</c:v>
                </c:pt>
                <c:pt idx="1">
                  <c:v>0.60103680463708964</c:v>
                </c:pt>
                <c:pt idx="2">
                  <c:v>0.59157941141956449</c:v>
                </c:pt>
                <c:pt idx="3">
                  <c:v>0.59812592761485173</c:v>
                </c:pt>
                <c:pt idx="4">
                  <c:v>0.54647438117388536</c:v>
                </c:pt>
                <c:pt idx="5">
                  <c:v>0.51396059258428872</c:v>
                </c:pt>
                <c:pt idx="6">
                  <c:v>0.4606959319454873</c:v>
                </c:pt>
                <c:pt idx="7">
                  <c:v>0.39790893698535124</c:v>
                </c:pt>
                <c:pt idx="8">
                  <c:v>0.4048687681038224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P$243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BA$243:$BI$243</c:f>
                <c:numCache>
                  <c:formatCode>General</c:formatCode>
                  <c:ptCount val="9"/>
                  <c:pt idx="0">
                    <c:v>1.2604214630485177E-2</c:v>
                  </c:pt>
                  <c:pt idx="1">
                    <c:v>1.8707448321009262E-2</c:v>
                  </c:pt>
                  <c:pt idx="2">
                    <c:v>2.055681432168617E-2</c:v>
                  </c:pt>
                  <c:pt idx="3">
                    <c:v>1.8550969203264035E-2</c:v>
                  </c:pt>
                  <c:pt idx="4">
                    <c:v>1.9742249199946455E-2</c:v>
                  </c:pt>
                  <c:pt idx="5">
                    <c:v>1.5055357607012265E-2</c:v>
                  </c:pt>
                  <c:pt idx="6">
                    <c:v>4.5252322453767473E-2</c:v>
                  </c:pt>
                  <c:pt idx="7">
                    <c:v>8.2699806930638969E-2</c:v>
                  </c:pt>
                  <c:pt idx="8">
                    <c:v>0.11095404826441306</c:v>
                  </c:pt>
                </c:numCache>
              </c:numRef>
            </c:plus>
            <c:minus>
              <c:numRef>
                <c:f>'Fig S3'!$BA$243:$BI$243</c:f>
                <c:numCache>
                  <c:formatCode>General</c:formatCode>
                  <c:ptCount val="9"/>
                  <c:pt idx="0">
                    <c:v>1.2604214630485177E-2</c:v>
                  </c:pt>
                  <c:pt idx="1">
                    <c:v>1.8707448321009262E-2</c:v>
                  </c:pt>
                  <c:pt idx="2">
                    <c:v>2.055681432168617E-2</c:v>
                  </c:pt>
                  <c:pt idx="3">
                    <c:v>1.8550969203264035E-2</c:v>
                  </c:pt>
                  <c:pt idx="4">
                    <c:v>1.9742249199946455E-2</c:v>
                  </c:pt>
                  <c:pt idx="5">
                    <c:v>1.5055357607012265E-2</c:v>
                  </c:pt>
                  <c:pt idx="6">
                    <c:v>4.5252322453767473E-2</c:v>
                  </c:pt>
                  <c:pt idx="7">
                    <c:v>8.2699806930638969E-2</c:v>
                  </c:pt>
                  <c:pt idx="8">
                    <c:v>0.11095404826441306</c:v>
                  </c:pt>
                </c:numCache>
              </c:numRef>
            </c:minus>
          </c:errBars>
          <c:xVal>
            <c:numRef>
              <c:f>'Fig S3'!$AR$237:$AZ$237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R$243:$AZ$243</c:f>
              <c:numCache>
                <c:formatCode>0.000</c:formatCode>
                <c:ptCount val="9"/>
                <c:pt idx="0">
                  <c:v>0.60094353144286716</c:v>
                </c:pt>
                <c:pt idx="1">
                  <c:v>0.61094542759272141</c:v>
                </c:pt>
                <c:pt idx="2">
                  <c:v>0.60506824350393074</c:v>
                </c:pt>
                <c:pt idx="3">
                  <c:v>0.5952322948666442</c:v>
                </c:pt>
                <c:pt idx="4">
                  <c:v>0.56708573115205618</c:v>
                </c:pt>
                <c:pt idx="5">
                  <c:v>0.55858545462661724</c:v>
                </c:pt>
                <c:pt idx="6">
                  <c:v>0.52112229475703953</c:v>
                </c:pt>
                <c:pt idx="7">
                  <c:v>0.47506472812419281</c:v>
                </c:pt>
                <c:pt idx="8">
                  <c:v>0.4376514898730894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3876400"/>
        <c:axId val="373854000"/>
      </c:scatterChart>
      <c:valAx>
        <c:axId val="37387640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73854000"/>
        <c:crosses val="autoZero"/>
        <c:crossBetween val="midCat"/>
        <c:majorUnit val="2"/>
        <c:minorUnit val="1"/>
      </c:valAx>
      <c:valAx>
        <c:axId val="373854000"/>
        <c:scaling>
          <c:orientation val="minMax"/>
          <c:max val="0.8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73876400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P$244</c:f>
              <c:strCache>
                <c:ptCount val="1"/>
                <c:pt idx="0">
                  <c:v>high Rs</c:v>
                </c:pt>
              </c:strCache>
            </c:strRef>
          </c:tx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BA$244:$BI$244</c:f>
                <c:numCache>
                  <c:formatCode>General</c:formatCode>
                  <c:ptCount val="9"/>
                  <c:pt idx="0">
                    <c:v>3.9273470218511984E-2</c:v>
                  </c:pt>
                  <c:pt idx="1">
                    <c:v>4.3047461975497976E-2</c:v>
                  </c:pt>
                  <c:pt idx="2">
                    <c:v>1.8907746120547617E-2</c:v>
                  </c:pt>
                  <c:pt idx="3">
                    <c:v>5.1228709115940137E-2</c:v>
                  </c:pt>
                  <c:pt idx="4">
                    <c:v>6.479105161947496E-2</c:v>
                  </c:pt>
                  <c:pt idx="5">
                    <c:v>8.6275550966925393E-2</c:v>
                  </c:pt>
                  <c:pt idx="6">
                    <c:v>7.9702308590820947E-2</c:v>
                  </c:pt>
                  <c:pt idx="7">
                    <c:v>7.6617279020809531E-2</c:v>
                  </c:pt>
                  <c:pt idx="8">
                    <c:v>7.3000181346846146E-2</c:v>
                  </c:pt>
                </c:numCache>
              </c:numRef>
            </c:plus>
            <c:minus>
              <c:numRef>
                <c:f>'Fig S3'!$BA$244:$BI$244</c:f>
                <c:numCache>
                  <c:formatCode>General</c:formatCode>
                  <c:ptCount val="9"/>
                  <c:pt idx="0">
                    <c:v>3.9273470218511984E-2</c:v>
                  </c:pt>
                  <c:pt idx="1">
                    <c:v>4.3047461975497976E-2</c:v>
                  </c:pt>
                  <c:pt idx="2">
                    <c:v>1.8907746120547617E-2</c:v>
                  </c:pt>
                  <c:pt idx="3">
                    <c:v>5.1228709115940137E-2</c:v>
                  </c:pt>
                  <c:pt idx="4">
                    <c:v>6.479105161947496E-2</c:v>
                  </c:pt>
                  <c:pt idx="5">
                    <c:v>8.6275550966925393E-2</c:v>
                  </c:pt>
                  <c:pt idx="6">
                    <c:v>7.9702308590820947E-2</c:v>
                  </c:pt>
                  <c:pt idx="7">
                    <c:v>7.6617279020809531E-2</c:v>
                  </c:pt>
                  <c:pt idx="8">
                    <c:v>7.3000181346846146E-2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R$237:$AZ$237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R$244:$AZ$244</c:f>
              <c:numCache>
                <c:formatCode>0.000</c:formatCode>
                <c:ptCount val="9"/>
                <c:pt idx="0">
                  <c:v>0.58000761156192604</c:v>
                </c:pt>
                <c:pt idx="1">
                  <c:v>0.58864560909165053</c:v>
                </c:pt>
                <c:pt idx="2">
                  <c:v>0.62766331547741394</c:v>
                </c:pt>
                <c:pt idx="3">
                  <c:v>0.57575027238364507</c:v>
                </c:pt>
                <c:pt idx="4">
                  <c:v>0.3884954776940524</c:v>
                </c:pt>
                <c:pt idx="5">
                  <c:v>0.32096408096408097</c:v>
                </c:pt>
                <c:pt idx="6">
                  <c:v>0.28826572603864753</c:v>
                </c:pt>
                <c:pt idx="7">
                  <c:v>0.28448343156290046</c:v>
                </c:pt>
                <c:pt idx="8">
                  <c:v>0.2765466643794006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P$245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BA$245:$BI$245</c:f>
                <c:numCache>
                  <c:formatCode>General</c:formatCode>
                  <c:ptCount val="9"/>
                  <c:pt idx="0">
                    <c:v>2.8733409519583256E-2</c:v>
                  </c:pt>
                  <c:pt idx="1">
                    <c:v>2.5236815733866377E-2</c:v>
                  </c:pt>
                  <c:pt idx="2">
                    <c:v>4.6296666449351181E-2</c:v>
                  </c:pt>
                  <c:pt idx="3">
                    <c:v>2.59460340913042E-2</c:v>
                  </c:pt>
                  <c:pt idx="4">
                    <c:v>3.8066916638331207E-2</c:v>
                  </c:pt>
                  <c:pt idx="5">
                    <c:v>5.4157540147771792E-2</c:v>
                  </c:pt>
                  <c:pt idx="6">
                    <c:v>4.3644167773130342E-2</c:v>
                  </c:pt>
                  <c:pt idx="7">
                    <c:v>6.9190630993198332E-2</c:v>
                  </c:pt>
                  <c:pt idx="8">
                    <c:v>6.2039654084149361E-2</c:v>
                  </c:pt>
                </c:numCache>
              </c:numRef>
            </c:plus>
            <c:minus>
              <c:numRef>
                <c:f>'Fig S3'!$BA$245:$BI$245</c:f>
                <c:numCache>
                  <c:formatCode>General</c:formatCode>
                  <c:ptCount val="9"/>
                  <c:pt idx="0">
                    <c:v>2.8733409519583256E-2</c:v>
                  </c:pt>
                  <c:pt idx="1">
                    <c:v>2.5236815733866377E-2</c:v>
                  </c:pt>
                  <c:pt idx="2">
                    <c:v>4.6296666449351181E-2</c:v>
                  </c:pt>
                  <c:pt idx="3">
                    <c:v>2.59460340913042E-2</c:v>
                  </c:pt>
                  <c:pt idx="4">
                    <c:v>3.8066916638331207E-2</c:v>
                  </c:pt>
                  <c:pt idx="5">
                    <c:v>5.4157540147771792E-2</c:v>
                  </c:pt>
                  <c:pt idx="6">
                    <c:v>4.3644167773130342E-2</c:v>
                  </c:pt>
                  <c:pt idx="7">
                    <c:v>6.9190630993198332E-2</c:v>
                  </c:pt>
                  <c:pt idx="8">
                    <c:v>6.2039654084149361E-2</c:v>
                  </c:pt>
                </c:numCache>
              </c:numRef>
            </c:minus>
          </c:errBars>
          <c:xVal>
            <c:numRef>
              <c:f>'Fig S3'!$AR$237:$AZ$237</c:f>
              <c:numCache>
                <c:formatCode>General</c:formatCode>
                <c:ptCount val="9"/>
                <c:pt idx="0">
                  <c:v>-10</c:v>
                </c:pt>
                <c:pt idx="1">
                  <c:v>-5</c:v>
                </c:pt>
                <c:pt idx="2">
                  <c:v>-3</c:v>
                </c:pt>
                <c:pt idx="3">
                  <c:v>0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8</c:v>
                </c:pt>
                <c:pt idx="8">
                  <c:v>11</c:v>
                </c:pt>
              </c:numCache>
            </c:numRef>
          </c:xVal>
          <c:yVal>
            <c:numRef>
              <c:f>'Fig S3'!$AR$245:$AZ$245</c:f>
              <c:numCache>
                <c:formatCode>0.000</c:formatCode>
                <c:ptCount val="9"/>
                <c:pt idx="0">
                  <c:v>0.59466221291498567</c:v>
                </c:pt>
                <c:pt idx="1">
                  <c:v>0.60443215440017128</c:v>
                </c:pt>
                <c:pt idx="2">
                  <c:v>0.53314995265128717</c:v>
                </c:pt>
                <c:pt idx="3">
                  <c:v>0.58668035682626818</c:v>
                </c:pt>
                <c:pt idx="4">
                  <c:v>0.40191914630207676</c:v>
                </c:pt>
                <c:pt idx="5">
                  <c:v>0.34226095990187866</c:v>
                </c:pt>
                <c:pt idx="6">
                  <c:v>0.31902792673002145</c:v>
                </c:pt>
                <c:pt idx="7">
                  <c:v>0.25524891454506149</c:v>
                </c:pt>
                <c:pt idx="8">
                  <c:v>0.2184071240919023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3866320"/>
        <c:axId val="373864640"/>
      </c:scatterChart>
      <c:valAx>
        <c:axId val="37386632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73864640"/>
        <c:crosses val="autoZero"/>
        <c:crossBetween val="midCat"/>
        <c:majorUnit val="2"/>
        <c:minorUnit val="1"/>
      </c:valAx>
      <c:valAx>
        <c:axId val="373864640"/>
        <c:scaling>
          <c:orientation val="minMax"/>
          <c:max val="0.8"/>
          <c:min val="0"/>
        </c:scaling>
        <c:delete val="0"/>
        <c:axPos val="l"/>
        <c:numFmt formatCode="#,##0.00" sourceLinked="0"/>
        <c:majorTickMark val="out"/>
        <c:minorTickMark val="none"/>
        <c:tickLblPos val="none"/>
        <c:crossAx val="373866320"/>
        <c:crossesAt val="-11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g S3'!$AM$89</c:f>
              <c:strCache>
                <c:ptCount val="1"/>
                <c:pt idx="0">
                  <c:v>high Rs</c:v>
                </c:pt>
              </c:strCache>
            </c:strRef>
          </c:tx>
          <c:spPr>
            <a:ln w="12700">
              <a:solidFill>
                <a:sysClr val="window" lastClr="FFFFFF">
                  <a:lumMod val="65000"/>
                </a:sysClr>
              </a:solidFill>
            </a:ln>
          </c:spPr>
          <c:marker>
            <c:symbol val="x"/>
            <c:size val="5"/>
            <c:spPr>
              <a:noFill/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W$89:$BD$89</c:f>
                <c:numCache>
                  <c:formatCode>General</c:formatCode>
                  <c:ptCount val="8"/>
                  <c:pt idx="0">
                    <c:v>1004716.1963798566</c:v>
                  </c:pt>
                  <c:pt idx="1">
                    <c:v>769500.81297450454</c:v>
                  </c:pt>
                  <c:pt idx="2">
                    <c:v>2330824.9219195629</c:v>
                  </c:pt>
                  <c:pt idx="3">
                    <c:v>1271062.775371633</c:v>
                  </c:pt>
                  <c:pt idx="4">
                    <c:v>1072324.1181544147</c:v>
                  </c:pt>
                  <c:pt idx="5">
                    <c:v>918898.40012519818</c:v>
                  </c:pt>
                  <c:pt idx="6">
                    <c:v>3192491.5534435553</c:v>
                  </c:pt>
                  <c:pt idx="7">
                    <c:v>1250649.2790701035</c:v>
                  </c:pt>
                </c:numCache>
              </c:numRef>
            </c:plus>
            <c:minus>
              <c:numRef>
                <c:f>'Fig S3'!$AW$89:$BD$89</c:f>
                <c:numCache>
                  <c:formatCode>General</c:formatCode>
                  <c:ptCount val="8"/>
                  <c:pt idx="0">
                    <c:v>1004716.1963798566</c:v>
                  </c:pt>
                  <c:pt idx="1">
                    <c:v>769500.81297450454</c:v>
                  </c:pt>
                  <c:pt idx="2">
                    <c:v>2330824.9219195629</c:v>
                  </c:pt>
                  <c:pt idx="3">
                    <c:v>1271062.775371633</c:v>
                  </c:pt>
                  <c:pt idx="4">
                    <c:v>1072324.1181544147</c:v>
                  </c:pt>
                  <c:pt idx="5">
                    <c:v>918898.40012519818</c:v>
                  </c:pt>
                  <c:pt idx="6">
                    <c:v>3192491.5534435553</c:v>
                  </c:pt>
                  <c:pt idx="7">
                    <c:v>1250649.2790701035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xVal>
            <c:numRef>
              <c:f>'Fig S3'!$AO$88:$AV$8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3'!$AO$89:$AV$89</c:f>
              <c:numCache>
                <c:formatCode>0.00E+00</c:formatCode>
                <c:ptCount val="8"/>
                <c:pt idx="0">
                  <c:v>2220744.0187656269</c:v>
                </c:pt>
                <c:pt idx="1">
                  <c:v>1901157.7594331361</c:v>
                </c:pt>
                <c:pt idx="2">
                  <c:v>3714800.5955787646</c:v>
                </c:pt>
                <c:pt idx="3">
                  <c:v>2227281.3402994433</c:v>
                </c:pt>
                <c:pt idx="4">
                  <c:v>2431513.168001988</c:v>
                </c:pt>
                <c:pt idx="5">
                  <c:v>2234604.1690515997</c:v>
                </c:pt>
                <c:pt idx="6">
                  <c:v>4582357.1194932992</c:v>
                </c:pt>
                <c:pt idx="7">
                  <c:v>2454056.14119374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 S3'!$AM$90</c:f>
              <c:strCache>
                <c:ptCount val="1"/>
                <c:pt idx="0">
                  <c:v>low Rs</c:v>
                </c:pt>
              </c:strCache>
            </c:strRef>
          </c:tx>
          <c:spPr>
            <a:ln w="31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 w="15875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3'!$AW$90:$BD$90</c:f>
                <c:numCache>
                  <c:formatCode>General</c:formatCode>
                  <c:ptCount val="8"/>
                  <c:pt idx="0">
                    <c:v>939358.56964064692</c:v>
                  </c:pt>
                  <c:pt idx="1">
                    <c:v>627511.0445543176</c:v>
                  </c:pt>
                  <c:pt idx="2">
                    <c:v>611450.73582360416</c:v>
                  </c:pt>
                  <c:pt idx="3">
                    <c:v>900975.44122559263</c:v>
                  </c:pt>
                  <c:pt idx="4">
                    <c:v>896240.18825276219</c:v>
                  </c:pt>
                  <c:pt idx="5">
                    <c:v>624917.15078597073</c:v>
                  </c:pt>
                  <c:pt idx="6">
                    <c:v>1097255.7717698079</c:v>
                  </c:pt>
                  <c:pt idx="7">
                    <c:v>521752.79576797341</c:v>
                  </c:pt>
                </c:numCache>
              </c:numRef>
            </c:plus>
            <c:minus>
              <c:numRef>
                <c:f>'Fig S3'!$AW$90:$BD$90</c:f>
                <c:numCache>
                  <c:formatCode>General</c:formatCode>
                  <c:ptCount val="8"/>
                  <c:pt idx="0">
                    <c:v>939358.56964064692</c:v>
                  </c:pt>
                  <c:pt idx="1">
                    <c:v>627511.0445543176</c:v>
                  </c:pt>
                  <c:pt idx="2">
                    <c:v>611450.73582360416</c:v>
                  </c:pt>
                  <c:pt idx="3">
                    <c:v>900975.44122559263</c:v>
                  </c:pt>
                  <c:pt idx="4">
                    <c:v>896240.18825276219</c:v>
                  </c:pt>
                  <c:pt idx="5">
                    <c:v>624917.15078597073</c:v>
                  </c:pt>
                  <c:pt idx="6">
                    <c:v>1097255.7717698079</c:v>
                  </c:pt>
                  <c:pt idx="7">
                    <c:v>521752.79576797341</c:v>
                  </c:pt>
                </c:numCache>
              </c:numRef>
            </c:minus>
          </c:errBars>
          <c:xVal>
            <c:numRef>
              <c:f>'Fig S3'!$AO$88:$AV$88</c:f>
              <c:numCache>
                <c:formatCode>General</c:formatCode>
                <c:ptCount val="8"/>
                <c:pt idx="0">
                  <c:v>-5</c:v>
                </c:pt>
                <c:pt idx="1">
                  <c:v>-3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8</c:v>
                </c:pt>
                <c:pt idx="7">
                  <c:v>11</c:v>
                </c:pt>
              </c:numCache>
            </c:numRef>
          </c:xVal>
          <c:yVal>
            <c:numRef>
              <c:f>'Fig S3'!$AO$90:$AV$90</c:f>
              <c:numCache>
                <c:formatCode>0.00E+00</c:formatCode>
                <c:ptCount val="8"/>
                <c:pt idx="0">
                  <c:v>1593692.0902767316</c:v>
                </c:pt>
                <c:pt idx="1">
                  <c:v>1415132.378605108</c:v>
                </c:pt>
                <c:pt idx="2">
                  <c:v>997992.94121225679</c:v>
                </c:pt>
                <c:pt idx="3">
                  <c:v>1509392.5903354133</c:v>
                </c:pt>
                <c:pt idx="4">
                  <c:v>1421988.9736337995</c:v>
                </c:pt>
                <c:pt idx="5">
                  <c:v>1197203.0318029181</c:v>
                </c:pt>
                <c:pt idx="6">
                  <c:v>1856787.1212883051</c:v>
                </c:pt>
                <c:pt idx="7">
                  <c:v>903294.6600900050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3861280"/>
        <c:axId val="373860720"/>
      </c:scatterChart>
      <c:valAx>
        <c:axId val="373861280"/>
        <c:scaling>
          <c:orientation val="minMax"/>
          <c:max val="12"/>
          <c:min val="-11"/>
        </c:scaling>
        <c:delete val="0"/>
        <c:axPos val="b"/>
        <c:numFmt formatCode="General" sourceLinked="1"/>
        <c:majorTickMark val="out"/>
        <c:minorTickMark val="out"/>
        <c:tickLblPos val="none"/>
        <c:crossAx val="373860720"/>
        <c:crosses val="autoZero"/>
        <c:crossBetween val="midCat"/>
        <c:majorUnit val="2"/>
        <c:minorUnit val="1"/>
      </c:valAx>
      <c:valAx>
        <c:axId val="373860720"/>
        <c:scaling>
          <c:logBase val="10"/>
          <c:orientation val="minMax"/>
          <c:min val="10000"/>
        </c:scaling>
        <c:delete val="0"/>
        <c:axPos val="l"/>
        <c:numFmt formatCode="0.0E+0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73861280"/>
        <c:crossesAt val="-11"/>
        <c:crossBetween val="midCat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78B0C2-C436-456F-A0DD-2C31CFB799CF}" type="datetimeFigureOut">
              <a:rPr lang="es-US" smtClean="0"/>
              <a:pPr/>
              <a:t>12/9/2015</a:t>
            </a:fld>
            <a:endParaRPr lang="es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C21B1-8D8C-4CF0-9150-6DCB0A2F01F2}" type="slidenum">
              <a:rPr lang="es-US" smtClean="0"/>
              <a:pPr/>
              <a:t>‹#›</a:t>
            </a:fld>
            <a:endParaRPr lang="es-US"/>
          </a:p>
        </p:txBody>
      </p:sp>
    </p:spTree>
    <p:extLst>
      <p:ext uri="{BB962C8B-B14F-4D97-AF65-F5344CB8AC3E}">
        <p14:creationId xmlns:p14="http://schemas.microsoft.com/office/powerpoint/2010/main" val="15420385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6C21B1-8D8C-4CF0-9150-6DCB0A2F01F2}" type="slidenum">
              <a:rPr lang="es-US" smtClean="0"/>
              <a:pPr/>
              <a:t>1</a:t>
            </a:fld>
            <a:endParaRPr lang="es-US"/>
          </a:p>
        </p:txBody>
      </p:sp>
    </p:spTree>
    <p:extLst>
      <p:ext uri="{BB962C8B-B14F-4D97-AF65-F5344CB8AC3E}">
        <p14:creationId xmlns:p14="http://schemas.microsoft.com/office/powerpoint/2010/main" val="4079401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31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441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90281" y="591397"/>
            <a:ext cx="1485662" cy="125869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0598" y="591397"/>
            <a:ext cx="4330144" cy="1258697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44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332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333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0597" y="3441277"/>
            <a:ext cx="2907903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8040" y="3441277"/>
            <a:ext cx="2907904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682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732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107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192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606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7921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C22DA-B6B0-46B1-8162-B81E92B23B11}" type="datetimeFigureOut">
              <a:rPr lang="en-US" smtClean="0"/>
              <a:pPr/>
              <a:t>12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DC4C91-B820-414B-9582-83EB4CDF89C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310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chart" Target="../charts/chart11.xml"/><Relationship Id="rId18" Type="http://schemas.openxmlformats.org/officeDocument/2006/relationships/chart" Target="../charts/chart16.xml"/><Relationship Id="rId26" Type="http://schemas.openxmlformats.org/officeDocument/2006/relationships/chart" Target="../charts/chart24.xml"/><Relationship Id="rId3" Type="http://schemas.openxmlformats.org/officeDocument/2006/relationships/chart" Target="../charts/chart1.xml"/><Relationship Id="rId21" Type="http://schemas.openxmlformats.org/officeDocument/2006/relationships/chart" Target="../charts/chart19.xml"/><Relationship Id="rId34" Type="http://schemas.openxmlformats.org/officeDocument/2006/relationships/chart" Target="../charts/chart32.xml"/><Relationship Id="rId7" Type="http://schemas.openxmlformats.org/officeDocument/2006/relationships/chart" Target="../charts/chart5.xml"/><Relationship Id="rId12" Type="http://schemas.openxmlformats.org/officeDocument/2006/relationships/chart" Target="../charts/chart10.xml"/><Relationship Id="rId17" Type="http://schemas.openxmlformats.org/officeDocument/2006/relationships/chart" Target="../charts/chart15.xml"/><Relationship Id="rId25" Type="http://schemas.openxmlformats.org/officeDocument/2006/relationships/chart" Target="../charts/chart23.xml"/><Relationship Id="rId33" Type="http://schemas.openxmlformats.org/officeDocument/2006/relationships/chart" Target="../charts/chart31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14.xml"/><Relationship Id="rId20" Type="http://schemas.openxmlformats.org/officeDocument/2006/relationships/chart" Target="../charts/chart18.xml"/><Relationship Id="rId29" Type="http://schemas.openxmlformats.org/officeDocument/2006/relationships/chart" Target="../charts/chart27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24" Type="http://schemas.openxmlformats.org/officeDocument/2006/relationships/chart" Target="../charts/chart22.xml"/><Relationship Id="rId32" Type="http://schemas.openxmlformats.org/officeDocument/2006/relationships/chart" Target="../charts/chart30.xml"/><Relationship Id="rId5" Type="http://schemas.openxmlformats.org/officeDocument/2006/relationships/chart" Target="../charts/chart3.xml"/><Relationship Id="rId15" Type="http://schemas.openxmlformats.org/officeDocument/2006/relationships/chart" Target="../charts/chart13.xml"/><Relationship Id="rId23" Type="http://schemas.openxmlformats.org/officeDocument/2006/relationships/chart" Target="../charts/chart21.xml"/><Relationship Id="rId28" Type="http://schemas.openxmlformats.org/officeDocument/2006/relationships/chart" Target="../charts/chart26.xml"/><Relationship Id="rId10" Type="http://schemas.openxmlformats.org/officeDocument/2006/relationships/chart" Target="../charts/chart8.xml"/><Relationship Id="rId19" Type="http://schemas.openxmlformats.org/officeDocument/2006/relationships/chart" Target="../charts/chart17.xml"/><Relationship Id="rId31" Type="http://schemas.openxmlformats.org/officeDocument/2006/relationships/chart" Target="../charts/chart29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Relationship Id="rId14" Type="http://schemas.openxmlformats.org/officeDocument/2006/relationships/chart" Target="../charts/chart12.xml"/><Relationship Id="rId22" Type="http://schemas.openxmlformats.org/officeDocument/2006/relationships/chart" Target="../charts/chart20.xml"/><Relationship Id="rId27" Type="http://schemas.openxmlformats.org/officeDocument/2006/relationships/chart" Target="../charts/chart25.xml"/><Relationship Id="rId30" Type="http://schemas.openxmlformats.org/officeDocument/2006/relationships/chart" Target="../charts/chart28.xml"/><Relationship Id="rId8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975063" y="350521"/>
            <a:ext cx="16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T-CL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48863" y="3589566"/>
            <a:ext cx="430887" cy="74006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i="1" dirty="0" err="1" smtClean="0"/>
              <a:t>F</a:t>
            </a:r>
            <a:r>
              <a:rPr lang="en-US" sz="800" b="1" baseline="-25000" dirty="0" err="1" smtClean="0"/>
              <a:t>v</a:t>
            </a:r>
            <a:r>
              <a:rPr lang="en-US" sz="800" b="1" dirty="0" smtClean="0"/>
              <a:t>/</a:t>
            </a:r>
            <a:r>
              <a:rPr lang="en-US" sz="800" b="1" i="1" dirty="0" err="1" smtClean="0"/>
              <a:t>F</a:t>
            </a:r>
            <a:r>
              <a:rPr lang="en-US" sz="800" b="1" baseline="-25000" dirty="0" err="1" smtClean="0"/>
              <a:t>m</a:t>
            </a:r>
            <a:endParaRPr lang="en-US" sz="800" b="1" baseline="-25000" dirty="0" smtClean="0"/>
          </a:p>
          <a:p>
            <a:pPr algn="ctr"/>
            <a:r>
              <a:rPr lang="en-US" sz="800" b="1" dirty="0" smtClean="0"/>
              <a:t> </a:t>
            </a:r>
            <a:endParaRPr lang="en-US" sz="8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612977" y="350521"/>
            <a:ext cx="1603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T-H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255224" y="350521"/>
            <a:ext cx="1608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HT-CL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906140" y="360046"/>
            <a:ext cx="1635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HT-HL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48863" y="4494697"/>
            <a:ext cx="430887" cy="79428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smtClean="0"/>
              <a:t>Φ</a:t>
            </a:r>
            <a:r>
              <a:rPr lang="en-US" sz="800" b="1" baseline="-25000" dirty="0" smtClean="0"/>
              <a:t>PSII</a:t>
            </a:r>
            <a:r>
              <a:rPr lang="en-US" sz="800" b="1" dirty="0" smtClean="0"/>
              <a:t> </a:t>
            </a:r>
          </a:p>
          <a:p>
            <a:pPr algn="ctr"/>
            <a:endParaRPr lang="en-US" sz="800" b="1" dirty="0" smtClean="0"/>
          </a:p>
        </p:txBody>
      </p:sp>
      <p:sp>
        <p:nvSpPr>
          <p:cNvPr id="22" name="TextBox 21"/>
          <p:cNvSpPr txBox="1"/>
          <p:nvPr/>
        </p:nvSpPr>
        <p:spPr>
          <a:xfrm>
            <a:off x="248863" y="6437471"/>
            <a:ext cx="430887" cy="82209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smtClean="0"/>
              <a:t>Φ</a:t>
            </a:r>
            <a:r>
              <a:rPr lang="en-US" sz="800" b="1" baseline="-25000" dirty="0" smtClean="0"/>
              <a:t>NPQ</a:t>
            </a:r>
          </a:p>
          <a:p>
            <a:pPr algn="ctr"/>
            <a:r>
              <a:rPr lang="en-US" sz="800" b="1" dirty="0" smtClean="0"/>
              <a:t>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48863" y="7433631"/>
            <a:ext cx="430887" cy="7394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smtClean="0"/>
              <a:t>Φ</a:t>
            </a:r>
            <a:r>
              <a:rPr lang="en-US" sz="800" b="1" baseline="-25000" dirty="0" smtClean="0"/>
              <a:t>NO</a:t>
            </a:r>
            <a:r>
              <a:rPr lang="en-US" sz="800" b="1" dirty="0" smtClean="0"/>
              <a:t> </a:t>
            </a:r>
          </a:p>
          <a:p>
            <a:pPr algn="ctr"/>
            <a:endParaRPr lang="en-US" sz="800" b="1" dirty="0" smtClean="0"/>
          </a:p>
        </p:txBody>
      </p:sp>
      <p:sp>
        <p:nvSpPr>
          <p:cNvPr id="857" name="TextBox 856"/>
          <p:cNvSpPr txBox="1"/>
          <p:nvPr/>
        </p:nvSpPr>
        <p:spPr>
          <a:xfrm>
            <a:off x="248863" y="612202"/>
            <a:ext cx="553998" cy="100159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err="1" smtClean="0"/>
              <a:t>Holobiont</a:t>
            </a:r>
            <a:r>
              <a:rPr lang="en-US" sz="800" b="1" dirty="0" smtClean="0"/>
              <a:t> Reflectance </a:t>
            </a:r>
          </a:p>
          <a:p>
            <a:pPr algn="ctr"/>
            <a:r>
              <a:rPr lang="en-US" sz="800" b="1" dirty="0" smtClean="0"/>
              <a:t>(au)</a:t>
            </a:r>
          </a:p>
        </p:txBody>
      </p:sp>
      <p:sp>
        <p:nvSpPr>
          <p:cNvPr id="858" name="TextBox 857"/>
          <p:cNvSpPr txBox="1"/>
          <p:nvPr/>
        </p:nvSpPr>
        <p:spPr>
          <a:xfrm>
            <a:off x="184779" y="1549462"/>
            <a:ext cx="430887" cy="111519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i="1" dirty="0" err="1" smtClean="0"/>
              <a:t>Symbiodinium</a:t>
            </a:r>
            <a:r>
              <a:rPr lang="en-US" sz="800" b="1" dirty="0" smtClean="0"/>
              <a:t> </a:t>
            </a:r>
          </a:p>
          <a:p>
            <a:pPr algn="ctr"/>
            <a:r>
              <a:rPr lang="en-US" sz="800" b="1" dirty="0" smtClean="0"/>
              <a:t>Density  (cells/cm</a:t>
            </a:r>
            <a:r>
              <a:rPr lang="en-US" sz="800" b="1" baseline="30000" dirty="0" smtClean="0"/>
              <a:t>2</a:t>
            </a:r>
            <a:r>
              <a:rPr lang="en-US" sz="800" b="1" dirty="0" smtClean="0"/>
              <a:t>)</a:t>
            </a:r>
          </a:p>
        </p:txBody>
      </p:sp>
      <p:sp>
        <p:nvSpPr>
          <p:cNvPr id="583" name="TextBox 582"/>
          <p:cNvSpPr txBox="1"/>
          <p:nvPr/>
        </p:nvSpPr>
        <p:spPr>
          <a:xfrm>
            <a:off x="248863" y="2545013"/>
            <a:ext cx="430887" cy="102288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800" dirty="0" smtClean="0"/>
              <a:t>Chlorophyll a</a:t>
            </a:r>
          </a:p>
          <a:p>
            <a:pPr algn="ctr">
              <a:defRPr sz="10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800" dirty="0" smtClean="0"/>
              <a:t> Density (ng/cell)</a:t>
            </a:r>
            <a:endParaRPr lang="en-US" sz="800" dirty="0"/>
          </a:p>
        </p:txBody>
      </p:sp>
      <p:sp>
        <p:nvSpPr>
          <p:cNvPr id="611" name="TextBox 610"/>
          <p:cNvSpPr txBox="1"/>
          <p:nvPr/>
        </p:nvSpPr>
        <p:spPr>
          <a:xfrm>
            <a:off x="87019" y="594385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a.</a:t>
            </a:r>
            <a:endParaRPr lang="en-US" sz="1200" b="1" dirty="0"/>
          </a:p>
        </p:txBody>
      </p:sp>
      <p:sp>
        <p:nvSpPr>
          <p:cNvPr id="612" name="TextBox 611"/>
          <p:cNvSpPr txBox="1"/>
          <p:nvPr/>
        </p:nvSpPr>
        <p:spPr>
          <a:xfrm>
            <a:off x="87019" y="1578688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b.</a:t>
            </a:r>
            <a:endParaRPr lang="en-US" sz="1200" b="1" dirty="0"/>
          </a:p>
        </p:txBody>
      </p:sp>
      <p:sp>
        <p:nvSpPr>
          <p:cNvPr id="614" name="TextBox 613"/>
          <p:cNvSpPr txBox="1"/>
          <p:nvPr/>
        </p:nvSpPr>
        <p:spPr>
          <a:xfrm>
            <a:off x="87019" y="2535442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.</a:t>
            </a:r>
            <a:endParaRPr lang="en-US" sz="1200" b="1" dirty="0"/>
          </a:p>
        </p:txBody>
      </p:sp>
      <p:sp>
        <p:nvSpPr>
          <p:cNvPr id="615" name="TextBox 614"/>
          <p:cNvSpPr txBox="1"/>
          <p:nvPr/>
        </p:nvSpPr>
        <p:spPr>
          <a:xfrm>
            <a:off x="87019" y="3413862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d</a:t>
            </a:r>
            <a:r>
              <a:rPr lang="en-US" sz="1200" b="1" dirty="0" smtClean="0"/>
              <a:t>.</a:t>
            </a:r>
            <a:endParaRPr lang="en-US" sz="1200" b="1" dirty="0"/>
          </a:p>
        </p:txBody>
      </p:sp>
      <p:sp>
        <p:nvSpPr>
          <p:cNvPr id="616" name="TextBox 615"/>
          <p:cNvSpPr txBox="1"/>
          <p:nvPr/>
        </p:nvSpPr>
        <p:spPr>
          <a:xfrm>
            <a:off x="87019" y="4418426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e</a:t>
            </a:r>
            <a:r>
              <a:rPr lang="en-US" sz="1200" b="1" dirty="0" smtClean="0"/>
              <a:t>.</a:t>
            </a:r>
            <a:endParaRPr lang="en-US" sz="1200" b="1" dirty="0"/>
          </a:p>
        </p:txBody>
      </p:sp>
      <p:sp>
        <p:nvSpPr>
          <p:cNvPr id="617" name="TextBox 616"/>
          <p:cNvSpPr txBox="1"/>
          <p:nvPr/>
        </p:nvSpPr>
        <p:spPr>
          <a:xfrm>
            <a:off x="87019" y="5350449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f</a:t>
            </a:r>
            <a:r>
              <a:rPr lang="en-US" sz="1200" b="1" dirty="0" smtClean="0"/>
              <a:t>.</a:t>
            </a:r>
            <a:endParaRPr lang="en-US" sz="1200" b="1" dirty="0"/>
          </a:p>
        </p:txBody>
      </p:sp>
      <p:sp>
        <p:nvSpPr>
          <p:cNvPr id="618" name="TextBox 617"/>
          <p:cNvSpPr txBox="1"/>
          <p:nvPr/>
        </p:nvSpPr>
        <p:spPr>
          <a:xfrm>
            <a:off x="87019" y="6347033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g</a:t>
            </a:r>
            <a:r>
              <a:rPr lang="en-US" sz="1200" b="1" dirty="0" smtClean="0"/>
              <a:t>.</a:t>
            </a:r>
            <a:endParaRPr lang="en-US" sz="1200" b="1" dirty="0"/>
          </a:p>
        </p:txBody>
      </p:sp>
      <p:sp>
        <p:nvSpPr>
          <p:cNvPr id="619" name="TextBox 618"/>
          <p:cNvSpPr txBox="1"/>
          <p:nvPr/>
        </p:nvSpPr>
        <p:spPr>
          <a:xfrm>
            <a:off x="87019" y="7300045"/>
            <a:ext cx="348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h</a:t>
            </a:r>
            <a:r>
              <a:rPr lang="en-US" sz="1200" b="1" dirty="0" smtClean="0"/>
              <a:t>.</a:t>
            </a:r>
            <a:endParaRPr lang="en-US" sz="1200" b="1" dirty="0"/>
          </a:p>
        </p:txBody>
      </p:sp>
      <p:sp>
        <p:nvSpPr>
          <p:cNvPr id="620" name="TextBox 619"/>
          <p:cNvSpPr txBox="1"/>
          <p:nvPr/>
        </p:nvSpPr>
        <p:spPr>
          <a:xfrm>
            <a:off x="242243" y="5491396"/>
            <a:ext cx="430887" cy="79428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800" b="1" dirty="0" err="1" smtClean="0"/>
              <a:t>Q</a:t>
            </a:r>
            <a:r>
              <a:rPr lang="en-US" sz="800" b="1" baseline="-25000" dirty="0" err="1" smtClean="0"/>
              <a:t>m</a:t>
            </a:r>
            <a:r>
              <a:rPr lang="en-US" sz="800" b="1" dirty="0"/>
              <a:t> </a:t>
            </a:r>
          </a:p>
          <a:p>
            <a:pPr algn="ctr"/>
            <a:endParaRPr lang="en-US" sz="800" b="1" dirty="0"/>
          </a:p>
        </p:txBody>
      </p:sp>
      <p:grpSp>
        <p:nvGrpSpPr>
          <p:cNvPr id="650" name="Group 649"/>
          <p:cNvGrpSpPr/>
          <p:nvPr/>
        </p:nvGrpSpPr>
        <p:grpSpPr>
          <a:xfrm>
            <a:off x="2618971" y="7351782"/>
            <a:ext cx="785070" cy="787300"/>
            <a:chOff x="725439" y="7856661"/>
            <a:chExt cx="674330" cy="914400"/>
          </a:xfrm>
        </p:grpSpPr>
        <p:cxnSp>
          <p:nvCxnSpPr>
            <p:cNvPr id="651" name="Straight Connector 650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2" name="Straight Connector 651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3" name="Straight Connector 652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4" name="Straight Connector 653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5" name="Straight Connector 654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6" name="Straight Connector 655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7" name="Straight Connector 656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8" name="Straight Connector 657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9" name="Straight Connector 658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0" name="Straight Connector 659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1" name="Straight Connector 660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2" name="Straight Connector 661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63" name="Group 662"/>
          <p:cNvGrpSpPr/>
          <p:nvPr/>
        </p:nvGrpSpPr>
        <p:grpSpPr>
          <a:xfrm>
            <a:off x="963649" y="7349524"/>
            <a:ext cx="1576153" cy="785749"/>
            <a:chOff x="803573" y="655857"/>
            <a:chExt cx="1538507" cy="795442"/>
          </a:xfrm>
        </p:grpSpPr>
        <p:cxnSp>
          <p:nvCxnSpPr>
            <p:cNvPr id="664" name="Straight Connector 663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5" name="Straight Connector 664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6" name="Straight Connector 665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7" name="Straight Connector 666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8" name="Straight Connector 667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9" name="Straight Connector 668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0" name="Straight Connector 669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1" name="Straight Connector 670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2" name="Straight Connector 671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3" name="Straight Connector 672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4" name="Straight Connector 673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5" name="Straight Connector 674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6" name="Straight Connector 675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7" name="Straight Connector 676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8" name="Straight Connector 677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9" name="Straight Connector 678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0" name="Straight Connector 679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1" name="Straight Connector 680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" name="Group 4"/>
          <p:cNvGrpSpPr/>
          <p:nvPr/>
        </p:nvGrpSpPr>
        <p:grpSpPr>
          <a:xfrm>
            <a:off x="966222" y="10972800"/>
            <a:ext cx="6532036" cy="10744200"/>
            <a:chOff x="966222" y="-565383"/>
            <a:chExt cx="6532036" cy="10744200"/>
          </a:xfrm>
        </p:grpSpPr>
        <p:grpSp>
          <p:nvGrpSpPr>
            <p:cNvPr id="4" name="Group 3"/>
            <p:cNvGrpSpPr/>
            <p:nvPr/>
          </p:nvGrpSpPr>
          <p:grpSpPr>
            <a:xfrm>
              <a:off x="966222" y="-565383"/>
              <a:ext cx="1568709" cy="10744200"/>
              <a:chOff x="966222" y="8609095"/>
              <a:chExt cx="1568709" cy="10744200"/>
            </a:xfrm>
          </p:grpSpPr>
          <p:cxnSp>
            <p:nvCxnSpPr>
              <p:cNvPr id="824" name="Straight Connector 823"/>
              <p:cNvCxnSpPr/>
              <p:nvPr/>
            </p:nvCxnSpPr>
            <p:spPr>
              <a:xfrm flipV="1">
                <a:off x="966222" y="8685295"/>
                <a:ext cx="0" cy="10668000"/>
              </a:xfrm>
              <a:prstGeom prst="line">
                <a:avLst/>
              </a:prstGeom>
              <a:ln/>
              <a:effectLst>
                <a:glow rad="63500">
                  <a:schemeClr val="accent2">
                    <a:satMod val="175000"/>
                    <a:alpha val="40000"/>
                  </a:schemeClr>
                </a:glow>
              </a:effectLst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829" name="Straight Connector 828"/>
              <p:cNvCxnSpPr/>
              <p:nvPr/>
            </p:nvCxnSpPr>
            <p:spPr>
              <a:xfrm flipV="1">
                <a:off x="2534931" y="8609095"/>
                <a:ext cx="0" cy="10668000"/>
              </a:xfrm>
              <a:prstGeom prst="line">
                <a:avLst/>
              </a:prstGeom>
              <a:ln/>
              <a:effectLst>
                <a:glow rad="63500">
                  <a:schemeClr val="accent2">
                    <a:satMod val="175000"/>
                    <a:alpha val="40000"/>
                  </a:schemeClr>
                </a:glow>
              </a:effectLst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  <p:grpSp>
          <p:nvGrpSpPr>
            <p:cNvPr id="859" name="Group 858"/>
            <p:cNvGrpSpPr/>
            <p:nvPr/>
          </p:nvGrpSpPr>
          <p:grpSpPr>
            <a:xfrm>
              <a:off x="2620664" y="-565383"/>
              <a:ext cx="1568709" cy="10744200"/>
              <a:chOff x="966222" y="8609095"/>
              <a:chExt cx="1568709" cy="10744200"/>
            </a:xfrm>
          </p:grpSpPr>
          <p:cxnSp>
            <p:nvCxnSpPr>
              <p:cNvPr id="860" name="Straight Connector 859"/>
              <p:cNvCxnSpPr/>
              <p:nvPr/>
            </p:nvCxnSpPr>
            <p:spPr>
              <a:xfrm flipV="1">
                <a:off x="966222" y="8685295"/>
                <a:ext cx="0" cy="10668000"/>
              </a:xfrm>
              <a:prstGeom prst="line">
                <a:avLst/>
              </a:prstGeom>
              <a:ln/>
              <a:effectLst>
                <a:glow rad="63500">
                  <a:schemeClr val="accent2">
                    <a:satMod val="175000"/>
                    <a:alpha val="40000"/>
                  </a:schemeClr>
                </a:glow>
              </a:effectLst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861" name="Straight Connector 860"/>
              <p:cNvCxnSpPr/>
              <p:nvPr/>
            </p:nvCxnSpPr>
            <p:spPr>
              <a:xfrm flipV="1">
                <a:off x="2534931" y="8609095"/>
                <a:ext cx="0" cy="10668000"/>
              </a:xfrm>
              <a:prstGeom prst="line">
                <a:avLst/>
              </a:prstGeom>
              <a:ln/>
              <a:effectLst>
                <a:glow rad="63500">
                  <a:schemeClr val="accent2">
                    <a:satMod val="175000"/>
                    <a:alpha val="40000"/>
                  </a:schemeClr>
                </a:glow>
              </a:effectLst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  <p:grpSp>
          <p:nvGrpSpPr>
            <p:cNvPr id="862" name="Group 861"/>
            <p:cNvGrpSpPr/>
            <p:nvPr/>
          </p:nvGrpSpPr>
          <p:grpSpPr>
            <a:xfrm>
              <a:off x="4275106" y="-565383"/>
              <a:ext cx="1568709" cy="10744200"/>
              <a:chOff x="966222" y="8609095"/>
              <a:chExt cx="1568709" cy="10744200"/>
            </a:xfrm>
          </p:grpSpPr>
          <p:cxnSp>
            <p:nvCxnSpPr>
              <p:cNvPr id="863" name="Straight Connector 862"/>
              <p:cNvCxnSpPr/>
              <p:nvPr/>
            </p:nvCxnSpPr>
            <p:spPr>
              <a:xfrm flipV="1">
                <a:off x="966222" y="8685295"/>
                <a:ext cx="0" cy="10668000"/>
              </a:xfrm>
              <a:prstGeom prst="line">
                <a:avLst/>
              </a:prstGeom>
              <a:ln/>
              <a:effectLst>
                <a:glow rad="63500">
                  <a:schemeClr val="accent2">
                    <a:satMod val="175000"/>
                    <a:alpha val="40000"/>
                  </a:schemeClr>
                </a:glow>
              </a:effectLst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864" name="Straight Connector 863"/>
              <p:cNvCxnSpPr/>
              <p:nvPr/>
            </p:nvCxnSpPr>
            <p:spPr>
              <a:xfrm flipV="1">
                <a:off x="2534931" y="8609095"/>
                <a:ext cx="0" cy="10668000"/>
              </a:xfrm>
              <a:prstGeom prst="line">
                <a:avLst/>
              </a:prstGeom>
              <a:ln/>
              <a:effectLst>
                <a:glow rad="63500">
                  <a:schemeClr val="accent2">
                    <a:satMod val="175000"/>
                    <a:alpha val="40000"/>
                  </a:schemeClr>
                </a:glow>
              </a:effectLst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  <p:grpSp>
          <p:nvGrpSpPr>
            <p:cNvPr id="865" name="Group 864"/>
            <p:cNvGrpSpPr/>
            <p:nvPr/>
          </p:nvGrpSpPr>
          <p:grpSpPr>
            <a:xfrm>
              <a:off x="5929549" y="-565383"/>
              <a:ext cx="1568709" cy="10744200"/>
              <a:chOff x="966222" y="8609095"/>
              <a:chExt cx="1568709" cy="10744200"/>
            </a:xfrm>
          </p:grpSpPr>
          <p:cxnSp>
            <p:nvCxnSpPr>
              <p:cNvPr id="866" name="Straight Connector 865"/>
              <p:cNvCxnSpPr/>
              <p:nvPr/>
            </p:nvCxnSpPr>
            <p:spPr>
              <a:xfrm flipV="1">
                <a:off x="966222" y="8685295"/>
                <a:ext cx="0" cy="10668000"/>
              </a:xfrm>
              <a:prstGeom prst="line">
                <a:avLst/>
              </a:prstGeom>
              <a:ln/>
              <a:effectLst>
                <a:glow rad="63500">
                  <a:schemeClr val="accent2">
                    <a:satMod val="175000"/>
                    <a:alpha val="40000"/>
                  </a:schemeClr>
                </a:glow>
              </a:effectLst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867" name="Straight Connector 866"/>
              <p:cNvCxnSpPr/>
              <p:nvPr/>
            </p:nvCxnSpPr>
            <p:spPr>
              <a:xfrm flipV="1">
                <a:off x="2534931" y="8609095"/>
                <a:ext cx="0" cy="10668000"/>
              </a:xfrm>
              <a:prstGeom prst="line">
                <a:avLst/>
              </a:prstGeom>
              <a:ln/>
              <a:effectLst>
                <a:glow rad="63500">
                  <a:schemeClr val="accent2">
                    <a:satMod val="175000"/>
                    <a:alpha val="40000"/>
                  </a:schemeClr>
                </a:glow>
              </a:effectLst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93" name="Group 892"/>
          <p:cNvGrpSpPr/>
          <p:nvPr/>
        </p:nvGrpSpPr>
        <p:grpSpPr>
          <a:xfrm>
            <a:off x="4280922" y="7351782"/>
            <a:ext cx="785070" cy="787300"/>
            <a:chOff x="725439" y="7856661"/>
            <a:chExt cx="674330" cy="914400"/>
          </a:xfrm>
        </p:grpSpPr>
        <p:cxnSp>
          <p:nvCxnSpPr>
            <p:cNvPr id="894" name="Straight Connector 893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5" name="Straight Connector 894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6" name="Straight Connector 895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7" name="Straight Connector 896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8" name="Straight Connector 897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9" name="Straight Connector 898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0" name="Straight Connector 899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1" name="Straight Connector 900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2" name="Straight Connector 901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3" name="Straight Connector 902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4" name="Straight Connector 903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5" name="Straight Connector 904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06" name="Group 905"/>
          <p:cNvGrpSpPr/>
          <p:nvPr/>
        </p:nvGrpSpPr>
        <p:grpSpPr>
          <a:xfrm>
            <a:off x="5923386" y="7351782"/>
            <a:ext cx="785070" cy="787300"/>
            <a:chOff x="725439" y="7856661"/>
            <a:chExt cx="674330" cy="914400"/>
          </a:xfrm>
        </p:grpSpPr>
        <p:cxnSp>
          <p:nvCxnSpPr>
            <p:cNvPr id="907" name="Straight Connector 906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8" name="Straight Connector 907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9" name="Straight Connector 908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0" name="Straight Connector 909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1" name="Straight Connector 910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2" name="Straight Connector 911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3" name="Straight Connector 912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4" name="Straight Connector 913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5" name="Straight Connector 914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6" name="Straight Connector 915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7" name="Straight Connector 916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8" name="Straight Connector 917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19" name="Group 918"/>
          <p:cNvGrpSpPr/>
          <p:nvPr/>
        </p:nvGrpSpPr>
        <p:grpSpPr>
          <a:xfrm>
            <a:off x="2618971" y="6394001"/>
            <a:ext cx="785070" cy="787300"/>
            <a:chOff x="725439" y="7856661"/>
            <a:chExt cx="674330" cy="914400"/>
          </a:xfrm>
        </p:grpSpPr>
        <p:cxnSp>
          <p:nvCxnSpPr>
            <p:cNvPr id="920" name="Straight Connector 919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1" name="Straight Connector 920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2" name="Straight Connector 921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3" name="Straight Connector 922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4" name="Straight Connector 923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5" name="Straight Connector 924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6" name="Straight Connector 925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7" name="Straight Connector 926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8" name="Straight Connector 927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9" name="Straight Connector 928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0" name="Straight Connector 929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1" name="Straight Connector 930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32" name="Group 931"/>
          <p:cNvGrpSpPr/>
          <p:nvPr/>
        </p:nvGrpSpPr>
        <p:grpSpPr>
          <a:xfrm>
            <a:off x="963649" y="6391743"/>
            <a:ext cx="1576153" cy="785749"/>
            <a:chOff x="803573" y="655857"/>
            <a:chExt cx="1538507" cy="795442"/>
          </a:xfrm>
        </p:grpSpPr>
        <p:cxnSp>
          <p:nvCxnSpPr>
            <p:cNvPr id="933" name="Straight Connector 932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4" name="Straight Connector 933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5" name="Straight Connector 934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6" name="Straight Connector 935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7" name="Straight Connector 936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8" name="Straight Connector 937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9" name="Straight Connector 938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0" name="Straight Connector 939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1" name="Straight Connector 940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2" name="Straight Connector 941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3" name="Straight Connector 942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4" name="Straight Connector 943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5" name="Straight Connector 944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6" name="Straight Connector 945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7" name="Straight Connector 946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8" name="Straight Connector 947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9" name="Straight Connector 948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0" name="Straight Connector 949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51" name="Group 950"/>
          <p:cNvGrpSpPr/>
          <p:nvPr/>
        </p:nvGrpSpPr>
        <p:grpSpPr>
          <a:xfrm>
            <a:off x="4280922" y="6394001"/>
            <a:ext cx="785070" cy="787300"/>
            <a:chOff x="725439" y="7856661"/>
            <a:chExt cx="674330" cy="914400"/>
          </a:xfrm>
        </p:grpSpPr>
        <p:cxnSp>
          <p:nvCxnSpPr>
            <p:cNvPr id="952" name="Straight Connector 951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3" name="Straight Connector 952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4" name="Straight Connector 953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5" name="Straight Connector 954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6" name="Straight Connector 955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7" name="Straight Connector 956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8" name="Straight Connector 957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9" name="Straight Connector 958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0" name="Straight Connector 959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1" name="Straight Connector 960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2" name="Straight Connector 961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3" name="Straight Connector 962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64" name="Group 963"/>
          <p:cNvGrpSpPr/>
          <p:nvPr/>
        </p:nvGrpSpPr>
        <p:grpSpPr>
          <a:xfrm>
            <a:off x="5923386" y="6394001"/>
            <a:ext cx="785070" cy="787300"/>
            <a:chOff x="725439" y="7856661"/>
            <a:chExt cx="674330" cy="914400"/>
          </a:xfrm>
        </p:grpSpPr>
        <p:cxnSp>
          <p:nvCxnSpPr>
            <p:cNvPr id="965" name="Straight Connector 964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6" name="Straight Connector 965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7" name="Straight Connector 966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8" name="Straight Connector 967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9" name="Straight Connector 968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0" name="Straight Connector 969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1" name="Straight Connector 970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2" name="Straight Connector 971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3" name="Straight Connector 972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4" name="Straight Connector 973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5" name="Straight Connector 974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6" name="Straight Connector 975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77" name="Group 976"/>
          <p:cNvGrpSpPr/>
          <p:nvPr/>
        </p:nvGrpSpPr>
        <p:grpSpPr>
          <a:xfrm>
            <a:off x="2618971" y="5436221"/>
            <a:ext cx="785070" cy="787300"/>
            <a:chOff x="725439" y="7856661"/>
            <a:chExt cx="674330" cy="914400"/>
          </a:xfrm>
        </p:grpSpPr>
        <p:cxnSp>
          <p:nvCxnSpPr>
            <p:cNvPr id="978" name="Straight Connector 977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9" name="Straight Connector 978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0" name="Straight Connector 979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1" name="Straight Connector 980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2" name="Straight Connector 981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3" name="Straight Connector 982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4" name="Straight Connector 983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5" name="Straight Connector 984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6" name="Straight Connector 985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7" name="Straight Connector 986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8" name="Straight Connector 987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89" name="Straight Connector 988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90" name="Group 989"/>
          <p:cNvGrpSpPr/>
          <p:nvPr/>
        </p:nvGrpSpPr>
        <p:grpSpPr>
          <a:xfrm>
            <a:off x="963649" y="5433963"/>
            <a:ext cx="1576153" cy="785749"/>
            <a:chOff x="803573" y="655857"/>
            <a:chExt cx="1538507" cy="795442"/>
          </a:xfrm>
        </p:grpSpPr>
        <p:cxnSp>
          <p:nvCxnSpPr>
            <p:cNvPr id="991" name="Straight Connector 990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2" name="Straight Connector 991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3" name="Straight Connector 992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4" name="Straight Connector 993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5" name="Straight Connector 994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6" name="Straight Connector 995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7" name="Straight Connector 996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8" name="Straight Connector 997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9" name="Straight Connector 998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0" name="Straight Connector 999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1" name="Straight Connector 1000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2" name="Straight Connector 1001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3" name="Straight Connector 1002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4" name="Straight Connector 1003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5" name="Straight Connector 1004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6" name="Straight Connector 1005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7" name="Straight Connector 1006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8" name="Straight Connector 1007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09" name="Group 1008"/>
          <p:cNvGrpSpPr/>
          <p:nvPr/>
        </p:nvGrpSpPr>
        <p:grpSpPr>
          <a:xfrm>
            <a:off x="4280922" y="5436221"/>
            <a:ext cx="785070" cy="787300"/>
            <a:chOff x="725439" y="7856661"/>
            <a:chExt cx="674330" cy="914400"/>
          </a:xfrm>
        </p:grpSpPr>
        <p:cxnSp>
          <p:nvCxnSpPr>
            <p:cNvPr id="1010" name="Straight Connector 1009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1" name="Straight Connector 1010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2" name="Straight Connector 1011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3" name="Straight Connector 1012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4" name="Straight Connector 1013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5" name="Straight Connector 1014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6" name="Straight Connector 1015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7" name="Straight Connector 1016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8" name="Straight Connector 1017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9" name="Straight Connector 1018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20" name="Straight Connector 1019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21" name="Straight Connector 1020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22" name="Group 1021"/>
          <p:cNvGrpSpPr/>
          <p:nvPr/>
        </p:nvGrpSpPr>
        <p:grpSpPr>
          <a:xfrm>
            <a:off x="5923386" y="5436221"/>
            <a:ext cx="785070" cy="787300"/>
            <a:chOff x="725439" y="7856661"/>
            <a:chExt cx="674330" cy="914400"/>
          </a:xfrm>
        </p:grpSpPr>
        <p:cxnSp>
          <p:nvCxnSpPr>
            <p:cNvPr id="1023" name="Straight Connector 1022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24" name="Straight Connector 1023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25" name="Straight Connector 1024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26" name="Straight Connector 1025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27" name="Straight Connector 1026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28" name="Straight Connector 1027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29" name="Straight Connector 1028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0" name="Straight Connector 1029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1" name="Straight Connector 1030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2" name="Straight Connector 1031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3" name="Straight Connector 1032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4" name="Straight Connector 1033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35" name="Group 1034"/>
          <p:cNvGrpSpPr/>
          <p:nvPr/>
        </p:nvGrpSpPr>
        <p:grpSpPr>
          <a:xfrm>
            <a:off x="2618971" y="4478441"/>
            <a:ext cx="785070" cy="787300"/>
            <a:chOff x="725439" y="7856661"/>
            <a:chExt cx="674330" cy="914400"/>
          </a:xfrm>
        </p:grpSpPr>
        <p:cxnSp>
          <p:nvCxnSpPr>
            <p:cNvPr id="1036" name="Straight Connector 1035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7" name="Straight Connector 1036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8" name="Straight Connector 1037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9" name="Straight Connector 1038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0" name="Straight Connector 1039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1" name="Straight Connector 1040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2" name="Straight Connector 1041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3" name="Straight Connector 1042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4" name="Straight Connector 1043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5" name="Straight Connector 1044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6" name="Straight Connector 1045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7" name="Straight Connector 1046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48" name="Group 1047"/>
          <p:cNvGrpSpPr/>
          <p:nvPr/>
        </p:nvGrpSpPr>
        <p:grpSpPr>
          <a:xfrm>
            <a:off x="963649" y="4476183"/>
            <a:ext cx="1576153" cy="785749"/>
            <a:chOff x="803573" y="655857"/>
            <a:chExt cx="1538507" cy="795442"/>
          </a:xfrm>
        </p:grpSpPr>
        <p:cxnSp>
          <p:nvCxnSpPr>
            <p:cNvPr id="1049" name="Straight Connector 1048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0" name="Straight Connector 1049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1" name="Straight Connector 1050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2" name="Straight Connector 1051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3" name="Straight Connector 1052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4" name="Straight Connector 1053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5" name="Straight Connector 1054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6" name="Straight Connector 1055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7" name="Straight Connector 1056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8" name="Straight Connector 1057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9" name="Straight Connector 1058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0" name="Straight Connector 1059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1" name="Straight Connector 1060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2" name="Straight Connector 1061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3" name="Straight Connector 1062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4" name="Straight Connector 1063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5" name="Straight Connector 1064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6" name="Straight Connector 1065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67" name="Group 1066"/>
          <p:cNvGrpSpPr/>
          <p:nvPr/>
        </p:nvGrpSpPr>
        <p:grpSpPr>
          <a:xfrm>
            <a:off x="4280922" y="4478441"/>
            <a:ext cx="785070" cy="787300"/>
            <a:chOff x="725439" y="7856661"/>
            <a:chExt cx="674330" cy="914400"/>
          </a:xfrm>
        </p:grpSpPr>
        <p:cxnSp>
          <p:nvCxnSpPr>
            <p:cNvPr id="1068" name="Straight Connector 1067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9" name="Straight Connector 1068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0" name="Straight Connector 1069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1" name="Straight Connector 1070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2" name="Straight Connector 1071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3" name="Straight Connector 1072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4" name="Straight Connector 1073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5" name="Straight Connector 1074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6" name="Straight Connector 1075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7" name="Straight Connector 1076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8" name="Straight Connector 1077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9" name="Straight Connector 1078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80" name="Group 1079"/>
          <p:cNvGrpSpPr/>
          <p:nvPr/>
        </p:nvGrpSpPr>
        <p:grpSpPr>
          <a:xfrm>
            <a:off x="5923386" y="4478441"/>
            <a:ext cx="785070" cy="787300"/>
            <a:chOff x="725439" y="7856661"/>
            <a:chExt cx="674330" cy="914400"/>
          </a:xfrm>
        </p:grpSpPr>
        <p:cxnSp>
          <p:nvCxnSpPr>
            <p:cNvPr id="1081" name="Straight Connector 1080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82" name="Straight Connector 1081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83" name="Straight Connector 1082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84" name="Straight Connector 1083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85" name="Straight Connector 1084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86" name="Straight Connector 1085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87" name="Straight Connector 1086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88" name="Straight Connector 1087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89" name="Straight Connector 1088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90" name="Straight Connector 1089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91" name="Straight Connector 1090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92" name="Straight Connector 1091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93" name="Group 1092"/>
          <p:cNvGrpSpPr/>
          <p:nvPr/>
        </p:nvGrpSpPr>
        <p:grpSpPr>
          <a:xfrm>
            <a:off x="2618971" y="3517417"/>
            <a:ext cx="785070" cy="787300"/>
            <a:chOff x="725439" y="7856661"/>
            <a:chExt cx="674330" cy="914400"/>
          </a:xfrm>
        </p:grpSpPr>
        <p:cxnSp>
          <p:nvCxnSpPr>
            <p:cNvPr id="1094" name="Straight Connector 1093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95" name="Straight Connector 1094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96" name="Straight Connector 1095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97" name="Straight Connector 1096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98" name="Straight Connector 1097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99" name="Straight Connector 1098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00" name="Straight Connector 1099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01" name="Straight Connector 1100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02" name="Straight Connector 1101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03" name="Straight Connector 1102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04" name="Straight Connector 1103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05" name="Straight Connector 1104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06" name="Group 1105"/>
          <p:cNvGrpSpPr/>
          <p:nvPr/>
        </p:nvGrpSpPr>
        <p:grpSpPr>
          <a:xfrm>
            <a:off x="963649" y="3515159"/>
            <a:ext cx="1576153" cy="785749"/>
            <a:chOff x="803573" y="655857"/>
            <a:chExt cx="1538507" cy="795442"/>
          </a:xfrm>
        </p:grpSpPr>
        <p:cxnSp>
          <p:nvCxnSpPr>
            <p:cNvPr id="1107" name="Straight Connector 1106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08" name="Straight Connector 1107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09" name="Straight Connector 1108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0" name="Straight Connector 1109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1" name="Straight Connector 1110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2" name="Straight Connector 1111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3" name="Straight Connector 1112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4" name="Straight Connector 1113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5" name="Straight Connector 1114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6" name="Straight Connector 1115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7" name="Straight Connector 1116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8" name="Straight Connector 1117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9" name="Straight Connector 1118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0" name="Straight Connector 1119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1" name="Straight Connector 1120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2" name="Straight Connector 1121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3" name="Straight Connector 1122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4" name="Straight Connector 1123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25" name="Group 1124"/>
          <p:cNvGrpSpPr/>
          <p:nvPr/>
        </p:nvGrpSpPr>
        <p:grpSpPr>
          <a:xfrm>
            <a:off x="4280922" y="3517417"/>
            <a:ext cx="785070" cy="787300"/>
            <a:chOff x="725439" y="7856661"/>
            <a:chExt cx="674330" cy="914400"/>
          </a:xfrm>
        </p:grpSpPr>
        <p:cxnSp>
          <p:nvCxnSpPr>
            <p:cNvPr id="1126" name="Straight Connector 1125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7" name="Straight Connector 1126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8" name="Straight Connector 1127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9" name="Straight Connector 1128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0" name="Straight Connector 1129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1" name="Straight Connector 1130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2" name="Straight Connector 1131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3" name="Straight Connector 1132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4" name="Straight Connector 1133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5" name="Straight Connector 1134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6" name="Straight Connector 1135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7" name="Straight Connector 1136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38" name="Group 1137"/>
          <p:cNvGrpSpPr/>
          <p:nvPr/>
        </p:nvGrpSpPr>
        <p:grpSpPr>
          <a:xfrm>
            <a:off x="5923386" y="3517417"/>
            <a:ext cx="785070" cy="787300"/>
            <a:chOff x="725439" y="7856661"/>
            <a:chExt cx="674330" cy="914400"/>
          </a:xfrm>
        </p:grpSpPr>
        <p:cxnSp>
          <p:nvCxnSpPr>
            <p:cNvPr id="1139" name="Straight Connector 1138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0" name="Straight Connector 1139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1" name="Straight Connector 1140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2" name="Straight Connector 1141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3" name="Straight Connector 1142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4" name="Straight Connector 1143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5" name="Straight Connector 1144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6" name="Straight Connector 1145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7" name="Straight Connector 1146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8" name="Straight Connector 1147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9" name="Straight Connector 1148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50" name="Straight Connector 1149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51" name="Group 1150"/>
          <p:cNvGrpSpPr/>
          <p:nvPr/>
        </p:nvGrpSpPr>
        <p:grpSpPr>
          <a:xfrm>
            <a:off x="2618971" y="2554028"/>
            <a:ext cx="785070" cy="787300"/>
            <a:chOff x="725439" y="7856661"/>
            <a:chExt cx="674330" cy="914400"/>
          </a:xfrm>
        </p:grpSpPr>
        <p:cxnSp>
          <p:nvCxnSpPr>
            <p:cNvPr id="1152" name="Straight Connector 1151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53" name="Straight Connector 1152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54" name="Straight Connector 1153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55" name="Straight Connector 1154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56" name="Straight Connector 1155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57" name="Straight Connector 1156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58" name="Straight Connector 1157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59" name="Straight Connector 1158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60" name="Straight Connector 1159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61" name="Straight Connector 1160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62" name="Straight Connector 1161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63" name="Straight Connector 1162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64" name="Group 1163"/>
          <p:cNvGrpSpPr/>
          <p:nvPr/>
        </p:nvGrpSpPr>
        <p:grpSpPr>
          <a:xfrm>
            <a:off x="963649" y="2551770"/>
            <a:ext cx="1576153" cy="785749"/>
            <a:chOff x="803573" y="655857"/>
            <a:chExt cx="1538507" cy="795442"/>
          </a:xfrm>
        </p:grpSpPr>
        <p:cxnSp>
          <p:nvCxnSpPr>
            <p:cNvPr id="1165" name="Straight Connector 1164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66" name="Straight Connector 1165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67" name="Straight Connector 1166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68" name="Straight Connector 1167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69" name="Straight Connector 1168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0" name="Straight Connector 1169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1" name="Straight Connector 1170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2" name="Straight Connector 1171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3" name="Straight Connector 1172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4" name="Straight Connector 1173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5" name="Straight Connector 1174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6" name="Straight Connector 1175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7" name="Straight Connector 1176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8" name="Straight Connector 1177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9" name="Straight Connector 1178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80" name="Straight Connector 1179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81" name="Straight Connector 1180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82" name="Straight Connector 1181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83" name="Group 1182"/>
          <p:cNvGrpSpPr/>
          <p:nvPr/>
        </p:nvGrpSpPr>
        <p:grpSpPr>
          <a:xfrm>
            <a:off x="4280922" y="2554028"/>
            <a:ext cx="785070" cy="787300"/>
            <a:chOff x="725439" y="7856661"/>
            <a:chExt cx="674330" cy="914400"/>
          </a:xfrm>
        </p:grpSpPr>
        <p:cxnSp>
          <p:nvCxnSpPr>
            <p:cNvPr id="1184" name="Straight Connector 1183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85" name="Straight Connector 1184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86" name="Straight Connector 1185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87" name="Straight Connector 1186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88" name="Straight Connector 1187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89" name="Straight Connector 1188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0" name="Straight Connector 1189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1" name="Straight Connector 1190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2" name="Straight Connector 1191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3" name="Straight Connector 1192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4" name="Straight Connector 1193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5" name="Straight Connector 1194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96" name="Group 1195"/>
          <p:cNvGrpSpPr/>
          <p:nvPr/>
        </p:nvGrpSpPr>
        <p:grpSpPr>
          <a:xfrm>
            <a:off x="5923386" y="2554028"/>
            <a:ext cx="785070" cy="787300"/>
            <a:chOff x="725439" y="7856661"/>
            <a:chExt cx="674330" cy="914400"/>
          </a:xfrm>
        </p:grpSpPr>
        <p:cxnSp>
          <p:nvCxnSpPr>
            <p:cNvPr id="1197" name="Straight Connector 1196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8" name="Straight Connector 1197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9" name="Straight Connector 1198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0" name="Straight Connector 1199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1" name="Straight Connector 1200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2" name="Straight Connector 1201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3" name="Straight Connector 1202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4" name="Straight Connector 1203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5" name="Straight Connector 1204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6" name="Straight Connector 1205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7" name="Straight Connector 1206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8" name="Straight Connector 1207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09" name="Group 1208"/>
          <p:cNvGrpSpPr/>
          <p:nvPr/>
        </p:nvGrpSpPr>
        <p:grpSpPr>
          <a:xfrm>
            <a:off x="2618971" y="1601104"/>
            <a:ext cx="785070" cy="787300"/>
            <a:chOff x="725439" y="7856661"/>
            <a:chExt cx="674330" cy="914400"/>
          </a:xfrm>
        </p:grpSpPr>
        <p:cxnSp>
          <p:nvCxnSpPr>
            <p:cNvPr id="1210" name="Straight Connector 1209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1" name="Straight Connector 1210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2" name="Straight Connector 1211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3" name="Straight Connector 1212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4" name="Straight Connector 1213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5" name="Straight Connector 1214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6" name="Straight Connector 1215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7" name="Straight Connector 1216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8" name="Straight Connector 1217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9" name="Straight Connector 1218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0" name="Straight Connector 1219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1" name="Straight Connector 1220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22" name="Group 1221"/>
          <p:cNvGrpSpPr/>
          <p:nvPr/>
        </p:nvGrpSpPr>
        <p:grpSpPr>
          <a:xfrm>
            <a:off x="963649" y="1598846"/>
            <a:ext cx="1576153" cy="785749"/>
            <a:chOff x="803573" y="655857"/>
            <a:chExt cx="1538507" cy="795442"/>
          </a:xfrm>
        </p:grpSpPr>
        <p:cxnSp>
          <p:nvCxnSpPr>
            <p:cNvPr id="1223" name="Straight Connector 1222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4" name="Straight Connector 1223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5" name="Straight Connector 1224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6" name="Straight Connector 1225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7" name="Straight Connector 1226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8" name="Straight Connector 1227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9" name="Straight Connector 1228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0" name="Straight Connector 1229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1" name="Straight Connector 1230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2" name="Straight Connector 1231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3" name="Straight Connector 1232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4" name="Straight Connector 1233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5" name="Straight Connector 1234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6" name="Straight Connector 1235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7" name="Straight Connector 1236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8" name="Straight Connector 1237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9" name="Straight Connector 1238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0" name="Straight Connector 1239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41" name="Group 1240"/>
          <p:cNvGrpSpPr/>
          <p:nvPr/>
        </p:nvGrpSpPr>
        <p:grpSpPr>
          <a:xfrm>
            <a:off x="4280922" y="1601104"/>
            <a:ext cx="785070" cy="787300"/>
            <a:chOff x="725439" y="7856661"/>
            <a:chExt cx="674330" cy="914400"/>
          </a:xfrm>
        </p:grpSpPr>
        <p:cxnSp>
          <p:nvCxnSpPr>
            <p:cNvPr id="1242" name="Straight Connector 1241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3" name="Straight Connector 1242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4" name="Straight Connector 1243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5" name="Straight Connector 1244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6" name="Straight Connector 1245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7" name="Straight Connector 1246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8" name="Straight Connector 1247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9" name="Straight Connector 1248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0" name="Straight Connector 1249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1" name="Straight Connector 1250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2" name="Straight Connector 1251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3" name="Straight Connector 1252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54" name="Group 1253"/>
          <p:cNvGrpSpPr/>
          <p:nvPr/>
        </p:nvGrpSpPr>
        <p:grpSpPr>
          <a:xfrm>
            <a:off x="5923386" y="1601104"/>
            <a:ext cx="785070" cy="787300"/>
            <a:chOff x="725439" y="7856661"/>
            <a:chExt cx="674330" cy="914400"/>
          </a:xfrm>
        </p:grpSpPr>
        <p:cxnSp>
          <p:nvCxnSpPr>
            <p:cNvPr id="1255" name="Straight Connector 1254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6" name="Straight Connector 1255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7" name="Straight Connector 1256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8" name="Straight Connector 1257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9" name="Straight Connector 1258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0" name="Straight Connector 1259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1" name="Straight Connector 1260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2" name="Straight Connector 1261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3" name="Straight Connector 1262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4" name="Straight Connector 1263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5" name="Straight Connector 1264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6" name="Straight Connector 1265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67" name="Group 1266"/>
          <p:cNvGrpSpPr/>
          <p:nvPr/>
        </p:nvGrpSpPr>
        <p:grpSpPr>
          <a:xfrm>
            <a:off x="2618971" y="648009"/>
            <a:ext cx="785070" cy="787300"/>
            <a:chOff x="725439" y="7856661"/>
            <a:chExt cx="674330" cy="914400"/>
          </a:xfrm>
        </p:grpSpPr>
        <p:cxnSp>
          <p:nvCxnSpPr>
            <p:cNvPr id="1268" name="Straight Connector 1267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9" name="Straight Connector 1268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0" name="Straight Connector 1269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1" name="Straight Connector 1270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2" name="Straight Connector 1271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3" name="Straight Connector 1272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4" name="Straight Connector 1273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5" name="Straight Connector 1274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6" name="Straight Connector 1275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7" name="Straight Connector 1276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8" name="Straight Connector 1277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9" name="Straight Connector 1278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80" name="Group 1279"/>
          <p:cNvGrpSpPr/>
          <p:nvPr/>
        </p:nvGrpSpPr>
        <p:grpSpPr>
          <a:xfrm>
            <a:off x="963649" y="645751"/>
            <a:ext cx="1576153" cy="785749"/>
            <a:chOff x="803573" y="655857"/>
            <a:chExt cx="1538507" cy="795442"/>
          </a:xfrm>
        </p:grpSpPr>
        <p:cxnSp>
          <p:nvCxnSpPr>
            <p:cNvPr id="1281" name="Straight Connector 1280"/>
            <p:cNvCxnSpPr/>
            <p:nvPr/>
          </p:nvCxnSpPr>
          <p:spPr>
            <a:xfrm>
              <a:off x="2061401" y="655857"/>
              <a:ext cx="275438" cy="3545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2" name="Straight Connector 1281"/>
            <p:cNvCxnSpPr/>
            <p:nvPr/>
          </p:nvCxnSpPr>
          <p:spPr>
            <a:xfrm>
              <a:off x="806044" y="1388697"/>
              <a:ext cx="48632" cy="6260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3" name="Straight Connector 1282"/>
            <p:cNvCxnSpPr/>
            <p:nvPr/>
          </p:nvCxnSpPr>
          <p:spPr>
            <a:xfrm>
              <a:off x="813220" y="1250459"/>
              <a:ext cx="156020" cy="20084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4" name="Straight Connector 1283"/>
            <p:cNvCxnSpPr/>
            <p:nvPr/>
          </p:nvCxnSpPr>
          <p:spPr>
            <a:xfrm>
              <a:off x="803573" y="1090562"/>
              <a:ext cx="280232" cy="36073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5" name="Straight Connector 1284"/>
            <p:cNvCxnSpPr/>
            <p:nvPr/>
          </p:nvCxnSpPr>
          <p:spPr>
            <a:xfrm>
              <a:off x="806044" y="946267"/>
              <a:ext cx="392327" cy="50503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6" name="Straight Connector 1285"/>
            <p:cNvCxnSpPr/>
            <p:nvPr/>
          </p:nvCxnSpPr>
          <p:spPr>
            <a:xfrm>
              <a:off x="806044" y="798790"/>
              <a:ext cx="506892" cy="65250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7" name="Straight Connector 1286"/>
            <p:cNvCxnSpPr/>
            <p:nvPr/>
          </p:nvCxnSpPr>
          <p:spPr>
            <a:xfrm>
              <a:off x="81610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8" name="Straight Connector 1287"/>
            <p:cNvCxnSpPr/>
            <p:nvPr/>
          </p:nvCxnSpPr>
          <p:spPr>
            <a:xfrm>
              <a:off x="1448978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89" name="Straight Connector 1288"/>
            <p:cNvCxnSpPr/>
            <p:nvPr/>
          </p:nvCxnSpPr>
          <p:spPr>
            <a:xfrm>
              <a:off x="1832271" y="655857"/>
              <a:ext cx="509809" cy="65626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0" name="Straight Connector 1289"/>
            <p:cNvCxnSpPr/>
            <p:nvPr/>
          </p:nvCxnSpPr>
          <p:spPr>
            <a:xfrm>
              <a:off x="1946836" y="655857"/>
              <a:ext cx="394241" cy="507496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1" name="Straight Connector 1290"/>
            <p:cNvCxnSpPr/>
            <p:nvPr/>
          </p:nvCxnSpPr>
          <p:spPr>
            <a:xfrm>
              <a:off x="2175966" y="655857"/>
              <a:ext cx="166114" cy="213835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2" name="Straight Connector 1291"/>
            <p:cNvCxnSpPr/>
            <p:nvPr/>
          </p:nvCxnSpPr>
          <p:spPr>
            <a:xfrm>
              <a:off x="2290531" y="655857"/>
              <a:ext cx="51549" cy="6635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3" name="Straight Connector 1292"/>
            <p:cNvCxnSpPr/>
            <p:nvPr/>
          </p:nvCxnSpPr>
          <p:spPr>
            <a:xfrm>
              <a:off x="105384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4" name="Straight Connector 1293"/>
            <p:cNvCxnSpPr/>
            <p:nvPr/>
          </p:nvCxnSpPr>
          <p:spPr>
            <a:xfrm>
              <a:off x="1187646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5" name="Straight Connector 1294"/>
            <p:cNvCxnSpPr/>
            <p:nvPr/>
          </p:nvCxnSpPr>
          <p:spPr>
            <a:xfrm>
              <a:off x="132127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6" name="Straight Connector 1295"/>
            <p:cNvCxnSpPr/>
            <p:nvPr/>
          </p:nvCxnSpPr>
          <p:spPr>
            <a:xfrm>
              <a:off x="933002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7" name="Straight Connector 1296"/>
            <p:cNvCxnSpPr/>
            <p:nvPr/>
          </p:nvCxnSpPr>
          <p:spPr>
            <a:xfrm>
              <a:off x="1573154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8" name="Straight Connector 1297"/>
            <p:cNvCxnSpPr/>
            <p:nvPr/>
          </p:nvCxnSpPr>
          <p:spPr>
            <a:xfrm>
              <a:off x="1687461" y="655857"/>
              <a:ext cx="611399" cy="787039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99" name="Group 1298"/>
          <p:cNvGrpSpPr/>
          <p:nvPr/>
        </p:nvGrpSpPr>
        <p:grpSpPr>
          <a:xfrm>
            <a:off x="4280922" y="648009"/>
            <a:ext cx="785070" cy="787300"/>
            <a:chOff x="725439" y="7856661"/>
            <a:chExt cx="674330" cy="914400"/>
          </a:xfrm>
        </p:grpSpPr>
        <p:cxnSp>
          <p:nvCxnSpPr>
            <p:cNvPr id="1300" name="Straight Connector 1299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1" name="Straight Connector 1300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2" name="Straight Connector 1301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3" name="Straight Connector 1302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4" name="Straight Connector 1303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5" name="Straight Connector 1304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6" name="Straight Connector 1305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7" name="Straight Connector 1306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8" name="Straight Connector 1307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9" name="Straight Connector 1308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0" name="Straight Connector 1309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1" name="Straight Connector 1310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12" name="Group 1311"/>
          <p:cNvGrpSpPr/>
          <p:nvPr/>
        </p:nvGrpSpPr>
        <p:grpSpPr>
          <a:xfrm>
            <a:off x="5923386" y="648009"/>
            <a:ext cx="785070" cy="787300"/>
            <a:chOff x="725439" y="7856661"/>
            <a:chExt cx="674330" cy="914400"/>
          </a:xfrm>
        </p:grpSpPr>
        <p:cxnSp>
          <p:nvCxnSpPr>
            <p:cNvPr id="1313" name="Straight Connector 1312"/>
            <p:cNvCxnSpPr/>
            <p:nvPr/>
          </p:nvCxnSpPr>
          <p:spPr>
            <a:xfrm>
              <a:off x="727656" y="8698328"/>
              <a:ext cx="43640" cy="72733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4" name="Straight Connector 1313"/>
            <p:cNvCxnSpPr/>
            <p:nvPr/>
          </p:nvCxnSpPr>
          <p:spPr>
            <a:xfrm>
              <a:off x="734096" y="8537720"/>
              <a:ext cx="140005" cy="23334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5" name="Straight Connector 1314"/>
            <p:cNvCxnSpPr/>
            <p:nvPr/>
          </p:nvCxnSpPr>
          <p:spPr>
            <a:xfrm>
              <a:off x="725439" y="8351949"/>
              <a:ext cx="251467" cy="41911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6" name="Straight Connector 1315"/>
            <p:cNvCxnSpPr/>
            <p:nvPr/>
          </p:nvCxnSpPr>
          <p:spPr>
            <a:xfrm>
              <a:off x="727656" y="8184303"/>
              <a:ext cx="352055" cy="58675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7" name="Straight Connector 1316"/>
            <p:cNvCxnSpPr/>
            <p:nvPr/>
          </p:nvCxnSpPr>
          <p:spPr>
            <a:xfrm>
              <a:off x="727656" y="8012961"/>
              <a:ext cx="454860" cy="7581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8" name="Straight Connector 1317"/>
            <p:cNvCxnSpPr/>
            <p:nvPr/>
          </p:nvCxnSpPr>
          <p:spPr>
            <a:xfrm>
              <a:off x="736681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9" name="Straight Connector 1318"/>
            <p:cNvCxnSpPr/>
            <p:nvPr/>
          </p:nvCxnSpPr>
          <p:spPr>
            <a:xfrm>
              <a:off x="839486" y="7856661"/>
              <a:ext cx="548640" cy="914400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0" name="Straight Connector 1319"/>
            <p:cNvCxnSpPr/>
            <p:nvPr/>
          </p:nvCxnSpPr>
          <p:spPr>
            <a:xfrm>
              <a:off x="942291" y="7856661"/>
              <a:ext cx="457478" cy="762464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1" name="Straight Connector 1320"/>
            <p:cNvCxnSpPr/>
            <p:nvPr/>
          </p:nvCxnSpPr>
          <p:spPr>
            <a:xfrm>
              <a:off x="1045096" y="7856661"/>
              <a:ext cx="353773" cy="589621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2" name="Straight Connector 1321"/>
            <p:cNvCxnSpPr/>
            <p:nvPr/>
          </p:nvCxnSpPr>
          <p:spPr>
            <a:xfrm>
              <a:off x="1147901" y="7856661"/>
              <a:ext cx="247165" cy="411942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3" name="Straight Connector 1322"/>
            <p:cNvCxnSpPr/>
            <p:nvPr/>
          </p:nvCxnSpPr>
          <p:spPr>
            <a:xfrm>
              <a:off x="1250706" y="7856661"/>
              <a:ext cx="149063" cy="248438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4" name="Straight Connector 1323"/>
            <p:cNvCxnSpPr/>
            <p:nvPr/>
          </p:nvCxnSpPr>
          <p:spPr>
            <a:xfrm>
              <a:off x="1353511" y="7856661"/>
              <a:ext cx="46258" cy="77097"/>
            </a:xfrm>
            <a:prstGeom prst="line">
              <a:avLst/>
            </a:prstGeom>
            <a:ln>
              <a:solidFill>
                <a:srgbClr val="1C1C1C">
                  <a:alpha val="5000"/>
                </a:srgb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31" name="TextBox 530"/>
          <p:cNvSpPr txBox="1"/>
          <p:nvPr/>
        </p:nvSpPr>
        <p:spPr>
          <a:xfrm>
            <a:off x="28293" y="-2561"/>
            <a:ext cx="1238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4</a:t>
            </a:r>
            <a:endParaRPr lang="en-US" dirty="0"/>
          </a:p>
        </p:txBody>
      </p:sp>
      <p:graphicFrame>
        <p:nvGraphicFramePr>
          <p:cNvPr id="532" name="Chart 5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1882599"/>
              </p:ext>
            </p:extLst>
          </p:nvPr>
        </p:nvGraphicFramePr>
        <p:xfrm>
          <a:off x="681976" y="526178"/>
          <a:ext cx="1977417" cy="10672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33" name="Chart 5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1508355"/>
              </p:ext>
            </p:extLst>
          </p:nvPr>
        </p:nvGraphicFramePr>
        <p:xfrm>
          <a:off x="2493009" y="536272"/>
          <a:ext cx="1818978" cy="1042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38" name="Chart 5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5452235"/>
              </p:ext>
            </p:extLst>
          </p:nvPr>
        </p:nvGraphicFramePr>
        <p:xfrm>
          <a:off x="4148863" y="525675"/>
          <a:ext cx="1819656" cy="1042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39" name="Chart 5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2413389"/>
              </p:ext>
            </p:extLst>
          </p:nvPr>
        </p:nvGraphicFramePr>
        <p:xfrm>
          <a:off x="5788581" y="525675"/>
          <a:ext cx="1828800" cy="1042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541" name="Chart 5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2325731"/>
              </p:ext>
            </p:extLst>
          </p:nvPr>
        </p:nvGraphicFramePr>
        <p:xfrm>
          <a:off x="701651" y="3385362"/>
          <a:ext cx="1957740" cy="10785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542" name="Chart 5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4510977"/>
              </p:ext>
            </p:extLst>
          </p:nvPr>
        </p:nvGraphicFramePr>
        <p:xfrm>
          <a:off x="2479724" y="3379295"/>
          <a:ext cx="1826616" cy="10846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543" name="Chart 5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8075955"/>
              </p:ext>
            </p:extLst>
          </p:nvPr>
        </p:nvGraphicFramePr>
        <p:xfrm>
          <a:off x="4144048" y="3385361"/>
          <a:ext cx="1824471" cy="10814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544" name="Chart 5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7762233"/>
              </p:ext>
            </p:extLst>
          </p:nvPr>
        </p:nvGraphicFramePr>
        <p:xfrm>
          <a:off x="5795759" y="3398625"/>
          <a:ext cx="1833945" cy="1067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536" name="Chart 5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0512807"/>
              </p:ext>
            </p:extLst>
          </p:nvPr>
        </p:nvGraphicFramePr>
        <p:xfrm>
          <a:off x="512648" y="1469294"/>
          <a:ext cx="2146743" cy="10752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540" name="Chart 5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3214520"/>
              </p:ext>
            </p:extLst>
          </p:nvPr>
        </p:nvGraphicFramePr>
        <p:xfrm>
          <a:off x="2491770" y="1477595"/>
          <a:ext cx="1820217" cy="10677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545" name="Chart 5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2548858"/>
              </p:ext>
            </p:extLst>
          </p:nvPr>
        </p:nvGraphicFramePr>
        <p:xfrm>
          <a:off x="4127730" y="1480581"/>
          <a:ext cx="1840789" cy="10627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546" name="Chart 5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5892421"/>
              </p:ext>
            </p:extLst>
          </p:nvPr>
        </p:nvGraphicFramePr>
        <p:xfrm>
          <a:off x="5779631" y="1467771"/>
          <a:ext cx="1820156" cy="10804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547" name="Chart 5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8583431"/>
              </p:ext>
            </p:extLst>
          </p:nvPr>
        </p:nvGraphicFramePr>
        <p:xfrm>
          <a:off x="679750" y="5295619"/>
          <a:ext cx="1979642" cy="10657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548" name="Chart 5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8001200"/>
              </p:ext>
            </p:extLst>
          </p:nvPr>
        </p:nvGraphicFramePr>
        <p:xfrm>
          <a:off x="2486663" y="5295619"/>
          <a:ext cx="1825324" cy="10723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549" name="Chart 54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3771988"/>
              </p:ext>
            </p:extLst>
          </p:nvPr>
        </p:nvGraphicFramePr>
        <p:xfrm>
          <a:off x="4136389" y="5305405"/>
          <a:ext cx="1832130" cy="10706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550" name="Chart 5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4724373"/>
              </p:ext>
            </p:extLst>
          </p:nvPr>
        </p:nvGraphicFramePr>
        <p:xfrm>
          <a:off x="5795757" y="5305405"/>
          <a:ext cx="1832589" cy="10774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551" name="Chart 55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3590589"/>
              </p:ext>
            </p:extLst>
          </p:nvPr>
        </p:nvGraphicFramePr>
        <p:xfrm>
          <a:off x="5793861" y="2423382"/>
          <a:ext cx="1829028" cy="1075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552" name="Chart 55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0831838"/>
              </p:ext>
            </p:extLst>
          </p:nvPr>
        </p:nvGraphicFramePr>
        <p:xfrm>
          <a:off x="4136389" y="2423382"/>
          <a:ext cx="1870764" cy="10701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graphicFrame>
        <p:nvGraphicFramePr>
          <p:cNvPr id="553" name="Chart 55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4873474"/>
              </p:ext>
            </p:extLst>
          </p:nvPr>
        </p:nvGraphicFramePr>
        <p:xfrm>
          <a:off x="2483040" y="2423382"/>
          <a:ext cx="1826968" cy="10701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graphicFrame>
        <p:nvGraphicFramePr>
          <p:cNvPr id="554" name="Chart 5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6378078"/>
              </p:ext>
            </p:extLst>
          </p:nvPr>
        </p:nvGraphicFramePr>
        <p:xfrm>
          <a:off x="701589" y="2412914"/>
          <a:ext cx="1957804" cy="10750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graphicFrame>
        <p:nvGraphicFramePr>
          <p:cNvPr id="555" name="Chart 5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990689"/>
              </p:ext>
            </p:extLst>
          </p:nvPr>
        </p:nvGraphicFramePr>
        <p:xfrm>
          <a:off x="5802310" y="4344380"/>
          <a:ext cx="1815231" cy="10712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graphicFrame>
        <p:nvGraphicFramePr>
          <p:cNvPr id="556" name="Chart 55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084741"/>
              </p:ext>
            </p:extLst>
          </p:nvPr>
        </p:nvGraphicFramePr>
        <p:xfrm>
          <a:off x="4136389" y="4340167"/>
          <a:ext cx="1840384" cy="1069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4"/>
          </a:graphicData>
        </a:graphic>
      </p:graphicFrame>
      <p:graphicFrame>
        <p:nvGraphicFramePr>
          <p:cNvPr id="557" name="Chart 55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9217366"/>
              </p:ext>
            </p:extLst>
          </p:nvPr>
        </p:nvGraphicFramePr>
        <p:xfrm>
          <a:off x="2482488" y="4328652"/>
          <a:ext cx="1823851" cy="10805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graphicFrame>
        <p:nvGraphicFramePr>
          <p:cNvPr id="558" name="Chart 55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9025571"/>
              </p:ext>
            </p:extLst>
          </p:nvPr>
        </p:nvGraphicFramePr>
        <p:xfrm>
          <a:off x="687248" y="4328652"/>
          <a:ext cx="1972144" cy="1073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6"/>
          </a:graphicData>
        </a:graphic>
      </p:graphicFrame>
      <p:graphicFrame>
        <p:nvGraphicFramePr>
          <p:cNvPr id="559" name="Chart 55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5108544"/>
              </p:ext>
            </p:extLst>
          </p:nvPr>
        </p:nvGraphicFramePr>
        <p:xfrm>
          <a:off x="5792902" y="6255327"/>
          <a:ext cx="1835443" cy="10689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7"/>
          </a:graphicData>
        </a:graphic>
      </p:graphicFrame>
      <p:graphicFrame>
        <p:nvGraphicFramePr>
          <p:cNvPr id="560" name="Chart 55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656839"/>
              </p:ext>
            </p:extLst>
          </p:nvPr>
        </p:nvGraphicFramePr>
        <p:xfrm>
          <a:off x="4134167" y="6255327"/>
          <a:ext cx="1842607" cy="105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8"/>
          </a:graphicData>
        </a:graphic>
      </p:graphicFrame>
      <p:graphicFrame>
        <p:nvGraphicFramePr>
          <p:cNvPr id="563" name="Chart 5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3282519"/>
              </p:ext>
            </p:extLst>
          </p:nvPr>
        </p:nvGraphicFramePr>
        <p:xfrm>
          <a:off x="2482430" y="6255327"/>
          <a:ext cx="1811580" cy="10611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9"/>
          </a:graphicData>
        </a:graphic>
      </p:graphicFrame>
      <p:graphicFrame>
        <p:nvGraphicFramePr>
          <p:cNvPr id="564" name="Chart 56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2412468"/>
              </p:ext>
            </p:extLst>
          </p:nvPr>
        </p:nvGraphicFramePr>
        <p:xfrm>
          <a:off x="687248" y="6255327"/>
          <a:ext cx="1972143" cy="105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0"/>
          </a:graphicData>
        </a:graphic>
      </p:graphicFrame>
      <p:graphicFrame>
        <p:nvGraphicFramePr>
          <p:cNvPr id="565" name="Chart 56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5746395"/>
              </p:ext>
            </p:extLst>
          </p:nvPr>
        </p:nvGraphicFramePr>
        <p:xfrm>
          <a:off x="5737982" y="7206721"/>
          <a:ext cx="1948204" cy="11809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1"/>
          </a:graphicData>
        </a:graphic>
      </p:graphicFrame>
      <p:graphicFrame>
        <p:nvGraphicFramePr>
          <p:cNvPr id="566" name="Chart 56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3838517"/>
              </p:ext>
            </p:extLst>
          </p:nvPr>
        </p:nvGraphicFramePr>
        <p:xfrm>
          <a:off x="4083424" y="7206721"/>
          <a:ext cx="1938025" cy="11701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4879779" y="8255090"/>
            <a:ext cx="370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smtClean="0"/>
              <a:t>Days</a:t>
            </a:r>
            <a:endParaRPr lang="en-US" sz="700" b="1" dirty="0"/>
          </a:p>
        </p:txBody>
      </p:sp>
      <p:sp>
        <p:nvSpPr>
          <p:cNvPr id="567" name="TextBox 566"/>
          <p:cNvSpPr txBox="1"/>
          <p:nvPr/>
        </p:nvSpPr>
        <p:spPr>
          <a:xfrm>
            <a:off x="6517816" y="8255090"/>
            <a:ext cx="370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smtClean="0"/>
              <a:t>Days</a:t>
            </a:r>
            <a:endParaRPr lang="en-US" sz="700" b="1" dirty="0"/>
          </a:p>
        </p:txBody>
      </p:sp>
      <p:graphicFrame>
        <p:nvGraphicFramePr>
          <p:cNvPr id="568" name="Chart 56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26590140"/>
              </p:ext>
            </p:extLst>
          </p:nvPr>
        </p:nvGraphicFramePr>
        <p:xfrm>
          <a:off x="2416494" y="7206721"/>
          <a:ext cx="1955225" cy="11713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3"/>
          </a:graphicData>
        </a:graphic>
      </p:graphicFrame>
      <p:graphicFrame>
        <p:nvGraphicFramePr>
          <p:cNvPr id="569" name="Chart 56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8106634"/>
              </p:ext>
            </p:extLst>
          </p:nvPr>
        </p:nvGraphicFramePr>
        <p:xfrm>
          <a:off x="680006" y="7196559"/>
          <a:ext cx="2013142" cy="11910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4"/>
          </a:graphicData>
        </a:graphic>
      </p:graphicFrame>
      <p:sp>
        <p:nvSpPr>
          <p:cNvPr id="570" name="TextBox 569"/>
          <p:cNvSpPr txBox="1"/>
          <p:nvPr/>
        </p:nvSpPr>
        <p:spPr>
          <a:xfrm>
            <a:off x="3197058" y="8255090"/>
            <a:ext cx="370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smtClean="0"/>
              <a:t>Days</a:t>
            </a:r>
            <a:endParaRPr lang="en-US" sz="700" b="1" dirty="0"/>
          </a:p>
        </p:txBody>
      </p:sp>
      <p:sp>
        <p:nvSpPr>
          <p:cNvPr id="571" name="TextBox 570"/>
          <p:cNvSpPr txBox="1"/>
          <p:nvPr/>
        </p:nvSpPr>
        <p:spPr>
          <a:xfrm>
            <a:off x="1514337" y="8255090"/>
            <a:ext cx="370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smtClean="0"/>
              <a:t>Days</a:t>
            </a:r>
            <a:endParaRPr lang="en-US" sz="700" b="1" dirty="0"/>
          </a:p>
        </p:txBody>
      </p:sp>
      <p:grpSp>
        <p:nvGrpSpPr>
          <p:cNvPr id="6" name="Group 5"/>
          <p:cNvGrpSpPr/>
          <p:nvPr/>
        </p:nvGrpSpPr>
        <p:grpSpPr>
          <a:xfrm>
            <a:off x="3317270" y="8427657"/>
            <a:ext cx="2154993" cy="446276"/>
            <a:chOff x="2751747" y="8427657"/>
            <a:chExt cx="2154993" cy="446276"/>
          </a:xfrm>
        </p:grpSpPr>
        <p:sp>
          <p:nvSpPr>
            <p:cNvPr id="537" name="Rectangle 536"/>
            <p:cNvSpPr/>
            <p:nvPr/>
          </p:nvSpPr>
          <p:spPr>
            <a:xfrm>
              <a:off x="2751747" y="8462677"/>
              <a:ext cx="2018545" cy="29879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61" name="Straight Connector 560"/>
            <p:cNvCxnSpPr/>
            <p:nvPr/>
          </p:nvCxnSpPr>
          <p:spPr>
            <a:xfrm>
              <a:off x="3745115" y="8663839"/>
              <a:ext cx="18288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2" name="Straight Connector 561"/>
            <p:cNvCxnSpPr/>
            <p:nvPr/>
          </p:nvCxnSpPr>
          <p:spPr>
            <a:xfrm>
              <a:off x="3745115" y="8539574"/>
              <a:ext cx="182880" cy="0"/>
            </a:xfrm>
            <a:prstGeom prst="line">
              <a:avLst/>
            </a:prstGeom>
            <a:ln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2" name="TextBox 571"/>
            <p:cNvSpPr txBox="1"/>
            <p:nvPr/>
          </p:nvSpPr>
          <p:spPr>
            <a:xfrm>
              <a:off x="3871872" y="8427657"/>
              <a:ext cx="1034868" cy="44627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smtClean="0"/>
                <a:t>Low-</a:t>
              </a:r>
              <a:r>
                <a:rPr lang="en-US" sz="800" i="1" smtClean="0"/>
                <a:t>R</a:t>
              </a:r>
              <a:r>
                <a:rPr lang="en-US" sz="800" i="1" baseline="-25000" smtClean="0"/>
                <a:t>S</a:t>
              </a:r>
              <a:r>
                <a:rPr lang="en-US" sz="800" i="1" smtClean="0"/>
                <a:t> </a:t>
              </a:r>
              <a:r>
                <a:rPr lang="en-US" sz="800" smtClean="0"/>
                <a:t>corals </a:t>
              </a:r>
            </a:p>
            <a:p>
              <a:r>
                <a:rPr lang="en-US" sz="800" smtClean="0"/>
                <a:t>High-</a:t>
              </a:r>
              <a:r>
                <a:rPr lang="en-US" sz="800" i="1" smtClean="0"/>
                <a:t>R</a:t>
              </a:r>
              <a:r>
                <a:rPr lang="en-US" sz="800" i="1" baseline="-25000" smtClean="0"/>
                <a:t>S</a:t>
              </a:r>
              <a:r>
                <a:rPr lang="en-US" sz="800" smtClean="0"/>
                <a:t> </a:t>
              </a:r>
              <a:r>
                <a:rPr lang="en-US" sz="800"/>
                <a:t>corals </a:t>
              </a:r>
            </a:p>
            <a:p>
              <a:endParaRPr lang="en-US" sz="700" dirty="0"/>
            </a:p>
          </p:txBody>
        </p:sp>
        <p:sp>
          <p:nvSpPr>
            <p:cNvPr id="573" name="TextBox 572"/>
            <p:cNvSpPr txBox="1"/>
            <p:nvPr/>
          </p:nvSpPr>
          <p:spPr>
            <a:xfrm>
              <a:off x="3701758" y="8484206"/>
              <a:ext cx="244193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smtClean="0">
                  <a:solidFill>
                    <a:schemeClr val="bg1">
                      <a:lumMod val="65000"/>
                    </a:schemeClr>
                  </a:solidFill>
                </a:rPr>
                <a:t>×</a:t>
              </a:r>
              <a:endParaRPr lang="en-US" sz="1600" dirty="0">
                <a:solidFill>
                  <a:schemeClr val="bg1">
                    <a:lumMod val="65000"/>
                  </a:schemeClr>
                </a:solidFill>
              </a:endParaRPr>
            </a:p>
          </p:txBody>
        </p:sp>
        <p:sp>
          <p:nvSpPr>
            <p:cNvPr id="574" name="Rectangle 573"/>
            <p:cNvSpPr/>
            <p:nvPr/>
          </p:nvSpPr>
          <p:spPr>
            <a:xfrm>
              <a:off x="3817514" y="8510257"/>
              <a:ext cx="45719" cy="5963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75" name="Group 574"/>
            <p:cNvGrpSpPr/>
            <p:nvPr/>
          </p:nvGrpSpPr>
          <p:grpSpPr>
            <a:xfrm>
              <a:off x="2819048" y="8442241"/>
              <a:ext cx="1034868" cy="307777"/>
              <a:chOff x="2087538" y="9366619"/>
              <a:chExt cx="1034868" cy="307777"/>
            </a:xfrm>
          </p:grpSpPr>
          <p:grpSp>
            <p:nvGrpSpPr>
              <p:cNvPr id="576" name="Group 575"/>
              <p:cNvGrpSpPr/>
              <p:nvPr/>
            </p:nvGrpSpPr>
            <p:grpSpPr>
              <a:xfrm>
                <a:off x="2093845" y="9454599"/>
                <a:ext cx="154622" cy="146513"/>
                <a:chOff x="725439" y="7856661"/>
                <a:chExt cx="674330" cy="914400"/>
              </a:xfrm>
            </p:grpSpPr>
            <p:cxnSp>
              <p:nvCxnSpPr>
                <p:cNvPr id="579" name="Straight Connector 578"/>
                <p:cNvCxnSpPr/>
                <p:nvPr/>
              </p:nvCxnSpPr>
              <p:spPr>
                <a:xfrm>
                  <a:off x="727656" y="8698328"/>
                  <a:ext cx="43640" cy="72733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80" name="Straight Connector 579"/>
                <p:cNvCxnSpPr/>
                <p:nvPr/>
              </p:nvCxnSpPr>
              <p:spPr>
                <a:xfrm>
                  <a:off x="734096" y="8537720"/>
                  <a:ext cx="140005" cy="233341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81" name="Straight Connector 580"/>
                <p:cNvCxnSpPr/>
                <p:nvPr/>
              </p:nvCxnSpPr>
              <p:spPr>
                <a:xfrm>
                  <a:off x="725439" y="8351949"/>
                  <a:ext cx="251467" cy="419112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82" name="Straight Connector 581"/>
                <p:cNvCxnSpPr/>
                <p:nvPr/>
              </p:nvCxnSpPr>
              <p:spPr>
                <a:xfrm>
                  <a:off x="727656" y="8184303"/>
                  <a:ext cx="352055" cy="586758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84" name="Straight Connector 583"/>
                <p:cNvCxnSpPr/>
                <p:nvPr/>
              </p:nvCxnSpPr>
              <p:spPr>
                <a:xfrm>
                  <a:off x="727656" y="8012961"/>
                  <a:ext cx="454860" cy="758100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85" name="Straight Connector 584"/>
                <p:cNvCxnSpPr/>
                <p:nvPr/>
              </p:nvCxnSpPr>
              <p:spPr>
                <a:xfrm>
                  <a:off x="736681" y="7856661"/>
                  <a:ext cx="548640" cy="914400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86" name="Straight Connector 585"/>
                <p:cNvCxnSpPr/>
                <p:nvPr/>
              </p:nvCxnSpPr>
              <p:spPr>
                <a:xfrm>
                  <a:off x="839486" y="7856661"/>
                  <a:ext cx="548640" cy="914400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87" name="Straight Connector 586"/>
                <p:cNvCxnSpPr/>
                <p:nvPr/>
              </p:nvCxnSpPr>
              <p:spPr>
                <a:xfrm>
                  <a:off x="942291" y="7856661"/>
                  <a:ext cx="457478" cy="762464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88" name="Straight Connector 587"/>
                <p:cNvCxnSpPr/>
                <p:nvPr/>
              </p:nvCxnSpPr>
              <p:spPr>
                <a:xfrm>
                  <a:off x="1045096" y="7856661"/>
                  <a:ext cx="353773" cy="589621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89" name="Straight Connector 588"/>
                <p:cNvCxnSpPr/>
                <p:nvPr/>
              </p:nvCxnSpPr>
              <p:spPr>
                <a:xfrm>
                  <a:off x="1147901" y="7856661"/>
                  <a:ext cx="247165" cy="411942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90" name="Straight Connector 589"/>
                <p:cNvCxnSpPr/>
                <p:nvPr/>
              </p:nvCxnSpPr>
              <p:spPr>
                <a:xfrm>
                  <a:off x="1250706" y="7856661"/>
                  <a:ext cx="149063" cy="248438"/>
                </a:xfrm>
                <a:prstGeom prst="line">
                  <a:avLst/>
                </a:prstGeom>
                <a:ln>
                  <a:solidFill>
                    <a:schemeClr val="tx1">
                      <a:alpha val="5000"/>
                    </a:scheme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91" name="Straight Connector 590"/>
                <p:cNvCxnSpPr/>
                <p:nvPr/>
              </p:nvCxnSpPr>
              <p:spPr>
                <a:xfrm>
                  <a:off x="1353511" y="7856661"/>
                  <a:ext cx="46258" cy="77097"/>
                </a:xfrm>
                <a:prstGeom prst="line">
                  <a:avLst/>
                </a:prstGeom>
                <a:ln>
                  <a:solidFill>
                    <a:srgbClr val="1C1C1C">
                      <a:alpha val="5000"/>
                    </a:srgb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77" name="Rectangle 576"/>
              <p:cNvSpPr/>
              <p:nvPr/>
            </p:nvSpPr>
            <p:spPr>
              <a:xfrm>
                <a:off x="2096262" y="9454599"/>
                <a:ext cx="152204" cy="140803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78" name="TextBox 577"/>
              <p:cNvSpPr txBox="1"/>
              <p:nvPr/>
            </p:nvSpPr>
            <p:spPr>
              <a:xfrm>
                <a:off x="2087538" y="9366619"/>
                <a:ext cx="1034868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/>
                  <a:t>Pre-stress control conditions</a:t>
                </a:r>
                <a:endParaRPr lang="en-US" sz="7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15323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57</TotalTime>
  <Words>59</Words>
  <Application>Microsoft Office PowerPoint</Application>
  <PresentationFormat>Custom</PresentationFormat>
  <Paragraphs>3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ckmanLab1</dc:creator>
  <cp:lastModifiedBy>Timothy Swain</cp:lastModifiedBy>
  <cp:revision>241</cp:revision>
  <dcterms:created xsi:type="dcterms:W3CDTF">2013-07-17T16:15:24Z</dcterms:created>
  <dcterms:modified xsi:type="dcterms:W3CDTF">2015-12-10T00:05:19Z</dcterms:modified>
</cp:coreProperties>
</file>